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notesSlides/notesSlide2.xml" ContentType="application/vnd.openxmlformats-officedocument.presentationml.notesSlide+xml"/>
  <Override PartName="/ppt/charts/chart11.xml" ContentType="application/vnd.openxmlformats-officedocument.drawingml.chart+xml"/>
  <Override PartName="/ppt/drawings/drawing3.xml" ContentType="application/vnd.openxmlformats-officedocument.drawingml.chartshapes+xml"/>
  <Override PartName="/ppt/charts/chart12.xml" ContentType="application/vnd.openxmlformats-officedocument.drawingml.chart+xml"/>
  <Override PartName="/ppt/drawings/drawing4.xml" ContentType="application/vnd.openxmlformats-officedocument.drawingml.chartshapes+xml"/>
  <Override PartName="/ppt/charts/chart13.xml" ContentType="application/vnd.openxmlformats-officedocument.drawingml.chart+xml"/>
  <Override PartName="/ppt/drawings/drawing5.xml" ContentType="application/vnd.openxmlformats-officedocument.drawingml.chartshapes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drawings/drawing6.xml" ContentType="application/vnd.openxmlformats-officedocument.drawingml.chartshapes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drawings/drawing7.xml" ContentType="application/vnd.openxmlformats-officedocument.drawingml.chartshapes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drawings/drawing8.xml" ContentType="application/vnd.openxmlformats-officedocument.drawingml.chartshapes+xml"/>
  <Override PartName="/ppt/charts/chart28.xml" ContentType="application/vnd.openxmlformats-officedocument.drawingml.chart+xml"/>
  <Override PartName="/ppt/drawings/drawing9.xml" ContentType="application/vnd.openxmlformats-officedocument.drawingml.chartshapes+xml"/>
  <Override PartName="/ppt/charts/chart29.xml" ContentType="application/vnd.openxmlformats-officedocument.drawingml.chart+xml"/>
  <Override PartName="/ppt/drawings/drawing10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70" r:id="rId2"/>
    <p:sldId id="260" r:id="rId3"/>
    <p:sldId id="259" r:id="rId4"/>
    <p:sldId id="261" r:id="rId5"/>
    <p:sldId id="263" r:id="rId6"/>
    <p:sldId id="257" r:id="rId7"/>
    <p:sldId id="256" r:id="rId8"/>
    <p:sldId id="272" r:id="rId9"/>
    <p:sldId id="268" r:id="rId10"/>
    <p:sldId id="267" r:id="rId11"/>
    <p:sldId id="262" r:id="rId12"/>
  </p:sldIdLst>
  <p:sldSz cx="7561263" cy="10693400"/>
  <p:notesSz cx="6662738" cy="9926638"/>
  <p:defaultTextStyle>
    <a:defPPr>
      <a:defRPr lang="fr-FR"/>
    </a:defPPr>
    <a:lvl1pPr marL="0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21528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43056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564584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086112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07640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129168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650696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172224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60" autoAdjust="0"/>
  </p:normalViewPr>
  <p:slideViewPr>
    <p:cSldViewPr>
      <p:cViewPr>
        <p:scale>
          <a:sx n="100" d="100"/>
          <a:sy n="100" d="100"/>
        </p:scale>
        <p:origin x="1014" y="-642"/>
      </p:cViewPr>
      <p:guideLst>
        <p:guide orient="horz" pos="3368"/>
        <p:guide pos="238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ois\Documents\projet%20REDD\article%20%232\BMC%20Biol\revision\suppl%20fig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ois\Documents\projet%20REDD\article%20%232\BMC%20Biol\revision\suppl%20fig1.xlsx" TargetMode="Externa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STAPS\Documents\projet%20REDD\article%20%232\Fig1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STAPS\Documents\projet%20REDD\article%20%232\Fig1.xlsx" TargetMode="Externa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Users\STAPS\Documents\projet%20REDD\article%20%232\Fig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APS\Documents\projet%20REDD\article%20%232\Fig1.xlsx" TargetMode="Externa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Users\STAPS\Documents\projet%20REDD\article%20%232\Fig1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APS\Documents\projet%20REDD\article%20%232\Fig1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ois\Documents\projet%20REDD\article%20%232\resoumission\Figures\supplemental%20data.xlsx" TargetMode="External"/></Relationships>
</file>

<file path=ppt/charts/_rels/chart1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C:\Users\Francois\Documents\projet%20REDD\Exercice%20aigu\quantif%20WB%20exo90min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TAPS\Documents\projet%20REDD\article%20%232\Fig2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.xlsx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2.xlsx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3.xlsx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4.xlsx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5.xlsx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rojet%20REDD\AAV-REDD1\quantif%20CS-REDD1%20AAV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ois\Documents\projet%20REDD\cell%20culture\myoblast%20Humain\Quantif%20PURO3%20AMPK%2031-10-17.xlsx" TargetMode="External"/></Relationships>
</file>

<file path=ppt/charts/_rels/chart2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E:\projet%20REDD\article%20%232\resoumission\supplemental%20data.xlsx" TargetMode="External"/></Relationships>
</file>

<file path=ppt/charts/_rels/chart2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E:\projet%20REDD\article%20%232\resoumission\supplemental%20data.xlsx" TargetMode="External"/></Relationships>
</file>

<file path=ppt/charts/_rels/chart2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package" Target="../embeddings/Feuille_de_calcul_Microsoft_Excel6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STAPS\Documents\projet%20REDD\article%20%232\Fig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ois\Documents\projet%20REDD\article%20%232\BMC%20Biol\revision\suppl%20fig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ois\Documents\projet%20REDD\article%20%232\BMC%20Biol\revision\suppl%20fig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ois\Documents\projet%20REDD\article%20%232\BMC%20Biol\revision\suppl%20fig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B$15</c:f>
                <c:numCache>
                  <c:formatCode>General</c:formatCode>
                  <c:ptCount val="1"/>
                  <c:pt idx="0">
                    <c:v>5.60800266383237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B$14</c:f>
              <c:numCache>
                <c:formatCode>0.0</c:formatCode>
                <c:ptCount val="1"/>
                <c:pt idx="0">
                  <c:v>163.657142857142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17-40FC-A48F-0112E283C2D8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Feuil1!$C$15</c:f>
                <c:numCache>
                  <c:formatCode>General</c:formatCode>
                  <c:ptCount val="1"/>
                  <c:pt idx="0">
                    <c:v>3.97801782931400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C$14</c:f>
              <c:numCache>
                <c:formatCode>0.0</c:formatCode>
                <c:ptCount val="1"/>
                <c:pt idx="0">
                  <c:v>149.528571428571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17-40FC-A48F-0112E283C2D8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15</c:f>
                <c:numCache>
                  <c:formatCode>General</c:formatCode>
                  <c:ptCount val="1"/>
                  <c:pt idx="0">
                    <c:v>4.6486087695205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D$14</c:f>
              <c:numCache>
                <c:formatCode>0.0</c:formatCode>
                <c:ptCount val="1"/>
                <c:pt idx="0">
                  <c:v>157.028571428571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017-40FC-A48F-0112E283C2D8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E$15</c:f>
                <c:numCache>
                  <c:formatCode>General</c:formatCode>
                  <c:ptCount val="1"/>
                  <c:pt idx="0">
                    <c:v>8.44138614209776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E$14</c:f>
              <c:numCache>
                <c:formatCode>0.0</c:formatCode>
                <c:ptCount val="1"/>
                <c:pt idx="0">
                  <c:v>129.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017-40FC-A48F-0112E283C2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euil1!$F$35,Feuil1!$H$35)</c:f>
                <c:numCache>
                  <c:formatCode>General</c:formatCode>
                  <c:ptCount val="2"/>
                  <c:pt idx="0">
                    <c:v>6.9278621943677815E-2</c:v>
                  </c:pt>
                  <c:pt idx="1">
                    <c:v>0.188059640252873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O$1:$P$1</c:f>
              <c:numCache>
                <c:formatCode>General</c:formatCode>
                <c:ptCount val="2"/>
              </c:numCache>
            </c:numRef>
          </c:cat>
          <c:val>
            <c:numRef>
              <c:f>(Feuil1!$F$34,Feuil1!$H$34)</c:f>
              <c:numCache>
                <c:formatCode>0.0000</c:formatCode>
                <c:ptCount val="2"/>
                <c:pt idx="0">
                  <c:v>0.30561742332321495</c:v>
                </c:pt>
                <c:pt idx="1">
                  <c:v>0.404843811684517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6A-4882-BCF9-40E76AB7B8C0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Feuil1!$G$35,Feuil1!$I$35)</c:f>
                <c:numCache>
                  <c:formatCode>General</c:formatCode>
                  <c:ptCount val="2"/>
                  <c:pt idx="0">
                    <c:v>0.24827213784633895</c:v>
                  </c:pt>
                  <c:pt idx="1">
                    <c:v>0.636514733993628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O$1:$P$1</c:f>
              <c:numCache>
                <c:formatCode>General</c:formatCode>
                <c:ptCount val="2"/>
              </c:numCache>
            </c:numRef>
          </c:cat>
          <c:val>
            <c:numRef>
              <c:f>(Feuil1!$G$34,Feuil1!$I$34)</c:f>
              <c:numCache>
                <c:formatCode>0.0000</c:formatCode>
                <c:ptCount val="2"/>
                <c:pt idx="0">
                  <c:v>0.96025557016524832</c:v>
                </c:pt>
                <c:pt idx="1">
                  <c:v>1.88636759431011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26A-4882-BCF9-40E76AB7B8C0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J$35:$K$35</c:f>
                <c:numCache>
                  <c:formatCode>General</c:formatCode>
                  <c:ptCount val="2"/>
                  <c:pt idx="0">
                    <c:v>0.12757646414424476</c:v>
                  </c:pt>
                  <c:pt idx="1">
                    <c:v>0.140924854007112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O$1:$P$1</c:f>
              <c:numCache>
                <c:formatCode>General</c:formatCode>
                <c:ptCount val="2"/>
              </c:numCache>
            </c:numRef>
          </c:cat>
          <c:val>
            <c:numRef>
              <c:f>(Feuil1!$J$34,Feuil1!$K$34)</c:f>
              <c:numCache>
                <c:formatCode>0.0000</c:formatCode>
                <c:ptCount val="2"/>
                <c:pt idx="0">
                  <c:v>0.64218911530165579</c:v>
                </c:pt>
                <c:pt idx="1">
                  <c:v>0.968796566414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26A-4882-BCF9-40E76AB7B8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  <c:majorUnit val="1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5DA7-4691-B12B-92D7E07EB58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5DA7-4691-B12B-92D7E07EB580}"/>
              </c:ext>
            </c:extLst>
          </c:dPt>
          <c:errBars>
            <c:errBarType val="plus"/>
            <c:errValType val="cust"/>
            <c:noEndCap val="0"/>
            <c:plus>
              <c:numRef>
                <c:f>('C:\Users\STAPS\Documents\projet REDD\article #2\[data+figures.xlsx]qPCR UPS-ATG'!$G$2;'C:\Users\STAPS\Documents\projet REDD\article #2\[data+figures.xlsx]qPCR UPS-ATG'!$I$2;'C:\Users\STAPS\Documents\projet REDD\article #2\[data+figures.xlsx]qPCR UPS-ATG'!$K$2;'C:\Users\STAPS\Documents\projet REDD\article #2\[data+figures.xlsx]qPCR UPS-ATG'!$M$2;'C:\Users\STAPS\Documents\projet REDD\article #2\[data+figures.xlsx]qPCR UPS-ATG'!$O$2;'C:\Users\STAPS\Documents\projet REDD\article #2\[data+figures.xlsx]qPCR UPS-ATG'!$Q$2;'C:\Users\STAPS\Documents\projet REDD\article #2\[data+figures.xlsx]qPCR UPS-ATG'!$S$2;'C:\Users\STAPS\Documents\projet REDD\article #2\[data+figures.xlsx]qPCR UPS-ATG'!$U$2;'C:\Users\STAPS\Documents\projet REDD\article #2\[data+figures.xlsx]qPCR UPS-ATG'!$W$2;'C:\Users\STAPS\Documents\projet REDD\article #2\[data+figures.xlsx]qPCR UPS-ATG'!$Y$2;'C:\Users\STAPS\Documents\projet REDD\article #2\[data+figures.xlsx]qPCR UPS-ATG'!$AA$2)</c:f>
                <c:numCache>
                  <c:formatCode>General</c:formatCode>
                  <c:ptCount val="11"/>
                  <c:pt idx="0">
                    <c:v>0.10943685930012552</c:v>
                  </c:pt>
                  <c:pt idx="1">
                    <c:v>0.13269398098804425</c:v>
                  </c:pt>
                  <c:pt idx="2">
                    <c:v>0.15689658905693257</c:v>
                  </c:pt>
                  <c:pt idx="3">
                    <c:v>8.6801799054389672E-2</c:v>
                  </c:pt>
                  <c:pt idx="4">
                    <c:v>0.11465357653973161</c:v>
                  </c:pt>
                  <c:pt idx="5">
                    <c:v>0.12960802038059419</c:v>
                  </c:pt>
                  <c:pt idx="6">
                    <c:v>4.5507365333409835E-2</c:v>
                  </c:pt>
                  <c:pt idx="7">
                    <c:v>0.1156506376768951</c:v>
                  </c:pt>
                  <c:pt idx="8">
                    <c:v>7.1590270652699031E-2</c:v>
                  </c:pt>
                  <c:pt idx="9">
                    <c:v>0.35</c:v>
                  </c:pt>
                  <c:pt idx="10">
                    <c:v>0.212088130276506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C:\Users\STAPS\Documents\projet REDD\article #2\[data+figures.xlsx]qPCR UPS-ATG'!$F$1;'C:\Users\STAPS\Documents\projet REDD\article #2\[data+figures.xlsx]qPCR UPS-ATG'!$H$1;'C:\Users\STAPS\Documents\projet REDD\article #2\[data+figures.xlsx]qPCR UPS-ATG'!$J$1;'C:\Users\STAPS\Documents\projet REDD\article #2\[data+figures.xlsx]qPCR UPS-ATG'!$L$1;'C:\Users\STAPS\Documents\projet REDD\article #2\[data+figures.xlsx]qPCR UPS-ATG'!$N$1;'C:\Users\STAPS\Documents\projet REDD\article #2\[data+figures.xlsx]qPCR UPS-ATG'!$P$1;'C:\Users\STAPS\Documents\projet REDD\article #2\[data+figures.xlsx]qPCR UPS-ATG'!$R$1;'C:\Users\STAPS\Documents\projet REDD\article #2\[data+figures.xlsx]qPCR UPS-ATG'!$T$1;'C:\Users\STAPS\Documents\projet REDD\article #2\[data+figures.xlsx]qPCR UPS-ATG'!$V$1;'C:\Users\STAPS\Documents\projet REDD\article #2\[data+figures.xlsx]qPCR UPS-ATG'!$X$1;'C:\Users\STAPS\Documents\projet REDD\article #2\[data+figures.xlsx]qPCR UPS-ATG'!$Z$1)</c:f>
              <c:strCache>
                <c:ptCount val="11"/>
                <c:pt idx="0">
                  <c:v>FOXO1</c:v>
                </c:pt>
                <c:pt idx="1">
                  <c:v>FOXO3A</c:v>
                </c:pt>
                <c:pt idx="2">
                  <c:v>MAFbx</c:v>
                </c:pt>
                <c:pt idx="3">
                  <c:v>MuRF1</c:v>
                </c:pt>
                <c:pt idx="4">
                  <c:v>BNIP3</c:v>
                </c:pt>
                <c:pt idx="5">
                  <c:v>CathL</c:v>
                </c:pt>
                <c:pt idx="6">
                  <c:v>Gabarapl</c:v>
                </c:pt>
                <c:pt idx="7">
                  <c:v>LAMP2A</c:v>
                </c:pt>
                <c:pt idx="8">
                  <c:v>LC3</c:v>
                </c:pt>
                <c:pt idx="9">
                  <c:v>REDD1</c:v>
                </c:pt>
                <c:pt idx="10">
                  <c:v>REDD2</c:v>
                </c:pt>
              </c:strCache>
            </c:strRef>
          </c:cat>
          <c:val>
            <c:numRef>
              <c:f>('C:\Users\STAPS\Documents\projet REDD\article #2\[data+figures.xlsx]qPCR UPS-ATG'!$F$2;'C:\Users\STAPS\Documents\projet REDD\article #2\[data+figures.xlsx]qPCR UPS-ATG'!$H$2;'C:\Users\STAPS\Documents\projet REDD\article #2\[data+figures.xlsx]qPCR UPS-ATG'!$J$2;'C:\Users\STAPS\Documents\projet REDD\article #2\[data+figures.xlsx]qPCR UPS-ATG'!$L$2;'C:\Users\STAPS\Documents\projet REDD\article #2\[data+figures.xlsx]qPCR UPS-ATG'!$N$2;'C:\Users\STAPS\Documents\projet REDD\article #2\[data+figures.xlsx]qPCR UPS-ATG'!$P$2;'C:\Users\STAPS\Documents\projet REDD\article #2\[data+figures.xlsx]qPCR UPS-ATG'!$R$2;'C:\Users\STAPS\Documents\projet REDD\article #2\[data+figures.xlsx]qPCR UPS-ATG'!$T$2;'C:\Users\STAPS\Documents\projet REDD\article #2\[data+figures.xlsx]qPCR UPS-ATG'!$V$2;'C:\Users\STAPS\Documents\projet REDD\article #2\[data+figures.xlsx]qPCR UPS-ATG'!$X$2;'C:\Users\STAPS\Documents\projet REDD\article #2\[data+figures.xlsx]qPCR UPS-ATG'!$Z$2)</c:f>
              <c:numCache>
                <c:formatCode>General</c:formatCode>
                <c:ptCount val="11"/>
                <c:pt idx="0">
                  <c:v>1</c:v>
                </c:pt>
                <c:pt idx="1">
                  <c:v>0.99999999999999989</c:v>
                </c:pt>
                <c:pt idx="2">
                  <c:v>0.99999999999999978</c:v>
                </c:pt>
                <c:pt idx="3">
                  <c:v>1</c:v>
                </c:pt>
                <c:pt idx="4">
                  <c:v>1.0000000000000002</c:v>
                </c:pt>
                <c:pt idx="5">
                  <c:v>1</c:v>
                </c:pt>
                <c:pt idx="6">
                  <c:v>1.0000000000000002</c:v>
                </c:pt>
                <c:pt idx="7">
                  <c:v>0.99999999999999989</c:v>
                </c:pt>
                <c:pt idx="8">
                  <c:v>1.0000000000000002</c:v>
                </c:pt>
                <c:pt idx="9">
                  <c:v>1</c:v>
                </c:pt>
                <c:pt idx="1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DA7-4691-B12B-92D7E07EB580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5DA7-4691-B12B-92D7E07EB580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5DA7-4691-B12B-92D7E07EB580}"/>
              </c:ext>
            </c:extLst>
          </c:dPt>
          <c:errBars>
            <c:errBarType val="plus"/>
            <c:errValType val="cust"/>
            <c:noEndCap val="0"/>
            <c:plus>
              <c:numRef>
                <c:f>('C:\Users\STAPS\Documents\projet REDD\article #2\[data+figures.xlsx]qPCR UPS-ATG'!$G$3;'C:\Users\STAPS\Documents\projet REDD\article #2\[data+figures.xlsx]qPCR UPS-ATG'!$I$3;'C:\Users\STAPS\Documents\projet REDD\article #2\[data+figures.xlsx]qPCR UPS-ATG'!$K$3;'C:\Users\STAPS\Documents\projet REDD\article #2\[data+figures.xlsx]qPCR UPS-ATG'!$M$3;'C:\Users\STAPS\Documents\projet REDD\article #2\[data+figures.xlsx]qPCR UPS-ATG'!$O$3;'C:\Users\STAPS\Documents\projet REDD\article #2\[data+figures.xlsx]qPCR UPS-ATG'!$Q$3;'C:\Users\STAPS\Documents\projet REDD\article #2\[data+figures.xlsx]qPCR UPS-ATG'!$S$3;'C:\Users\STAPS\Documents\projet REDD\article #2\[data+figures.xlsx]qPCR UPS-ATG'!$U$3;'C:\Users\STAPS\Documents\projet REDD\article #2\[data+figures.xlsx]qPCR UPS-ATG'!$W$3;'C:\Users\STAPS\Documents\projet REDD\article #2\[data+figures.xlsx]qPCR UPS-ATG'!$Y$3;'C:\Users\STAPS\Documents\projet REDD\article #2\[data+figures.xlsx]qPCR UPS-ATG'!$AA$3)</c:f>
                <c:numCache>
                  <c:formatCode>General</c:formatCode>
                  <c:ptCount val="11"/>
                  <c:pt idx="0">
                    <c:v>2.6989449552523151E-2</c:v>
                  </c:pt>
                  <c:pt idx="1">
                    <c:v>0.14517907798276625</c:v>
                  </c:pt>
                  <c:pt idx="2">
                    <c:v>0.12433435110132517</c:v>
                  </c:pt>
                  <c:pt idx="3">
                    <c:v>8.9552975435552656E-2</c:v>
                  </c:pt>
                  <c:pt idx="4">
                    <c:v>5.2218605556535916E-2</c:v>
                  </c:pt>
                  <c:pt idx="5">
                    <c:v>8.3000000000000004E-2</c:v>
                  </c:pt>
                  <c:pt idx="6">
                    <c:v>0.13434095695689324</c:v>
                  </c:pt>
                  <c:pt idx="7">
                    <c:v>0.13742434999751557</c:v>
                  </c:pt>
                  <c:pt idx="8">
                    <c:v>0.15348035961923148</c:v>
                  </c:pt>
                  <c:pt idx="9">
                    <c:v>0.31</c:v>
                  </c:pt>
                  <c:pt idx="10">
                    <c:v>0.193360533772817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C:\Users\STAPS\Documents\projet REDD\article #2\[data+figures.xlsx]qPCR UPS-ATG'!$F$1;'C:\Users\STAPS\Documents\projet REDD\article #2\[data+figures.xlsx]qPCR UPS-ATG'!$H$1;'C:\Users\STAPS\Documents\projet REDD\article #2\[data+figures.xlsx]qPCR UPS-ATG'!$J$1;'C:\Users\STAPS\Documents\projet REDD\article #2\[data+figures.xlsx]qPCR UPS-ATG'!$L$1;'C:\Users\STAPS\Documents\projet REDD\article #2\[data+figures.xlsx]qPCR UPS-ATG'!$N$1;'C:\Users\STAPS\Documents\projet REDD\article #2\[data+figures.xlsx]qPCR UPS-ATG'!$P$1;'C:\Users\STAPS\Documents\projet REDD\article #2\[data+figures.xlsx]qPCR UPS-ATG'!$R$1;'C:\Users\STAPS\Documents\projet REDD\article #2\[data+figures.xlsx]qPCR UPS-ATG'!$T$1;'C:\Users\STAPS\Documents\projet REDD\article #2\[data+figures.xlsx]qPCR UPS-ATG'!$V$1;'C:\Users\STAPS\Documents\projet REDD\article #2\[data+figures.xlsx]qPCR UPS-ATG'!$X$1;'C:\Users\STAPS\Documents\projet REDD\article #2\[data+figures.xlsx]qPCR UPS-ATG'!$Z$1)</c:f>
              <c:strCache>
                <c:ptCount val="11"/>
                <c:pt idx="0">
                  <c:v>FOXO1</c:v>
                </c:pt>
                <c:pt idx="1">
                  <c:v>FOXO3A</c:v>
                </c:pt>
                <c:pt idx="2">
                  <c:v>MAFbx</c:v>
                </c:pt>
                <c:pt idx="3">
                  <c:v>MuRF1</c:v>
                </c:pt>
                <c:pt idx="4">
                  <c:v>BNIP3</c:v>
                </c:pt>
                <c:pt idx="5">
                  <c:v>CathL</c:v>
                </c:pt>
                <c:pt idx="6">
                  <c:v>Gabarapl</c:v>
                </c:pt>
                <c:pt idx="7">
                  <c:v>LAMP2A</c:v>
                </c:pt>
                <c:pt idx="8">
                  <c:v>LC3</c:v>
                </c:pt>
                <c:pt idx="9">
                  <c:v>REDD1</c:v>
                </c:pt>
                <c:pt idx="10">
                  <c:v>REDD2</c:v>
                </c:pt>
              </c:strCache>
            </c:strRef>
          </c:cat>
          <c:val>
            <c:numRef>
              <c:f>('C:\Users\STAPS\Documents\projet REDD\article #2\[data+figures.xlsx]qPCR UPS-ATG'!$F$3;'C:\Users\STAPS\Documents\projet REDD\article #2\[data+figures.xlsx]qPCR UPS-ATG'!$H$3;'C:\Users\STAPS\Documents\projet REDD\article #2\[data+figures.xlsx]qPCR UPS-ATG'!$J$3;'C:\Users\STAPS\Documents\projet REDD\article #2\[data+figures.xlsx]qPCR UPS-ATG'!$L$3;'C:\Users\STAPS\Documents\projet REDD\article #2\[data+figures.xlsx]qPCR UPS-ATG'!$N$3;'C:\Users\STAPS\Documents\projet REDD\article #2\[data+figures.xlsx]qPCR UPS-ATG'!$P$3;'C:\Users\STAPS\Documents\projet REDD\article #2\[data+figures.xlsx]qPCR UPS-ATG'!$R$3;'C:\Users\STAPS\Documents\projet REDD\article #2\[data+figures.xlsx]qPCR UPS-ATG'!$T$3;'C:\Users\STAPS\Documents\projet REDD\article #2\[data+figures.xlsx]qPCR UPS-ATG'!$V$3;'C:\Users\STAPS\Documents\projet REDD\article #2\[data+figures.xlsx]qPCR UPS-ATG'!$X$3;'C:\Users\STAPS\Documents\projet REDD\article #2\[data+figures.xlsx]qPCR UPS-ATG'!$Z$3)</c:f>
              <c:numCache>
                <c:formatCode>General</c:formatCode>
                <c:ptCount val="11"/>
                <c:pt idx="0">
                  <c:v>0.79736846309763698</c:v>
                </c:pt>
                <c:pt idx="1">
                  <c:v>0.85265861333419857</c:v>
                </c:pt>
                <c:pt idx="2">
                  <c:v>1.0521481356896838</c:v>
                </c:pt>
                <c:pt idx="3">
                  <c:v>1.0631730540753497</c:v>
                </c:pt>
                <c:pt idx="4">
                  <c:v>0.91063597634254034</c:v>
                </c:pt>
                <c:pt idx="5">
                  <c:v>1.0129999999999999</c:v>
                </c:pt>
                <c:pt idx="6">
                  <c:v>1.3509723114667724</c:v>
                </c:pt>
                <c:pt idx="7">
                  <c:v>1.1697415539934617</c:v>
                </c:pt>
                <c:pt idx="8">
                  <c:v>1.2091701584786656</c:v>
                </c:pt>
                <c:pt idx="9">
                  <c:v>1.9</c:v>
                </c:pt>
                <c:pt idx="10">
                  <c:v>1.1424939229878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DA7-4691-B12B-92D7E07EB580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C:\Users\STAPS\Documents\projet REDD\article #2\[data+figures.xlsx]qPCR UPS-ATG'!$G$4;'C:\Users\STAPS\Documents\projet REDD\article #2\[data+figures.xlsx]qPCR UPS-ATG'!$I$4;'C:\Users\STAPS\Documents\projet REDD\article #2\[data+figures.xlsx]qPCR UPS-ATG'!$K$4;'C:\Users\STAPS\Documents\projet REDD\article #2\[data+figures.xlsx]qPCR UPS-ATG'!$M$4;'C:\Users\STAPS\Documents\projet REDD\article #2\[data+figures.xlsx]qPCR UPS-ATG'!$O$4;'C:\Users\STAPS\Documents\projet REDD\article #2\[data+figures.xlsx]qPCR UPS-ATG'!$Q$4;'C:\Users\STAPS\Documents\projet REDD\article #2\[data+figures.xlsx]qPCR UPS-ATG'!$S$4;'C:\Users\STAPS\Documents\projet REDD\article #2\[data+figures.xlsx]qPCR UPS-ATG'!$U$4;'C:\Users\STAPS\Documents\projet REDD\article #2\[data+figures.xlsx]qPCR UPS-ATG'!$W$4;'C:\Users\STAPS\Documents\projet REDD\article #2\[data+figures.xlsx]qPCR UPS-ATG'!$Y$4;'C:\Users\STAPS\Documents\projet REDD\article #2\[data+figures.xlsx]qPCR UPS-ATG'!$AA$4)</c:f>
                <c:numCache>
                  <c:formatCode>General</c:formatCode>
                  <c:ptCount val="11"/>
                  <c:pt idx="0">
                    <c:v>0.11059420043121096</c:v>
                  </c:pt>
                  <c:pt idx="1">
                    <c:v>0.17912545777993161</c:v>
                  </c:pt>
                  <c:pt idx="2">
                    <c:v>0.20376732550144855</c:v>
                  </c:pt>
                  <c:pt idx="3">
                    <c:v>0.11623571779566376</c:v>
                  </c:pt>
                  <c:pt idx="4">
                    <c:v>0.12408198741843535</c:v>
                  </c:pt>
                  <c:pt idx="5">
                    <c:v>0.12524307576986626</c:v>
                  </c:pt>
                  <c:pt idx="6">
                    <c:v>0.13385566144663169</c:v>
                  </c:pt>
                  <c:pt idx="7">
                    <c:v>0.13025713966280963</c:v>
                  </c:pt>
                  <c:pt idx="8">
                    <c:v>8.6482137889810448E-2</c:v>
                  </c:pt>
                  <c:pt idx="10">
                    <c:v>9.85369967317503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C:\Users\STAPS\Documents\projet REDD\article #2\[data+figures.xlsx]qPCR UPS-ATG'!$F$1;'C:\Users\STAPS\Documents\projet REDD\article #2\[data+figures.xlsx]qPCR UPS-ATG'!$H$1;'C:\Users\STAPS\Documents\projet REDD\article #2\[data+figures.xlsx]qPCR UPS-ATG'!$J$1;'C:\Users\STAPS\Documents\projet REDD\article #2\[data+figures.xlsx]qPCR UPS-ATG'!$L$1;'C:\Users\STAPS\Documents\projet REDD\article #2\[data+figures.xlsx]qPCR UPS-ATG'!$N$1;'C:\Users\STAPS\Documents\projet REDD\article #2\[data+figures.xlsx]qPCR UPS-ATG'!$P$1;'C:\Users\STAPS\Documents\projet REDD\article #2\[data+figures.xlsx]qPCR UPS-ATG'!$R$1;'C:\Users\STAPS\Documents\projet REDD\article #2\[data+figures.xlsx]qPCR UPS-ATG'!$T$1;'C:\Users\STAPS\Documents\projet REDD\article #2\[data+figures.xlsx]qPCR UPS-ATG'!$V$1;'C:\Users\STAPS\Documents\projet REDD\article #2\[data+figures.xlsx]qPCR UPS-ATG'!$X$1;'C:\Users\STAPS\Documents\projet REDD\article #2\[data+figures.xlsx]qPCR UPS-ATG'!$Z$1)</c:f>
              <c:strCache>
                <c:ptCount val="11"/>
                <c:pt idx="0">
                  <c:v>FOXO1</c:v>
                </c:pt>
                <c:pt idx="1">
                  <c:v>FOXO3A</c:v>
                </c:pt>
                <c:pt idx="2">
                  <c:v>MAFbx</c:v>
                </c:pt>
                <c:pt idx="3">
                  <c:v>MuRF1</c:v>
                </c:pt>
                <c:pt idx="4">
                  <c:v>BNIP3</c:v>
                </c:pt>
                <c:pt idx="5">
                  <c:v>CathL</c:v>
                </c:pt>
                <c:pt idx="6">
                  <c:v>Gabarapl</c:v>
                </c:pt>
                <c:pt idx="7">
                  <c:v>LAMP2A</c:v>
                </c:pt>
                <c:pt idx="8">
                  <c:v>LC3</c:v>
                </c:pt>
                <c:pt idx="9">
                  <c:v>REDD1</c:v>
                </c:pt>
                <c:pt idx="10">
                  <c:v>REDD2</c:v>
                </c:pt>
              </c:strCache>
            </c:strRef>
          </c:cat>
          <c:val>
            <c:numRef>
              <c:f>('C:\Users\STAPS\Documents\projet REDD\article #2\[data+figures.xlsx]qPCR UPS-ATG'!$F$4;'C:\Users\STAPS\Documents\projet REDD\article #2\[data+figures.xlsx]qPCR UPS-ATG'!$H$4;'C:\Users\STAPS\Documents\projet REDD\article #2\[data+figures.xlsx]qPCR UPS-ATG'!$J$4;'C:\Users\STAPS\Documents\projet REDD\article #2\[data+figures.xlsx]qPCR UPS-ATG'!$L$4;'C:\Users\STAPS\Documents\projet REDD\article #2\[data+figures.xlsx]qPCR UPS-ATG'!$N$4;'C:\Users\STAPS\Documents\projet REDD\article #2\[data+figures.xlsx]qPCR UPS-ATG'!$P$4;'C:\Users\STAPS\Documents\projet REDD\article #2\[data+figures.xlsx]qPCR UPS-ATG'!$R$4;'C:\Users\STAPS\Documents\projet REDD\article #2\[data+figures.xlsx]qPCR UPS-ATG'!$T$4;'C:\Users\STAPS\Documents\projet REDD\article #2\[data+figures.xlsx]qPCR UPS-ATG'!$V$4;'C:\Users\STAPS\Documents\projet REDD\article #2\[data+figures.xlsx]qPCR UPS-ATG'!$X$4;'C:\Users\STAPS\Documents\projet REDD\article #2\[data+figures.xlsx]qPCR UPS-ATG'!$Z$4)</c:f>
              <c:numCache>
                <c:formatCode>General</c:formatCode>
                <c:ptCount val="11"/>
                <c:pt idx="0">
                  <c:v>0.95761129975447357</c:v>
                </c:pt>
                <c:pt idx="1">
                  <c:v>1.1017326168871386</c:v>
                </c:pt>
                <c:pt idx="2">
                  <c:v>1.1056153338172485</c:v>
                </c:pt>
                <c:pt idx="3">
                  <c:v>0.98174245567536289</c:v>
                </c:pt>
                <c:pt idx="4">
                  <c:v>1.2903208924605525</c:v>
                </c:pt>
                <c:pt idx="5">
                  <c:v>0.97510407571074997</c:v>
                </c:pt>
                <c:pt idx="6">
                  <c:v>1.2883392753380249</c:v>
                </c:pt>
                <c:pt idx="7">
                  <c:v>1.0048824559628369</c:v>
                </c:pt>
                <c:pt idx="8">
                  <c:v>1.0609618749478791</c:v>
                </c:pt>
                <c:pt idx="10">
                  <c:v>1.09078215664403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DA7-4691-B12B-92D7E07EB580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C:\Users\STAPS\Documents\projet REDD\article #2\[data+figures.xlsx]qPCR UPS-ATG'!$G$5;'C:\Users\STAPS\Documents\projet REDD\article #2\[data+figures.xlsx]qPCR UPS-ATG'!$I$5;'C:\Users\STAPS\Documents\projet REDD\article #2\[data+figures.xlsx]qPCR UPS-ATG'!$K$5;'C:\Users\STAPS\Documents\projet REDD\article #2\[data+figures.xlsx]qPCR UPS-ATG'!$M$5;'C:\Users\STAPS\Documents\projet REDD\article #2\[data+figures.xlsx]qPCR UPS-ATG'!$O$5;'C:\Users\STAPS\Documents\projet REDD\article #2\[data+figures.xlsx]qPCR UPS-ATG'!$Q$5;'C:\Users\STAPS\Documents\projet REDD\article #2\[data+figures.xlsx]qPCR UPS-ATG'!$S$5;'C:\Users\STAPS\Documents\projet REDD\article #2\[data+figures.xlsx]qPCR UPS-ATG'!$U$5;'C:\Users\STAPS\Documents\projet REDD\article #2\[data+figures.xlsx]qPCR UPS-ATG'!$W$5;'C:\Users\STAPS\Documents\projet REDD\article #2\[data+figures.xlsx]qPCR UPS-ATG'!$Y$5;'C:\Users\STAPS\Documents\projet REDD\article #2\[data+figures.xlsx]qPCR UPS-ATG'!$AA$5)</c:f>
                <c:numCache>
                  <c:formatCode>General</c:formatCode>
                  <c:ptCount val="11"/>
                  <c:pt idx="0">
                    <c:v>0.15791825551614475</c:v>
                  </c:pt>
                  <c:pt idx="1">
                    <c:v>0.17418153019174068</c:v>
                  </c:pt>
                  <c:pt idx="2">
                    <c:v>0.46591625769750727</c:v>
                  </c:pt>
                  <c:pt idx="3">
                    <c:v>0.17299999999999999</c:v>
                  </c:pt>
                  <c:pt idx="4">
                    <c:v>0.1793581287524256</c:v>
                  </c:pt>
                  <c:pt idx="5">
                    <c:v>0.21013520883227071</c:v>
                  </c:pt>
                  <c:pt idx="6">
                    <c:v>0.28853445906713132</c:v>
                  </c:pt>
                  <c:pt idx="7">
                    <c:v>0.1675772393183626</c:v>
                  </c:pt>
                  <c:pt idx="8">
                    <c:v>0.13314364269194529</c:v>
                  </c:pt>
                  <c:pt idx="10">
                    <c:v>0.191340916284752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C:\Users\STAPS\Documents\projet REDD\article #2\[data+figures.xlsx]qPCR UPS-ATG'!$F$1;'C:\Users\STAPS\Documents\projet REDD\article #2\[data+figures.xlsx]qPCR UPS-ATG'!$H$1;'C:\Users\STAPS\Documents\projet REDD\article #2\[data+figures.xlsx]qPCR UPS-ATG'!$J$1;'C:\Users\STAPS\Documents\projet REDD\article #2\[data+figures.xlsx]qPCR UPS-ATG'!$L$1;'C:\Users\STAPS\Documents\projet REDD\article #2\[data+figures.xlsx]qPCR UPS-ATG'!$N$1;'C:\Users\STAPS\Documents\projet REDD\article #2\[data+figures.xlsx]qPCR UPS-ATG'!$P$1;'C:\Users\STAPS\Documents\projet REDD\article #2\[data+figures.xlsx]qPCR UPS-ATG'!$R$1;'C:\Users\STAPS\Documents\projet REDD\article #2\[data+figures.xlsx]qPCR UPS-ATG'!$T$1;'C:\Users\STAPS\Documents\projet REDD\article #2\[data+figures.xlsx]qPCR UPS-ATG'!$V$1;'C:\Users\STAPS\Documents\projet REDD\article #2\[data+figures.xlsx]qPCR UPS-ATG'!$X$1;'C:\Users\STAPS\Documents\projet REDD\article #2\[data+figures.xlsx]qPCR UPS-ATG'!$Z$1)</c:f>
              <c:strCache>
                <c:ptCount val="11"/>
                <c:pt idx="0">
                  <c:v>FOXO1</c:v>
                </c:pt>
                <c:pt idx="1">
                  <c:v>FOXO3A</c:v>
                </c:pt>
                <c:pt idx="2">
                  <c:v>MAFbx</c:v>
                </c:pt>
                <c:pt idx="3">
                  <c:v>MuRF1</c:v>
                </c:pt>
                <c:pt idx="4">
                  <c:v>BNIP3</c:v>
                </c:pt>
                <c:pt idx="5">
                  <c:v>CathL</c:v>
                </c:pt>
                <c:pt idx="6">
                  <c:v>Gabarapl</c:v>
                </c:pt>
                <c:pt idx="7">
                  <c:v>LAMP2A</c:v>
                </c:pt>
                <c:pt idx="8">
                  <c:v>LC3</c:v>
                </c:pt>
                <c:pt idx="9">
                  <c:v>REDD1</c:v>
                </c:pt>
                <c:pt idx="10">
                  <c:v>REDD2</c:v>
                </c:pt>
              </c:strCache>
            </c:strRef>
          </c:cat>
          <c:val>
            <c:numRef>
              <c:f>('C:\Users\STAPS\Documents\projet REDD\article #2\[data+figures.xlsx]qPCR UPS-ATG'!$F$5;'C:\Users\STAPS\Documents\projet REDD\article #2\[data+figures.xlsx]qPCR UPS-ATG'!$H$5;'C:\Users\STAPS\Documents\projet REDD\article #2\[data+figures.xlsx]qPCR UPS-ATG'!$J$5;'C:\Users\STAPS\Documents\projet REDD\article #2\[data+figures.xlsx]qPCR UPS-ATG'!$L$5;'C:\Users\STAPS\Documents\projet REDD\article #2\[data+figures.xlsx]qPCR UPS-ATG'!$N$5;'C:\Users\STAPS\Documents\projet REDD\article #2\[data+figures.xlsx]qPCR UPS-ATG'!$P$5;'C:\Users\STAPS\Documents\projet REDD\article #2\[data+figures.xlsx]qPCR UPS-ATG'!$R$5;'C:\Users\STAPS\Documents\projet REDD\article #2\[data+figures.xlsx]qPCR UPS-ATG'!$T$5;'C:\Users\STAPS\Documents\projet REDD\article #2\[data+figures.xlsx]qPCR UPS-ATG'!$V$5;'C:\Users\STAPS\Documents\projet REDD\article #2\[data+figures.xlsx]qPCR UPS-ATG'!$X$5;'C:\Users\STAPS\Documents\projet REDD\article #2\[data+figures.xlsx]qPCR UPS-ATG'!$Z$5)</c:f>
              <c:numCache>
                <c:formatCode>General</c:formatCode>
                <c:ptCount val="11"/>
                <c:pt idx="0">
                  <c:v>1.494344538684345</c:v>
                </c:pt>
                <c:pt idx="1">
                  <c:v>1.314985330801953</c:v>
                </c:pt>
                <c:pt idx="2">
                  <c:v>1.8007</c:v>
                </c:pt>
                <c:pt idx="3">
                  <c:v>1.3075129890517065</c:v>
                </c:pt>
                <c:pt idx="4">
                  <c:v>1.7296836092244161</c:v>
                </c:pt>
                <c:pt idx="5">
                  <c:v>1.3525066063803879</c:v>
                </c:pt>
                <c:pt idx="6">
                  <c:v>1.9121615529394456</c:v>
                </c:pt>
                <c:pt idx="7">
                  <c:v>1.4697580044583696</c:v>
                </c:pt>
                <c:pt idx="8">
                  <c:v>1.2038756979062459</c:v>
                </c:pt>
                <c:pt idx="10">
                  <c:v>0.71036064100729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DA7-4691-B12B-92D7E07EB5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368192"/>
        <c:axId val="79369728"/>
      </c:barChart>
      <c:catAx>
        <c:axId val="79368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79369728"/>
        <c:crosses val="autoZero"/>
        <c:auto val="1"/>
        <c:lblAlgn val="ctr"/>
        <c:lblOffset val="100"/>
        <c:noMultiLvlLbl val="0"/>
      </c:catAx>
      <c:valAx>
        <c:axId val="7936972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79368192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E1A5-44E3-8284-419CA629E52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E1A5-44E3-8284-419CA629E52B}"/>
              </c:ext>
            </c:extLst>
          </c:dPt>
          <c:errBars>
            <c:errBarType val="plus"/>
            <c:errValType val="cust"/>
            <c:noEndCap val="0"/>
            <c:plus>
              <c:numRef>
                <c:f>('[data+figures.xlsx]REDOX'!$J$2,'[data+figures.xlsx]REDOX'!$L$2,'[data+figures.xlsx]REDOX'!$N$2)</c:f>
                <c:numCache>
                  <c:formatCode>General</c:formatCode>
                  <c:ptCount val="3"/>
                  <c:pt idx="0">
                    <c:v>8.7417323018927198E-2</c:v>
                  </c:pt>
                  <c:pt idx="1">
                    <c:v>0.08</c:v>
                  </c:pt>
                  <c:pt idx="2">
                    <c:v>0.151611548337668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[data+figures.xlsx]REDOX'!$I$1,'[data+figures.xlsx]REDOX'!$K$1,'[data+figures.xlsx]REDOX'!$M$1)</c:f>
              <c:strCache>
                <c:ptCount val="3"/>
                <c:pt idx="0">
                  <c:v>GPx</c:v>
                </c:pt>
                <c:pt idx="1">
                  <c:v>TRX</c:v>
                </c:pt>
                <c:pt idx="2">
                  <c:v>TXNIP</c:v>
                </c:pt>
              </c:strCache>
            </c:strRef>
          </c:cat>
          <c:val>
            <c:numRef>
              <c:f>('[data+figures.xlsx]REDOX'!$I$2,'[data+figures.xlsx]REDOX'!$K$2,'[data+figures.xlsx]REDOX'!$M$2)</c:f>
              <c:numCache>
                <c:formatCode>General</c:formatCode>
                <c:ptCount val="3"/>
                <c:pt idx="0">
                  <c:v>1.0000000000000002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1A5-44E3-8284-419CA629E52B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E1A5-44E3-8284-419CA629E52B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E1A5-44E3-8284-419CA629E52B}"/>
              </c:ext>
            </c:extLst>
          </c:dPt>
          <c:errBars>
            <c:errBarType val="plus"/>
            <c:errValType val="cust"/>
            <c:noEndCap val="0"/>
            <c:plus>
              <c:numRef>
                <c:f>('[data+figures.xlsx]REDOX'!$J$3,'[data+figures.xlsx]REDOX'!$L$3,'[data+figures.xlsx]REDOX'!$N$3)</c:f>
                <c:numCache>
                  <c:formatCode>General</c:formatCode>
                  <c:ptCount val="3"/>
                  <c:pt idx="0">
                    <c:v>0.12836597223966478</c:v>
                  </c:pt>
                  <c:pt idx="1">
                    <c:v>0.09</c:v>
                  </c:pt>
                  <c:pt idx="2">
                    <c:v>0.122777816543534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[data+figures.xlsx]REDOX'!$I$1,'[data+figures.xlsx]REDOX'!$K$1,'[data+figures.xlsx]REDOX'!$M$1)</c:f>
              <c:strCache>
                <c:ptCount val="3"/>
                <c:pt idx="0">
                  <c:v>GPx</c:v>
                </c:pt>
                <c:pt idx="1">
                  <c:v>TRX</c:v>
                </c:pt>
                <c:pt idx="2">
                  <c:v>TXNIP</c:v>
                </c:pt>
              </c:strCache>
            </c:strRef>
          </c:cat>
          <c:val>
            <c:numRef>
              <c:f>('[data+figures.xlsx]REDOX'!$I$3,'[data+figures.xlsx]REDOX'!$K$3,'[data+figures.xlsx]REDOX'!$M$3)</c:f>
              <c:numCache>
                <c:formatCode>General</c:formatCode>
                <c:ptCount val="3"/>
                <c:pt idx="0">
                  <c:v>1.6521898024838755</c:v>
                </c:pt>
                <c:pt idx="1">
                  <c:v>0.96</c:v>
                </c:pt>
                <c:pt idx="2">
                  <c:v>0.538212130876156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1A5-44E3-8284-419CA629E52B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[data+figures.xlsx]REDOX'!$J$4,'[data+figures.xlsx]REDOX'!$L$4,'[data+figures.xlsx]REDOX'!$N$4)</c:f>
                <c:numCache>
                  <c:formatCode>General</c:formatCode>
                  <c:ptCount val="3"/>
                  <c:pt idx="0">
                    <c:v>0.16647290587206112</c:v>
                  </c:pt>
                  <c:pt idx="1">
                    <c:v>0.05</c:v>
                  </c:pt>
                  <c:pt idx="2">
                    <c:v>5.223461971601804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[data+figures.xlsx]REDOX'!$I$1,'[data+figures.xlsx]REDOX'!$K$1,'[data+figures.xlsx]REDOX'!$M$1)</c:f>
              <c:strCache>
                <c:ptCount val="3"/>
                <c:pt idx="0">
                  <c:v>GPx</c:v>
                </c:pt>
                <c:pt idx="1">
                  <c:v>TRX</c:v>
                </c:pt>
                <c:pt idx="2">
                  <c:v>TXNIP</c:v>
                </c:pt>
              </c:strCache>
            </c:strRef>
          </c:cat>
          <c:val>
            <c:numRef>
              <c:f>('[data+figures.xlsx]REDOX'!$I$4,'[data+figures.xlsx]REDOX'!$K$4,'[data+figures.xlsx]REDOX'!$M$4)</c:f>
              <c:numCache>
                <c:formatCode>General</c:formatCode>
                <c:ptCount val="3"/>
                <c:pt idx="0">
                  <c:v>1.1364881482683593</c:v>
                </c:pt>
                <c:pt idx="1">
                  <c:v>0.98</c:v>
                </c:pt>
                <c:pt idx="2">
                  <c:v>0.69538051496284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1A5-44E3-8284-419CA629E52B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[data+figures.xlsx]REDOX'!$J$5,'[data+figures.xlsx]REDOX'!$L$5,'[data+figures.xlsx]REDOX'!$N$5)</c:f>
                <c:numCache>
                  <c:formatCode>General</c:formatCode>
                  <c:ptCount val="3"/>
                  <c:pt idx="0">
                    <c:v>0.25565787146039987</c:v>
                  </c:pt>
                  <c:pt idx="1">
                    <c:v>7.0000000000000007E-2</c:v>
                  </c:pt>
                  <c:pt idx="2">
                    <c:v>5.896499133329470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[data+figures.xlsx]REDOX'!$I$1,'[data+figures.xlsx]REDOX'!$K$1,'[data+figures.xlsx]REDOX'!$M$1)</c:f>
              <c:strCache>
                <c:ptCount val="3"/>
                <c:pt idx="0">
                  <c:v>GPx</c:v>
                </c:pt>
                <c:pt idx="1">
                  <c:v>TRX</c:v>
                </c:pt>
                <c:pt idx="2">
                  <c:v>TXNIP</c:v>
                </c:pt>
              </c:strCache>
            </c:strRef>
          </c:cat>
          <c:val>
            <c:numRef>
              <c:f>('[data+figures.xlsx]REDOX'!$I$5,'[data+figures.xlsx]REDOX'!$K$5,'[data+figures.xlsx]REDOX'!$M$5)</c:f>
              <c:numCache>
                <c:formatCode>General</c:formatCode>
                <c:ptCount val="3"/>
                <c:pt idx="0">
                  <c:v>1.8021723104847116</c:v>
                </c:pt>
                <c:pt idx="1">
                  <c:v>0.99</c:v>
                </c:pt>
                <c:pt idx="2">
                  <c:v>0.38798121252473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1A5-44E3-8284-419CA629E5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303232"/>
        <c:axId val="80304768"/>
      </c:barChart>
      <c:catAx>
        <c:axId val="80303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304768"/>
        <c:crosses val="autoZero"/>
        <c:auto val="1"/>
        <c:lblAlgn val="ctr"/>
        <c:lblOffset val="100"/>
        <c:noMultiLvlLbl val="0"/>
      </c:catAx>
      <c:valAx>
        <c:axId val="8030476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crossAx val="803032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E305-49D0-9E56-EEB598379C8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E305-49D0-9E56-EEB598379C8A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C$2</c:f>
                <c:numCache>
                  <c:formatCode>General</c:formatCode>
                  <c:ptCount val="1"/>
                  <c:pt idx="0">
                    <c:v>3.83330671740545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B$1</c:f>
              <c:strCache>
                <c:ptCount val="1"/>
                <c:pt idx="0">
                  <c:v>SH</c:v>
                </c:pt>
              </c:strCache>
            </c:strRef>
          </c:cat>
          <c:val>
            <c:numRef>
              <c:f>'[data+figures.xlsx]REDOX'!$B$2</c:f>
              <c:numCache>
                <c:formatCode>General</c:formatCode>
                <c:ptCount val="1"/>
                <c:pt idx="0">
                  <c:v>68.142833505705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305-49D0-9E56-EEB598379C8A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E305-49D0-9E56-EEB598379C8A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E305-49D0-9E56-EEB598379C8A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C$3</c:f>
                <c:numCache>
                  <c:formatCode>General</c:formatCode>
                  <c:ptCount val="1"/>
                  <c:pt idx="0">
                    <c:v>4.65152699762830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B$1</c:f>
              <c:strCache>
                <c:ptCount val="1"/>
                <c:pt idx="0">
                  <c:v>SH</c:v>
                </c:pt>
              </c:strCache>
            </c:strRef>
          </c:cat>
          <c:val>
            <c:numRef>
              <c:f>'[data+figures.xlsx]REDOX'!$B$3</c:f>
              <c:numCache>
                <c:formatCode>General</c:formatCode>
                <c:ptCount val="1"/>
                <c:pt idx="0">
                  <c:v>57.785266925765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305-49D0-9E56-EEB598379C8A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C$4</c:f>
                <c:numCache>
                  <c:formatCode>General</c:formatCode>
                  <c:ptCount val="1"/>
                  <c:pt idx="0">
                    <c:v>1.89315512360997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B$1</c:f>
              <c:strCache>
                <c:ptCount val="1"/>
                <c:pt idx="0">
                  <c:v>SH</c:v>
                </c:pt>
              </c:strCache>
            </c:strRef>
          </c:cat>
          <c:val>
            <c:numRef>
              <c:f>'[data+figures.xlsx]REDOX'!$B$4</c:f>
              <c:numCache>
                <c:formatCode>General</c:formatCode>
                <c:ptCount val="1"/>
                <c:pt idx="0">
                  <c:v>69.6495353354108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305-49D0-9E56-EEB598379C8A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C$5</c:f>
                <c:numCache>
                  <c:formatCode>General</c:formatCode>
                  <c:ptCount val="1"/>
                  <c:pt idx="0">
                    <c:v>3.11171368060033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B$1</c:f>
              <c:strCache>
                <c:ptCount val="1"/>
                <c:pt idx="0">
                  <c:v>SH</c:v>
                </c:pt>
              </c:strCache>
            </c:strRef>
          </c:cat>
          <c:val>
            <c:numRef>
              <c:f>'[data+figures.xlsx]REDOX'!$B$5</c:f>
              <c:numCache>
                <c:formatCode>General</c:formatCode>
                <c:ptCount val="1"/>
                <c:pt idx="0">
                  <c:v>61.9284163796772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305-49D0-9E56-EEB598379C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163200"/>
        <c:axId val="80164736"/>
      </c:barChart>
      <c:catAx>
        <c:axId val="80163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164736"/>
        <c:crosses val="autoZero"/>
        <c:auto val="1"/>
        <c:lblAlgn val="ctr"/>
        <c:lblOffset val="100"/>
        <c:noMultiLvlLbl val="0"/>
      </c:catAx>
      <c:valAx>
        <c:axId val="8016473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1632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5394-4F3A-B4D0-A560F8FF051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5394-4F3A-B4D0-A560F8FF0514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E$2</c:f>
                <c:numCache>
                  <c:formatCode>General</c:formatCode>
                  <c:ptCount val="1"/>
                  <c:pt idx="0">
                    <c:v>8.53278337340364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D$1</c:f>
              <c:strCache>
                <c:ptCount val="1"/>
                <c:pt idx="0">
                  <c:v>GPx</c:v>
                </c:pt>
              </c:strCache>
            </c:strRef>
          </c:cat>
          <c:val>
            <c:numRef>
              <c:f>'[data+figures.xlsx]REDOX'!$D$2</c:f>
              <c:numCache>
                <c:formatCode>General</c:formatCode>
                <c:ptCount val="1"/>
                <c:pt idx="0">
                  <c:v>276.543783404800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394-4F3A-B4D0-A560F8FF0514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5394-4F3A-B4D0-A560F8FF0514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5394-4F3A-B4D0-A560F8FF0514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E$3</c:f>
                <c:numCache>
                  <c:formatCode>General</c:formatCode>
                  <c:ptCount val="1"/>
                  <c:pt idx="0">
                    <c:v>15.7096565704320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D$1</c:f>
              <c:strCache>
                <c:ptCount val="1"/>
                <c:pt idx="0">
                  <c:v>GPx</c:v>
                </c:pt>
              </c:strCache>
            </c:strRef>
          </c:cat>
          <c:val>
            <c:numRef>
              <c:f>'[data+figures.xlsx]REDOX'!$D$3</c:f>
              <c:numCache>
                <c:formatCode>General</c:formatCode>
                <c:ptCount val="1"/>
                <c:pt idx="0">
                  <c:v>287.490137930760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394-4F3A-B4D0-A560F8FF0514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E$4</c:f>
                <c:numCache>
                  <c:formatCode>General</c:formatCode>
                  <c:ptCount val="1"/>
                  <c:pt idx="0">
                    <c:v>8.68801731261171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D$1</c:f>
              <c:strCache>
                <c:ptCount val="1"/>
                <c:pt idx="0">
                  <c:v>GPx</c:v>
                </c:pt>
              </c:strCache>
            </c:strRef>
          </c:cat>
          <c:val>
            <c:numRef>
              <c:f>'[data+figures.xlsx]REDOX'!$D$4</c:f>
              <c:numCache>
                <c:formatCode>General</c:formatCode>
                <c:ptCount val="1"/>
                <c:pt idx="0">
                  <c:v>274.649242028398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394-4F3A-B4D0-A560F8FF0514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E$5</c:f>
                <c:numCache>
                  <c:formatCode>General</c:formatCode>
                  <c:ptCount val="1"/>
                  <c:pt idx="0">
                    <c:v>20.1868937382997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D$1</c:f>
              <c:strCache>
                <c:ptCount val="1"/>
                <c:pt idx="0">
                  <c:v>GPx</c:v>
                </c:pt>
              </c:strCache>
            </c:strRef>
          </c:cat>
          <c:val>
            <c:numRef>
              <c:f>'[data+figures.xlsx]REDOX'!$D$5</c:f>
              <c:numCache>
                <c:formatCode>General</c:formatCode>
                <c:ptCount val="1"/>
                <c:pt idx="0">
                  <c:v>301.229171710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394-4F3A-B4D0-A560F8FF05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209792"/>
        <c:axId val="80211328"/>
      </c:barChart>
      <c:catAx>
        <c:axId val="80209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211328"/>
        <c:crosses val="autoZero"/>
        <c:auto val="1"/>
        <c:lblAlgn val="ctr"/>
        <c:lblOffset val="100"/>
        <c:noMultiLvlLbl val="0"/>
      </c:catAx>
      <c:valAx>
        <c:axId val="80211328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2097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A45-4B5F-A700-D97B5650528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2A45-4B5F-A700-D97B56505289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G$2</c:f>
                <c:numCache>
                  <c:formatCode>General</c:formatCode>
                  <c:ptCount val="1"/>
                  <c:pt idx="0">
                    <c:v>0.138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F$1</c:f>
              <c:strCache>
                <c:ptCount val="1"/>
                <c:pt idx="0">
                  <c:v>SOD</c:v>
                </c:pt>
              </c:strCache>
            </c:strRef>
          </c:cat>
          <c:val>
            <c:numRef>
              <c:f>'[data+figures.xlsx]REDOX'!$F$2</c:f>
              <c:numCache>
                <c:formatCode>General</c:formatCode>
                <c:ptCount val="1"/>
                <c:pt idx="0">
                  <c:v>7.14684411212538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A45-4B5F-A700-D97B56505289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2A45-4B5F-A700-D97B5650528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2A45-4B5F-A700-D97B56505289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G$3</c:f>
                <c:numCache>
                  <c:formatCode>General</c:formatCode>
                  <c:ptCount val="1"/>
                  <c:pt idx="0">
                    <c:v>0.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F$1</c:f>
              <c:strCache>
                <c:ptCount val="1"/>
                <c:pt idx="0">
                  <c:v>SOD</c:v>
                </c:pt>
              </c:strCache>
            </c:strRef>
          </c:cat>
          <c:val>
            <c:numRef>
              <c:f>'[data+figures.xlsx]REDOX'!$F$3</c:f>
              <c:numCache>
                <c:formatCode>General</c:formatCode>
                <c:ptCount val="1"/>
                <c:pt idx="0">
                  <c:v>5.8617309829364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A45-4B5F-A700-D97B56505289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G$4</c:f>
                <c:numCache>
                  <c:formatCode>General</c:formatCode>
                  <c:ptCount val="1"/>
                  <c:pt idx="0">
                    <c:v>0.377797393453641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F$1</c:f>
              <c:strCache>
                <c:ptCount val="1"/>
                <c:pt idx="0">
                  <c:v>SOD</c:v>
                </c:pt>
              </c:strCache>
            </c:strRef>
          </c:cat>
          <c:val>
            <c:numRef>
              <c:f>'[data+figures.xlsx]REDOX'!$F$4</c:f>
              <c:numCache>
                <c:formatCode>General</c:formatCode>
                <c:ptCount val="1"/>
                <c:pt idx="0">
                  <c:v>6.7298114276543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A45-4B5F-A700-D97B56505289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G$5</c:f>
                <c:numCache>
                  <c:formatCode>General</c:formatCode>
                  <c:ptCount val="1"/>
                  <c:pt idx="0">
                    <c:v>0.43495063287422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F$1</c:f>
              <c:strCache>
                <c:ptCount val="1"/>
                <c:pt idx="0">
                  <c:v>SOD</c:v>
                </c:pt>
              </c:strCache>
            </c:strRef>
          </c:cat>
          <c:val>
            <c:numRef>
              <c:f>'[data+figures.xlsx]REDOX'!$F$5</c:f>
              <c:numCache>
                <c:formatCode>General</c:formatCode>
                <c:ptCount val="1"/>
                <c:pt idx="0">
                  <c:v>6.89135335806402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A45-4B5F-A700-D97B565052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235520"/>
        <c:axId val="80253696"/>
      </c:barChart>
      <c:catAx>
        <c:axId val="80235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253696"/>
        <c:crosses val="autoZero"/>
        <c:auto val="1"/>
        <c:lblAlgn val="ctr"/>
        <c:lblOffset val="100"/>
        <c:noMultiLvlLbl val="0"/>
      </c:catAx>
      <c:valAx>
        <c:axId val="80253696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23552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8C5-4BE0-BA8E-E615C3AF918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28C5-4BE0-BA8E-E615C3AF918C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Q$2</c:f>
                <c:numCache>
                  <c:formatCode>General</c:formatCode>
                  <c:ptCount val="1"/>
                  <c:pt idx="0">
                    <c:v>2.865967282166916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P$1</c:f>
              <c:strCache>
                <c:ptCount val="1"/>
                <c:pt idx="0">
                  <c:v>carbonyls</c:v>
                </c:pt>
              </c:strCache>
            </c:strRef>
          </c:cat>
          <c:val>
            <c:numRef>
              <c:f>'[data+figures.xlsx]REDOX'!$P$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8C5-4BE0-BA8E-E615C3AF918C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28C5-4BE0-BA8E-E615C3AF918C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28C5-4BE0-BA8E-E615C3AF918C}"/>
              </c:ext>
            </c:extLst>
          </c:dPt>
          <c:errBars>
            <c:errBarType val="plus"/>
            <c:errValType val="cust"/>
            <c:noEndCap val="0"/>
            <c:plus>
              <c:numRef>
                <c:f>'[data+figures.xlsx]REDOX'!$Q$3</c:f>
                <c:numCache>
                  <c:formatCode>General</c:formatCode>
                  <c:ptCount val="1"/>
                  <c:pt idx="0">
                    <c:v>7.973873196022297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P$1</c:f>
              <c:strCache>
                <c:ptCount val="1"/>
                <c:pt idx="0">
                  <c:v>carbonyls</c:v>
                </c:pt>
              </c:strCache>
            </c:strRef>
          </c:cat>
          <c:val>
            <c:numRef>
              <c:f>'[data+figures.xlsx]REDOX'!$P$3</c:f>
              <c:numCache>
                <c:formatCode>General</c:formatCode>
                <c:ptCount val="1"/>
                <c:pt idx="0">
                  <c:v>0.96124838921376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8C5-4BE0-BA8E-E615C3AF918C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Q$4</c:f>
                <c:numCache>
                  <c:formatCode>General</c:formatCode>
                  <c:ptCount val="1"/>
                  <c:pt idx="0">
                    <c:v>0.105270693886575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P$1</c:f>
              <c:strCache>
                <c:ptCount val="1"/>
                <c:pt idx="0">
                  <c:v>carbonyls</c:v>
                </c:pt>
              </c:strCache>
            </c:strRef>
          </c:cat>
          <c:val>
            <c:numRef>
              <c:f>'[data+figures.xlsx]REDOX'!$P$4</c:f>
              <c:numCache>
                <c:formatCode>General</c:formatCode>
                <c:ptCount val="1"/>
                <c:pt idx="0">
                  <c:v>1.01950898704134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8C5-4BE0-BA8E-E615C3AF918C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data+figures.xlsx]REDOX'!$Q$5</c:f>
                <c:numCache>
                  <c:formatCode>General</c:formatCode>
                  <c:ptCount val="1"/>
                  <c:pt idx="0">
                    <c:v>0.155017411936270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data+figures.xlsx]REDOX'!$P$1</c:f>
              <c:strCache>
                <c:ptCount val="1"/>
                <c:pt idx="0">
                  <c:v>carbonyls</c:v>
                </c:pt>
              </c:strCache>
            </c:strRef>
          </c:cat>
          <c:val>
            <c:numRef>
              <c:f>'[data+figures.xlsx]REDOX'!$P$5</c:f>
              <c:numCache>
                <c:formatCode>General</c:formatCode>
                <c:ptCount val="1"/>
                <c:pt idx="0">
                  <c:v>1.05441783344126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8C5-4BE0-BA8E-E615C3AF91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626816"/>
        <c:axId val="80628352"/>
      </c:barChart>
      <c:catAx>
        <c:axId val="80626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0628352"/>
        <c:crosses val="autoZero"/>
        <c:auto val="1"/>
        <c:lblAlgn val="ctr"/>
        <c:lblOffset val="100"/>
        <c:noMultiLvlLbl val="0"/>
      </c:catAx>
      <c:valAx>
        <c:axId val="80628352"/>
        <c:scaling>
          <c:orientation val="minMax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crossAx val="80626816"/>
        <c:crosses val="autoZero"/>
        <c:crossBetween val="between"/>
        <c:majorUnit val="0.30000000000000004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WB jeune'!$A$4,'WB jeune'!$A$9,'WB jeune'!$A$14,'WB jeune'!$A$20)</c:f>
                <c:numCache>
                  <c:formatCode>General</c:formatCode>
                  <c:ptCount val="4"/>
                  <c:pt idx="0">
                    <c:v>0.15833234493897363</c:v>
                  </c:pt>
                  <c:pt idx="1">
                    <c:v>3.5316291847352174E-2</c:v>
                  </c:pt>
                  <c:pt idx="2">
                    <c:v>0.155832012597442</c:v>
                  </c:pt>
                  <c:pt idx="3">
                    <c:v>0.2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WB jeune'!$A$3,'WB jeune'!$A$8,'WB jeune'!$A$13,'WB jeune'!$A$19)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5="http://schemas.microsoft.com/office/drawing/2012/chart" uri="{02D57815-91ED-43cb-92C2-25804820EDAC}">
              <c15:filteredCategoryTitle>
                <c15:cat>
                  <c:multiLvlStrRef>
                    <c:extLst>
                      <c:ext uri="{02D57815-91ED-43cb-92C2-25804820EDAC}">
                        <c15:formulaRef>
                          <c15:sqref>('WB jeune'!#REF!,'WB jeune'!#REF!)</c15:sqref>
                        </c15:formulaRef>
                      </c:ext>
                    </c:extLst>
                  </c:multiLvlStrRef>
                </c15:cat>
              </c15:filteredCategoryTitle>
            </c:ext>
            <c:ext xmlns:c16="http://schemas.microsoft.com/office/drawing/2014/chart" uri="{C3380CC4-5D6E-409C-BE32-E72D297353CC}">
              <c16:uniqueId val="{00000000-B5C1-4FF3-B194-4167E55FB0BC}"/>
            </c:ext>
          </c:extLst>
        </c:ser>
        <c:ser>
          <c:idx val="1"/>
          <c:order val="1"/>
          <c:tx>
            <c:v>KO</c:v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WB jeune'!$B$4,'WB jeune'!$B$9,'WB jeune'!$B$14,'WB jeune'!$B$20)</c:f>
                <c:numCache>
                  <c:formatCode>General</c:formatCode>
                  <c:ptCount val="4"/>
                  <c:pt idx="0">
                    <c:v>0.34240177393617266</c:v>
                  </c:pt>
                  <c:pt idx="1">
                    <c:v>4.1804294470462737E-2</c:v>
                  </c:pt>
                  <c:pt idx="2">
                    <c:v>0.38150000000000001</c:v>
                  </c:pt>
                  <c:pt idx="3">
                    <c:v>0.4179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WB jeune'!$B$3,'WB jeune'!$B$8,'WB jeune'!$B$13,'WB jeune'!$B$19)</c:f>
              <c:numCache>
                <c:formatCode>General</c:formatCode>
                <c:ptCount val="4"/>
                <c:pt idx="0">
                  <c:v>1.3776041525989595</c:v>
                </c:pt>
                <c:pt idx="1">
                  <c:v>1.1838111881145852</c:v>
                </c:pt>
                <c:pt idx="2">
                  <c:v>2.0249999999999999</c:v>
                </c:pt>
                <c:pt idx="3">
                  <c:v>2.02</c:v>
                </c:pt>
              </c:numCache>
            </c:numRef>
          </c:val>
          <c:extLst>
            <c:ext xmlns:c15="http://schemas.microsoft.com/office/drawing/2012/chart" uri="{02D57815-91ED-43cb-92C2-25804820EDAC}">
              <c15:filteredCategoryTitle>
                <c15:cat>
                  <c:multiLvlStrRef>
                    <c:extLst>
                      <c:ext uri="{02D57815-91ED-43cb-92C2-25804820EDAC}">
                        <c15:formulaRef>
                          <c15:sqref>('WB jeune'!#REF!,'WB jeune'!#REF!)</c15:sqref>
                        </c15:formulaRef>
                      </c:ext>
                    </c:extLst>
                  </c:multiLvlStrRef>
                </c15:cat>
              </c15:filteredCategoryTitle>
            </c:ext>
            <c:ext xmlns:c16="http://schemas.microsoft.com/office/drawing/2014/chart" uri="{C3380CC4-5D6E-409C-BE32-E72D297353CC}">
              <c16:uniqueId val="{00000001-B5C1-4FF3-B194-4167E55FB0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3029888"/>
        <c:axId val="133031424"/>
      </c:barChart>
      <c:catAx>
        <c:axId val="1330298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 b="1"/>
            </a:pPr>
            <a:endParaRPr lang="fr-FR"/>
          </a:p>
        </c:txPr>
        <c:crossAx val="133031424"/>
        <c:crosses val="autoZero"/>
        <c:auto val="1"/>
        <c:lblAlgn val="ctr"/>
        <c:lblOffset val="100"/>
        <c:noMultiLvlLbl val="0"/>
      </c:catAx>
      <c:valAx>
        <c:axId val="133031424"/>
        <c:scaling>
          <c:orientation val="minMax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1100" b="1"/>
            </a:pPr>
            <a:endParaRPr lang="fr-FR"/>
          </a:p>
        </c:txPr>
        <c:crossAx val="1330298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4033701352860517E-2"/>
          <c:y val="5.0925925925925923E-2"/>
          <c:w val="0.92393295541827469"/>
          <c:h val="0.79805592009332171"/>
        </c:manualLayout>
      </c:layout>
      <c:barChart>
        <c:barDir val="col"/>
        <c:grouping val="clustered"/>
        <c:varyColors val="0"/>
        <c:ser>
          <c:idx val="0"/>
          <c:order val="0"/>
          <c:tx>
            <c:v>WT SED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Feuil1!$C$5,Feuil1!$F$5,Feuil1!$I$5,Feuil1!$L$5,Feuil1!$R$5,Feuil1!$U$5)</c:f>
                <c:numCache>
                  <c:formatCode>General</c:formatCode>
                  <c:ptCount val="6"/>
                  <c:pt idx="0">
                    <c:v>0.19190576262999318</c:v>
                  </c:pt>
                  <c:pt idx="1">
                    <c:v>8.4575629836566621E-2</c:v>
                  </c:pt>
                  <c:pt idx="2">
                    <c:v>0.1377467732136001</c:v>
                  </c:pt>
                  <c:pt idx="3">
                    <c:v>0.15248240018004292</c:v>
                  </c:pt>
                  <c:pt idx="4">
                    <c:v>0.11888697758198731</c:v>
                  </c:pt>
                  <c:pt idx="5">
                    <c:v>0.201458946161965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B$1</c:f>
              <c:strCache>
                <c:ptCount val="1"/>
                <c:pt idx="0">
                  <c:v>Akt T308</c:v>
                </c:pt>
              </c:strCache>
            </c:strRef>
          </c:cat>
          <c:val>
            <c:numRef>
              <c:f>Feuil1!$B$5</c:f>
              <c:numCache>
                <c:formatCode>General</c:formatCode>
                <c:ptCount val="1"/>
                <c:pt idx="0">
                  <c:v>0.99999999999999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81-4064-A0E8-BE1A939539E2}"/>
            </c:ext>
          </c:extLst>
        </c:ser>
        <c:ser>
          <c:idx val="1"/>
          <c:order val="1"/>
          <c:tx>
            <c:v>WT EX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wdDnDiag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9A81-4064-A0E8-BE1A939539E2}"/>
              </c:ext>
            </c:extLst>
          </c:dPt>
          <c:errBars>
            <c:errBarType val="plus"/>
            <c:errValType val="cust"/>
            <c:noEndCap val="0"/>
            <c:plus>
              <c:numRef>
                <c:f>(Feuil1!$C$6,Feuil1!$F$6,Feuil1!$I$6,Feuil1!$L$6,Feuil1!$R$6,Feuil1!$U$6)</c:f>
                <c:numCache>
                  <c:formatCode>General</c:formatCode>
                  <c:ptCount val="6"/>
                  <c:pt idx="0">
                    <c:v>7.490639146683932E-2</c:v>
                  </c:pt>
                  <c:pt idx="1">
                    <c:v>4.5646042444282997E-2</c:v>
                  </c:pt>
                  <c:pt idx="2">
                    <c:v>1.7899999999999999E-2</c:v>
                  </c:pt>
                  <c:pt idx="3">
                    <c:v>4.5235576239141241E-2</c:v>
                  </c:pt>
                  <c:pt idx="4">
                    <c:v>8.3902209942079406E-2</c:v>
                  </c:pt>
                  <c:pt idx="5">
                    <c:v>8.879300308582474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B$1</c:f>
              <c:strCache>
                <c:ptCount val="1"/>
                <c:pt idx="0">
                  <c:v>Akt T308</c:v>
                </c:pt>
              </c:strCache>
            </c:strRef>
          </c:cat>
          <c:val>
            <c:numRef>
              <c:f>Feuil1!$B$6</c:f>
              <c:numCache>
                <c:formatCode>0.000</c:formatCode>
                <c:ptCount val="1"/>
                <c:pt idx="0">
                  <c:v>0.34689549727705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81-4064-A0E8-BE1A939539E2}"/>
            </c:ext>
          </c:extLst>
        </c:ser>
        <c:ser>
          <c:idx val="2"/>
          <c:order val="2"/>
          <c:tx>
            <c:v>KO SED</c:v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Feuil1!$C$7,Feuil1!$F$7,Feuil1!$I$7,Feuil1!$L$7,Feuil1!$R$7,Feuil1!$U$7)</c:f>
                <c:numCache>
                  <c:formatCode>General</c:formatCode>
                  <c:ptCount val="6"/>
                  <c:pt idx="0">
                    <c:v>0.1997127331487191</c:v>
                  </c:pt>
                  <c:pt idx="1">
                    <c:v>0.12291842613091904</c:v>
                  </c:pt>
                  <c:pt idx="2">
                    <c:v>0.25220633548842686</c:v>
                  </c:pt>
                  <c:pt idx="3">
                    <c:v>7.5476625397793692E-2</c:v>
                  </c:pt>
                  <c:pt idx="4">
                    <c:v>0.26703750976062213</c:v>
                  </c:pt>
                  <c:pt idx="5">
                    <c:v>0.299089183410025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B$1</c:f>
              <c:strCache>
                <c:ptCount val="1"/>
                <c:pt idx="0">
                  <c:v>Akt T308</c:v>
                </c:pt>
              </c:strCache>
            </c:strRef>
          </c:cat>
          <c:val>
            <c:numRef>
              <c:f>Feuil1!$B$7</c:f>
              <c:numCache>
                <c:formatCode>0.000</c:formatCode>
                <c:ptCount val="1"/>
                <c:pt idx="0">
                  <c:v>0.71923982506686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A81-4064-A0E8-BE1A939539E2}"/>
            </c:ext>
          </c:extLst>
        </c:ser>
        <c:ser>
          <c:idx val="3"/>
          <c:order val="3"/>
          <c:tx>
            <c:v>KO EX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Feuil1!$C$8,Feuil1!$F$8,Feuil1!$I$8,Feuil1!$L$8,Feuil1!$R$8,Feuil1!$U$8)</c:f>
                <c:numCache>
                  <c:formatCode>General</c:formatCode>
                  <c:ptCount val="6"/>
                  <c:pt idx="0">
                    <c:v>0.12696809510835458</c:v>
                  </c:pt>
                  <c:pt idx="1">
                    <c:v>0.17683920067697662</c:v>
                  </c:pt>
                  <c:pt idx="2">
                    <c:v>5.3999999999999999E-2</c:v>
                  </c:pt>
                  <c:pt idx="3">
                    <c:v>3.5813046714036338E-2</c:v>
                  </c:pt>
                  <c:pt idx="4">
                    <c:v>0.10927407872279188</c:v>
                  </c:pt>
                  <c:pt idx="5">
                    <c:v>0.1307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B$1</c:f>
              <c:strCache>
                <c:ptCount val="1"/>
                <c:pt idx="0">
                  <c:v>Akt T308</c:v>
                </c:pt>
              </c:strCache>
            </c:strRef>
          </c:cat>
          <c:val>
            <c:numRef>
              <c:f>Feuil1!$B$8</c:f>
              <c:numCache>
                <c:formatCode>0.000</c:formatCode>
                <c:ptCount val="1"/>
                <c:pt idx="0">
                  <c:v>0.578569130265483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A81-4064-A0E8-BE1A939539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125888"/>
        <c:axId val="95127424"/>
      </c:barChart>
      <c:catAx>
        <c:axId val="951258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5127424"/>
        <c:crosses val="autoZero"/>
        <c:auto val="1"/>
        <c:lblAlgn val="ctr"/>
        <c:lblOffset val="100"/>
        <c:noMultiLvlLbl val="0"/>
      </c:catAx>
      <c:valAx>
        <c:axId val="95127424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5125888"/>
        <c:crosses val="autoZero"/>
        <c:crossBetween val="between"/>
        <c:majorUnit val="0.5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C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D$4:$E$4</c:f>
                <c:numCache>
                  <c:formatCode>General</c:formatCode>
                  <c:ptCount val="2"/>
                  <c:pt idx="0">
                    <c:v>1027</c:v>
                  </c:pt>
                  <c:pt idx="1">
                    <c:v>44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2:$E$2</c:f>
              <c:numCache>
                <c:formatCode>General</c:formatCode>
                <c:ptCount val="2"/>
                <c:pt idx="0">
                  <c:v>3216</c:v>
                </c:pt>
                <c:pt idx="1">
                  <c:v>112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8C-4D10-9093-8339B7A53F6F}"/>
            </c:ext>
          </c:extLst>
        </c:ser>
        <c:ser>
          <c:idx val="1"/>
          <c:order val="1"/>
          <c:tx>
            <c:strRef>
              <c:f>Feuil1!$C$3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5:$E$5</c:f>
                <c:numCache>
                  <c:formatCode>General</c:formatCode>
                  <c:ptCount val="2"/>
                  <c:pt idx="0">
                    <c:v>395</c:v>
                  </c:pt>
                  <c:pt idx="1">
                    <c:v>41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3:$E$3</c:f>
              <c:numCache>
                <c:formatCode>General</c:formatCode>
                <c:ptCount val="2"/>
                <c:pt idx="0">
                  <c:v>3432</c:v>
                </c:pt>
                <c:pt idx="1">
                  <c:v>131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8C-4D10-9093-8339B7A53F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7268096"/>
        <c:axId val="97269632"/>
      </c:barChart>
      <c:catAx>
        <c:axId val="97268096"/>
        <c:scaling>
          <c:orientation val="minMax"/>
        </c:scaling>
        <c:delete val="0"/>
        <c:axPos val="b"/>
        <c:majorTickMark val="out"/>
        <c:minorTickMark val="none"/>
        <c:tickLblPos val="nextTo"/>
        <c:crossAx val="97269632"/>
        <c:crosses val="autoZero"/>
        <c:auto val="1"/>
        <c:lblAlgn val="ctr"/>
        <c:lblOffset val="100"/>
        <c:noMultiLvlLbl val="0"/>
      </c:catAx>
      <c:valAx>
        <c:axId val="9726963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72680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8144026441139303"/>
          <c:y val="0.32231862526618132"/>
          <c:w val="0.60991776027996503"/>
          <c:h val="0.519603327885901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M$4</c:f>
                <c:numCache>
                  <c:formatCode>General</c:formatCode>
                  <c:ptCount val="1"/>
                  <c:pt idx="0">
                    <c:v>9.700000000000000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B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M$3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99-4708-A9AB-A8FC74881817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M$6</c:f>
                <c:numCache>
                  <c:formatCode>General</c:formatCode>
                  <c:ptCount val="1"/>
                  <c:pt idx="0">
                    <c:v>0.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B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M$5</c:f>
              <c:numCache>
                <c:formatCode>General</c:formatCode>
                <c:ptCount val="1"/>
                <c:pt idx="0">
                  <c:v>0.763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C99-4708-A9AB-A8FC74881817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M$8</c:f>
                <c:numCache>
                  <c:formatCode>General</c:formatCode>
                  <c:ptCount val="1"/>
                  <c:pt idx="0">
                    <c:v>0.1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B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M$7</c:f>
              <c:numCache>
                <c:formatCode>General</c:formatCode>
                <c:ptCount val="1"/>
                <c:pt idx="0">
                  <c:v>0.831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C99-4708-A9AB-A8FC74881817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M$10</c:f>
                <c:numCache>
                  <c:formatCode>General</c:formatCode>
                  <c:ptCount val="1"/>
                  <c:pt idx="0">
                    <c:v>0.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B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M$9</c:f>
              <c:numCache>
                <c:formatCode>General</c:formatCode>
                <c:ptCount val="1"/>
                <c:pt idx="0">
                  <c:v>1.782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C99-4708-A9AB-A8FC748818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094144"/>
        <c:axId val="79095680"/>
      </c:barChart>
      <c:catAx>
        <c:axId val="79094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79095680"/>
        <c:crosses val="autoZero"/>
        <c:auto val="1"/>
        <c:lblAlgn val="ctr"/>
        <c:lblOffset val="100"/>
        <c:noMultiLvlLbl val="0"/>
      </c:catAx>
      <c:valAx>
        <c:axId val="79095680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79094144"/>
        <c:crosses val="autoZero"/>
        <c:crossBetween val="between"/>
        <c:majorUnit val="1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G$4</c:f>
                <c:numCache>
                  <c:formatCode>General</c:formatCode>
                  <c:ptCount val="1"/>
                  <c:pt idx="0">
                    <c:v>0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G$2</c:f>
              <c:numCache>
                <c:formatCode>General</c:formatCode>
                <c:ptCount val="1"/>
                <c:pt idx="0">
                  <c:v>3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DB-4323-BE8B-ADDDBDA91917}"/>
            </c:ext>
          </c:extLst>
        </c:ser>
        <c:ser>
          <c:idx val="1"/>
          <c:order val="1"/>
          <c:tx>
            <c:v>ko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G$5</c:f>
                <c:numCache>
                  <c:formatCode>General</c:formatCode>
                  <c:ptCount val="1"/>
                  <c:pt idx="0">
                    <c:v>0.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G$3</c:f>
              <c:numCache>
                <c:formatCode>General</c:formatCode>
                <c:ptCount val="1"/>
                <c:pt idx="0">
                  <c:v>3.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6DB-4323-BE8B-ADDDBDA919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7290880"/>
        <c:axId val="97309056"/>
      </c:barChart>
      <c:catAx>
        <c:axId val="97290880"/>
        <c:scaling>
          <c:orientation val="minMax"/>
        </c:scaling>
        <c:delete val="0"/>
        <c:axPos val="b"/>
        <c:majorTickMark val="out"/>
        <c:minorTickMark val="none"/>
        <c:tickLblPos val="nextTo"/>
        <c:crossAx val="97309056"/>
        <c:crosses val="autoZero"/>
        <c:auto val="1"/>
        <c:lblAlgn val="ctr"/>
        <c:lblOffset val="100"/>
        <c:tickLblSkip val="1"/>
        <c:noMultiLvlLbl val="0"/>
      </c:catAx>
      <c:valAx>
        <c:axId val="97309056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7290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C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D$4:$E$4</c:f>
                <c:numCache>
                  <c:formatCode>General</c:formatCode>
                  <c:ptCount val="2"/>
                  <c:pt idx="0">
                    <c:v>181</c:v>
                  </c:pt>
                  <c:pt idx="1">
                    <c:v>11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2:$E$2</c:f>
              <c:numCache>
                <c:formatCode>General</c:formatCode>
                <c:ptCount val="2"/>
                <c:pt idx="0">
                  <c:v>2483</c:v>
                </c:pt>
                <c:pt idx="1">
                  <c:v>5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9B-4238-B22B-78438487143D}"/>
            </c:ext>
          </c:extLst>
        </c:ser>
        <c:ser>
          <c:idx val="1"/>
          <c:order val="1"/>
          <c:tx>
            <c:strRef>
              <c:f>Feuil1!$C$3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5:$E$5</c:f>
                <c:numCache>
                  <c:formatCode>General</c:formatCode>
                  <c:ptCount val="2"/>
                  <c:pt idx="0">
                    <c:v>221</c:v>
                  </c:pt>
                  <c:pt idx="1">
                    <c:v>2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3:$E$3</c:f>
              <c:numCache>
                <c:formatCode>General</c:formatCode>
                <c:ptCount val="2"/>
                <c:pt idx="0">
                  <c:v>2291</c:v>
                </c:pt>
                <c:pt idx="1">
                  <c:v>53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9B-4238-B22B-7843848714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835136"/>
        <c:axId val="81836672"/>
      </c:barChart>
      <c:catAx>
        <c:axId val="81835136"/>
        <c:scaling>
          <c:orientation val="minMax"/>
        </c:scaling>
        <c:delete val="0"/>
        <c:axPos val="b"/>
        <c:majorTickMark val="out"/>
        <c:minorTickMark val="none"/>
        <c:tickLblPos val="nextTo"/>
        <c:crossAx val="81836672"/>
        <c:crosses val="autoZero"/>
        <c:auto val="1"/>
        <c:lblAlgn val="ctr"/>
        <c:lblOffset val="100"/>
        <c:noMultiLvlLbl val="0"/>
      </c:catAx>
      <c:valAx>
        <c:axId val="8183667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18351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G$4</c:f>
                <c:numCache>
                  <c:formatCode>General</c:formatCode>
                  <c:ptCount val="1"/>
                  <c:pt idx="0">
                    <c:v>0.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G$2</c:f>
              <c:numCache>
                <c:formatCode>General</c:formatCode>
                <c:ptCount val="1"/>
                <c:pt idx="0">
                  <c:v>2.2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7D-4CCE-8F9C-2D4257E97741}"/>
            </c:ext>
          </c:extLst>
        </c:ser>
        <c:ser>
          <c:idx val="1"/>
          <c:order val="1"/>
          <c:tx>
            <c:v>ko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G$5</c:f>
                <c:numCache>
                  <c:formatCode>General</c:formatCode>
                  <c:ptCount val="1"/>
                  <c:pt idx="0">
                    <c:v>0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G$3</c:f>
              <c:numCache>
                <c:formatCode>General</c:formatCode>
                <c:ptCount val="1"/>
                <c:pt idx="0">
                  <c:v>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7D-4CCE-8F9C-2D4257E977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870208"/>
        <c:axId val="81876096"/>
      </c:barChart>
      <c:catAx>
        <c:axId val="81870208"/>
        <c:scaling>
          <c:orientation val="minMax"/>
        </c:scaling>
        <c:delete val="0"/>
        <c:axPos val="b"/>
        <c:majorTickMark val="out"/>
        <c:minorTickMark val="none"/>
        <c:tickLblPos val="nextTo"/>
        <c:crossAx val="81876096"/>
        <c:crosses val="autoZero"/>
        <c:auto val="1"/>
        <c:lblAlgn val="ctr"/>
        <c:lblOffset val="100"/>
        <c:noMultiLvlLbl val="0"/>
      </c:catAx>
      <c:valAx>
        <c:axId val="81876096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1870208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C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4:$E$4</c:f>
                <c:numCache>
                  <c:formatCode>General</c:formatCode>
                  <c:ptCount val="2"/>
                  <c:pt idx="0">
                    <c:v>634</c:v>
                  </c:pt>
                  <c:pt idx="1">
                    <c:v>20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2:$E$2</c:f>
              <c:numCache>
                <c:formatCode>General</c:formatCode>
                <c:ptCount val="2"/>
                <c:pt idx="0">
                  <c:v>3207</c:v>
                </c:pt>
                <c:pt idx="1">
                  <c:v>14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A9-4E3A-A67F-372B174D7CAB}"/>
            </c:ext>
          </c:extLst>
        </c:ser>
        <c:ser>
          <c:idx val="1"/>
          <c:order val="1"/>
          <c:tx>
            <c:strRef>
              <c:f>Feuil1!$C$3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5:$E$5</c:f>
                <c:numCache>
                  <c:formatCode>General</c:formatCode>
                  <c:ptCount val="2"/>
                  <c:pt idx="0">
                    <c:v>388</c:v>
                  </c:pt>
                  <c:pt idx="1">
                    <c:v>5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D$3:$E$3</c:f>
              <c:numCache>
                <c:formatCode>General</c:formatCode>
                <c:ptCount val="2"/>
                <c:pt idx="0">
                  <c:v>2956</c:v>
                </c:pt>
                <c:pt idx="1">
                  <c:v>133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A9-4E3A-A67F-372B174D7C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954688"/>
        <c:axId val="81956224"/>
      </c:barChart>
      <c:catAx>
        <c:axId val="81954688"/>
        <c:scaling>
          <c:orientation val="minMax"/>
        </c:scaling>
        <c:delete val="0"/>
        <c:axPos val="b"/>
        <c:majorTickMark val="out"/>
        <c:minorTickMark val="none"/>
        <c:tickLblPos val="nextTo"/>
        <c:crossAx val="81956224"/>
        <c:crosses val="autoZero"/>
        <c:auto val="1"/>
        <c:lblAlgn val="ctr"/>
        <c:lblOffset val="100"/>
        <c:noMultiLvlLbl val="0"/>
      </c:catAx>
      <c:valAx>
        <c:axId val="8195622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819546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G$4</c:f>
                <c:numCache>
                  <c:formatCode>General</c:formatCode>
                  <c:ptCount val="1"/>
                  <c:pt idx="0">
                    <c:v>0.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G$2</c:f>
              <c:numCache>
                <c:formatCode>General</c:formatCode>
                <c:ptCount val="1"/>
                <c:pt idx="0">
                  <c:v>4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A1-436A-B68D-1DF3E5B3DE68}"/>
            </c:ext>
          </c:extLst>
        </c:ser>
        <c:ser>
          <c:idx val="1"/>
          <c:order val="1"/>
          <c:tx>
            <c:v>ko</c:v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1FA1-436A-B68D-1DF3E5B3DE68}"/>
              </c:ext>
            </c:extLst>
          </c:dPt>
          <c:errBars>
            <c:errBarType val="plus"/>
            <c:errValType val="cust"/>
            <c:noEndCap val="0"/>
            <c:plus>
              <c:numRef>
                <c:f>Feuil1!$G$5</c:f>
                <c:numCache>
                  <c:formatCode>General</c:formatCode>
                  <c:ptCount val="1"/>
                  <c:pt idx="0">
                    <c:v>0.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G$3</c:f>
              <c:numCache>
                <c:formatCode>General</c:formatCode>
                <c:ptCount val="1"/>
                <c:pt idx="0">
                  <c:v>4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FA1-436A-B68D-1DF3E5B3DE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1365760"/>
        <c:axId val="91367296"/>
      </c:barChart>
      <c:catAx>
        <c:axId val="91365760"/>
        <c:scaling>
          <c:orientation val="minMax"/>
        </c:scaling>
        <c:delete val="0"/>
        <c:axPos val="b"/>
        <c:majorTickMark val="out"/>
        <c:minorTickMark val="none"/>
        <c:tickLblPos val="nextTo"/>
        <c:crossAx val="91367296"/>
        <c:crosses val="autoZero"/>
        <c:auto val="1"/>
        <c:lblAlgn val="ctr"/>
        <c:lblOffset val="100"/>
        <c:tickLblSkip val="1"/>
        <c:noMultiLvlLbl val="0"/>
      </c:catAx>
      <c:valAx>
        <c:axId val="91367296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13657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E$8</c:f>
                <c:numCache>
                  <c:formatCode>General</c:formatCode>
                  <c:ptCount val="1"/>
                  <c:pt idx="0">
                    <c:v>0.100081083400014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G$1:$H$1</c:f>
              <c:strCache>
                <c:ptCount val="2"/>
                <c:pt idx="1">
                  <c:v>KO</c:v>
                </c:pt>
              </c:strCache>
            </c:strRef>
          </c:cat>
          <c:val>
            <c:numRef>
              <c:f>Feuil1!$E$4</c:f>
              <c:numCache>
                <c:formatCode>General</c:formatCode>
                <c:ptCount val="1"/>
                <c:pt idx="0">
                  <c:v>0.999999999999999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51-4F63-A07F-37DCA7A4FD46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I$8</c:f>
                <c:numCache>
                  <c:formatCode>General</c:formatCode>
                  <c:ptCount val="1"/>
                  <c:pt idx="0">
                    <c:v>8.142472167089766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euil1!$I$4</c:f>
              <c:numCache>
                <c:formatCode>0.000</c:formatCode>
                <c:ptCount val="1"/>
                <c:pt idx="0">
                  <c:v>1.0391902287003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951-4F63-A07F-37DCA7A4FD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631296"/>
        <c:axId val="78632832"/>
      </c:barChart>
      <c:catAx>
        <c:axId val="78631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8632832"/>
        <c:crosses val="autoZero"/>
        <c:auto val="1"/>
        <c:lblAlgn val="ctr"/>
        <c:lblOffset val="100"/>
        <c:noMultiLvlLbl val="0"/>
      </c:catAx>
      <c:valAx>
        <c:axId val="7863283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786312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13425925925926"/>
          <c:y val="8.1410256410256412E-2"/>
          <c:w val="0.63007253086419757"/>
          <c:h val="0.73721082621082623"/>
        </c:manualLayout>
      </c:layout>
      <c:barChart>
        <c:barDir val="col"/>
        <c:grouping val="clustered"/>
        <c:varyColors val="0"/>
        <c:ser>
          <c:idx val="0"/>
          <c:order val="0"/>
          <c:tx>
            <c:v>CTRL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ig BMC'!$Z$11,'fig BMC'!$Z$13)</c:f>
                <c:numCache>
                  <c:formatCode>General</c:formatCode>
                  <c:ptCount val="2"/>
                  <c:pt idx="0">
                    <c:v>4.1982838142729166</c:v>
                  </c:pt>
                  <c:pt idx="1">
                    <c:v>10.0803178477291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 BMC'!$AA$18:$AB$18</c:f>
              <c:numCache>
                <c:formatCode>General</c:formatCode>
                <c:ptCount val="2"/>
              </c:numCache>
            </c:numRef>
          </c:cat>
          <c:val>
            <c:numRef>
              <c:f>('fig BMC'!$Y$11,'fig BMC'!$Y$13)</c:f>
              <c:numCache>
                <c:formatCode>General</c:formatCode>
                <c:ptCount val="2"/>
                <c:pt idx="0">
                  <c:v>100</c:v>
                </c:pt>
                <c:pt idx="1">
                  <c:v>84.084356141629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54-4C3B-B690-775AEA8E0CA0}"/>
            </c:ext>
          </c:extLst>
        </c:ser>
        <c:ser>
          <c:idx val="1"/>
          <c:order val="1"/>
          <c:tx>
            <c:v>R1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fig BMC'!$Z$15,'fig BMC'!$Z$17)</c:f>
                <c:numCache>
                  <c:formatCode>General</c:formatCode>
                  <c:ptCount val="2"/>
                  <c:pt idx="0">
                    <c:v>10.250168800126723</c:v>
                  </c:pt>
                  <c:pt idx="1">
                    <c:v>13.3205316672455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 BMC'!$AA$18:$AB$18</c:f>
              <c:numCache>
                <c:formatCode>General</c:formatCode>
                <c:ptCount val="2"/>
              </c:numCache>
            </c:numRef>
          </c:cat>
          <c:val>
            <c:numRef>
              <c:f>('fig BMC'!$Y$15,'fig BMC'!$Y$17)</c:f>
              <c:numCache>
                <c:formatCode>General</c:formatCode>
                <c:ptCount val="2"/>
                <c:pt idx="0">
                  <c:v>94.378343004149755</c:v>
                </c:pt>
                <c:pt idx="1">
                  <c:v>106.78979029710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454-4C3B-B690-775AEA8E0C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33984"/>
        <c:axId val="36324480"/>
      </c:barChart>
      <c:catAx>
        <c:axId val="3663398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36324480"/>
        <c:crosses val="autoZero"/>
        <c:auto val="1"/>
        <c:lblAlgn val="ctr"/>
        <c:lblOffset val="100"/>
        <c:noMultiLvlLbl val="0"/>
      </c:catAx>
      <c:valAx>
        <c:axId val="36324480"/>
        <c:scaling>
          <c:orientation val="minMax"/>
          <c:max val="125"/>
        </c:scaling>
        <c:delete val="0"/>
        <c:axPos val="l"/>
        <c:majorGridlines>
          <c:spPr>
            <a:ln>
              <a:noFill/>
            </a:ln>
          </c:spPr>
        </c:majorGridlines>
        <c:numFmt formatCode="#,##0" sourceLinked="0"/>
        <c:majorTickMark val="none"/>
        <c:minorTickMark val="none"/>
        <c:tickLblPos val="nextTo"/>
        <c:txPr>
          <a:bodyPr/>
          <a:lstStyle/>
          <a:p>
            <a:pPr>
              <a:defRPr sz="900"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36633984"/>
        <c:crosses val="autoZero"/>
        <c:crossBetween val="between"/>
        <c:majorUnit val="2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13603658933394072"/>
          <c:w val="0.68547331583552051"/>
          <c:h val="0.692604956398659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[1]Feuil3!$P$6:$Q$6</c:f>
                <c:numCache>
                  <c:formatCode>General</c:formatCode>
                  <c:ptCount val="2"/>
                  <c:pt idx="0">
                    <c:v>9.2415031935507527E-2</c:v>
                  </c:pt>
                  <c:pt idx="1">
                    <c:v>5.801868812797569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1]Feuil3!$Q$10:$R$10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[1]Feuil3!$P$4:$Q$4</c:f>
              <c:numCache>
                <c:formatCode>General</c:formatCode>
                <c:ptCount val="2"/>
                <c:pt idx="0">
                  <c:v>1</c:v>
                </c:pt>
                <c:pt idx="1">
                  <c:v>1.002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8F-4854-831C-B383F5CBAF58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[1]Feuil3!$P$7:$Q$7</c:f>
                <c:numCache>
                  <c:formatCode>General</c:formatCode>
                  <c:ptCount val="2"/>
                  <c:pt idx="0">
                    <c:v>0.25336217483686052</c:v>
                  </c:pt>
                  <c:pt idx="1">
                    <c:v>0.432558562282032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1]Feuil3!$Q$10:$R$10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[1]Feuil3!$P$5:$Q$5</c:f>
              <c:numCache>
                <c:formatCode>General</c:formatCode>
                <c:ptCount val="2"/>
                <c:pt idx="0">
                  <c:v>1.222</c:v>
                </c:pt>
                <c:pt idx="1">
                  <c:v>1.887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A8F-4854-831C-B383F5CBAF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294208"/>
        <c:axId val="95295744"/>
      </c:barChart>
      <c:catAx>
        <c:axId val="95294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5295744"/>
        <c:crosses val="autoZero"/>
        <c:auto val="1"/>
        <c:lblAlgn val="ctr"/>
        <c:lblOffset val="100"/>
        <c:noMultiLvlLbl val="0"/>
      </c:catAx>
      <c:valAx>
        <c:axId val="9529574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5294208"/>
        <c:crosses val="autoZero"/>
        <c:crossBetween val="between"/>
        <c:majorUnit val="1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13603658933394072"/>
          <c:w val="0.68547331583552051"/>
          <c:h val="0.692604956398659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mitophagy!$C$2,mitophagy!$C$4)</c:f>
                <c:numCache>
                  <c:formatCode>General</c:formatCode>
                  <c:ptCount val="2"/>
                  <c:pt idx="0">
                    <c:v>0.159</c:v>
                  </c:pt>
                  <c:pt idx="1">
                    <c:v>0.3390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1]Feuil3!$Q$10:$R$10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(mitophagy!$B$2,mitophagy!$B$4)</c:f>
              <c:numCache>
                <c:formatCode>General</c:formatCode>
                <c:ptCount val="2"/>
                <c:pt idx="0">
                  <c:v>1</c:v>
                </c:pt>
                <c:pt idx="1">
                  <c:v>0.888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55-4B25-B66D-EA1DE037C101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mitophagy!$C$3,mitophagy!$C$5)</c:f>
                <c:numCache>
                  <c:formatCode>General</c:formatCode>
                  <c:ptCount val="2"/>
                  <c:pt idx="0">
                    <c:v>0.223</c:v>
                  </c:pt>
                  <c:pt idx="1">
                    <c:v>0.8539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1]Feuil3!$Q$10:$R$10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(mitophagy!$B$3,mitophagy!$B$5)</c:f>
              <c:numCache>
                <c:formatCode>General</c:formatCode>
                <c:ptCount val="2"/>
                <c:pt idx="0">
                  <c:v>0.95899999999999996</c:v>
                </c:pt>
                <c:pt idx="1">
                  <c:v>2.345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55-4B25-B66D-EA1DE037C1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6669056"/>
        <c:axId val="96679040"/>
      </c:barChart>
      <c:catAx>
        <c:axId val="966690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6679040"/>
        <c:crosses val="autoZero"/>
        <c:auto val="1"/>
        <c:lblAlgn val="ctr"/>
        <c:lblOffset val="100"/>
        <c:noMultiLvlLbl val="0"/>
      </c:catAx>
      <c:valAx>
        <c:axId val="9667904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6669056"/>
        <c:crosses val="autoZero"/>
        <c:crossBetween val="between"/>
        <c:majorUnit val="1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79628526415426"/>
          <c:y val="0.17061611374407584"/>
          <c:w val="0.78640900967240857"/>
          <c:h val="0.697376790010437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Q$4</c:f>
              <c:strCache>
                <c:ptCount val="1"/>
                <c:pt idx="0">
                  <c:v>SED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4A5A-4130-8309-117EC468842F}"/>
              </c:ext>
            </c:extLst>
          </c:dPt>
          <c:errBars>
            <c:errBarType val="plus"/>
            <c:errValType val="cust"/>
            <c:noEndCap val="0"/>
            <c:plus>
              <c:numRef>
                <c:f>Feuil1!$R$6:$S$6</c:f>
                <c:numCache>
                  <c:formatCode>General</c:formatCode>
                  <c:ptCount val="2"/>
                  <c:pt idx="0">
                    <c:v>0.1376</c:v>
                  </c:pt>
                  <c:pt idx="1">
                    <c:v>0.25390000000000001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Feuil1!$R$3:$S$3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Feuil1!$R$4:$S$4</c:f>
              <c:numCache>
                <c:formatCode>General</c:formatCode>
                <c:ptCount val="2"/>
                <c:pt idx="0">
                  <c:v>1</c:v>
                </c:pt>
                <c:pt idx="1">
                  <c:v>1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A5A-4130-8309-117EC468842F}"/>
            </c:ext>
          </c:extLst>
        </c:ser>
        <c:ser>
          <c:idx val="1"/>
          <c:order val="1"/>
          <c:tx>
            <c:strRef>
              <c:f>Feuil1!$Q$5</c:f>
              <c:strCache>
                <c:ptCount val="1"/>
                <c:pt idx="0">
                  <c:v>EX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4A5A-4130-8309-117EC468842F}"/>
              </c:ext>
            </c:extLst>
          </c:dPt>
          <c:errBars>
            <c:errBarType val="plus"/>
            <c:errValType val="cust"/>
            <c:noEndCap val="0"/>
            <c:plus>
              <c:numRef>
                <c:f>Feuil1!$R$7:$S$7</c:f>
                <c:numCache>
                  <c:formatCode>General</c:formatCode>
                  <c:ptCount val="2"/>
                  <c:pt idx="0">
                    <c:v>9.9400000000000002E-2</c:v>
                  </c:pt>
                  <c:pt idx="1">
                    <c:v>7.8E-2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Feuil1!$R$3:$S$3</c:f>
              <c:strCache>
                <c:ptCount val="2"/>
                <c:pt idx="0">
                  <c:v>WT</c:v>
                </c:pt>
                <c:pt idx="1">
                  <c:v>KO</c:v>
                </c:pt>
              </c:strCache>
            </c:strRef>
          </c:cat>
          <c:val>
            <c:numRef>
              <c:f>Feuil1!$R$5:$S$5</c:f>
              <c:numCache>
                <c:formatCode>General</c:formatCode>
                <c:ptCount val="2"/>
                <c:pt idx="0">
                  <c:v>0.94</c:v>
                </c:pt>
                <c:pt idx="1">
                  <c:v>0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A5A-4130-8309-117EC46884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301824"/>
        <c:axId val="120307712"/>
      </c:barChart>
      <c:catAx>
        <c:axId val="120301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12030771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20307712"/>
        <c:scaling>
          <c:orientation val="minMax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+mn-lt"/>
                <a:ea typeface="Arial"/>
                <a:cs typeface="Arial"/>
              </a:defRPr>
            </a:pPr>
            <a:endParaRPr lang="fr-FR"/>
          </a:p>
        </c:txPr>
        <c:crossAx val="120301824"/>
        <c:crosses val="autoZero"/>
        <c:crossBetween val="between"/>
        <c:majorUnit val="1"/>
      </c:valAx>
      <c:spPr>
        <a:noFill/>
        <a:ln w="12700">
          <a:solidFill>
            <a:srgbClr val="FFFFFF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N$4</c:f>
                <c:numCache>
                  <c:formatCode>General</c:formatCode>
                  <c:ptCount val="1"/>
                  <c:pt idx="0">
                    <c:v>0.190935853581389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C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N$3</c:f>
              <c:numCache>
                <c:formatCode>General</c:formatCode>
                <c:ptCount val="1"/>
                <c:pt idx="0">
                  <c:v>1.7811220703885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71-41B5-8FDF-9B7C50C3263A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N$6</c:f>
                <c:numCache>
                  <c:formatCode>General</c:formatCode>
                  <c:ptCount val="1"/>
                  <c:pt idx="0">
                    <c:v>0.2889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C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N$5</c:f>
              <c:numCache>
                <c:formatCode>General</c:formatCode>
                <c:ptCount val="1"/>
                <c:pt idx="0">
                  <c:v>3.84305074549976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71-41B5-8FDF-9B7C50C3263A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N$8</c:f>
                <c:numCache>
                  <c:formatCode>General</c:formatCode>
                  <c:ptCount val="1"/>
                  <c:pt idx="0">
                    <c:v>0.34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C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N$7</c:f>
              <c:numCache>
                <c:formatCode>General</c:formatCode>
                <c:ptCount val="1"/>
                <c:pt idx="0">
                  <c:v>4.01870408434167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B71-41B5-8FDF-9B7C50C3263A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STAPS\Documents\projet REDD\article #2\[data+figures - Copie.xlsx]glycogen AMPK'!$N$10</c:f>
                <c:numCache>
                  <c:formatCode>General</c:formatCode>
                  <c:ptCount val="1"/>
                  <c:pt idx="0">
                    <c:v>0.81630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Fig. 2'!$C$1</c:f>
              <c:numCache>
                <c:formatCode>General</c:formatCode>
                <c:ptCount val="1"/>
              </c:numCache>
            </c:numRef>
          </c:cat>
          <c:val>
            <c:numRef>
              <c:f>'C:\Users\STAPS\Documents\projet REDD\article #2\[data+figures - Copie.xlsx]glycogen AMPK'!$N$9</c:f>
              <c:numCache>
                <c:formatCode>General</c:formatCode>
                <c:ptCount val="1"/>
                <c:pt idx="0">
                  <c:v>4.00629644892120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B71-41B5-8FDF-9B7C50C326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  <c:majorUnit val="2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B$4</c:f>
                <c:numCache>
                  <c:formatCode>General</c:formatCode>
                  <c:ptCount val="1"/>
                  <c:pt idx="0">
                    <c:v>2.103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B$3</c:f>
              <c:numCache>
                <c:formatCode>General</c:formatCode>
                <c:ptCount val="1"/>
                <c:pt idx="0">
                  <c:v>48.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BE-4871-9B38-3931DADB8747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C$4</c:f>
                <c:numCache>
                  <c:formatCode>General</c:formatCode>
                  <c:ptCount val="1"/>
                  <c:pt idx="0">
                    <c:v>1.8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C$3</c:f>
              <c:numCache>
                <c:formatCode>General</c:formatCode>
                <c:ptCount val="1"/>
                <c:pt idx="0">
                  <c:v>43.582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9BE-4871-9B38-3931DADB8747}"/>
            </c:ext>
          </c:extLst>
        </c:ser>
        <c:ser>
          <c:idx val="2"/>
          <c:order val="2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4</c:f>
                <c:numCache>
                  <c:formatCode>General</c:formatCode>
                  <c:ptCount val="1"/>
                  <c:pt idx="0">
                    <c:v>2.545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D$3</c:f>
              <c:numCache>
                <c:formatCode>General</c:formatCode>
                <c:ptCount val="1"/>
                <c:pt idx="0">
                  <c:v>48.758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9BE-4871-9B38-3931DADB8747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E$4</c:f>
                <c:numCache>
                  <c:formatCode>General</c:formatCode>
                  <c:ptCount val="1"/>
                  <c:pt idx="0">
                    <c:v>1.6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E$3</c:f>
              <c:numCache>
                <c:formatCode>General</c:formatCode>
                <c:ptCount val="1"/>
                <c:pt idx="0">
                  <c:v>40.764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9BE-4871-9B38-3931DADB87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B$6</c:f>
                <c:numCache>
                  <c:formatCode>General</c:formatCode>
                  <c:ptCount val="1"/>
                  <c:pt idx="0">
                    <c:v>7.581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B$5</c:f>
              <c:numCache>
                <c:formatCode>General</c:formatCode>
                <c:ptCount val="1"/>
                <c:pt idx="0">
                  <c:v>136.324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E5-4CB2-B4A7-7D32A9E34EA5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C$6</c:f>
                <c:numCache>
                  <c:formatCode>General</c:formatCode>
                  <c:ptCount val="1"/>
                  <c:pt idx="0">
                    <c:v>4.6260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C$5</c:f>
              <c:numCache>
                <c:formatCode>General</c:formatCode>
                <c:ptCount val="1"/>
                <c:pt idx="0">
                  <c:v>126.4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1E5-4CB2-B4A7-7D32A9E34EA5}"/>
            </c:ext>
          </c:extLst>
        </c:ser>
        <c:ser>
          <c:idx val="2"/>
          <c:order val="2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6</c:f>
                <c:numCache>
                  <c:formatCode>General</c:formatCode>
                  <c:ptCount val="1"/>
                  <c:pt idx="0">
                    <c:v>4.9139999999999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D$5</c:f>
              <c:numCache>
                <c:formatCode>General</c:formatCode>
                <c:ptCount val="1"/>
                <c:pt idx="0">
                  <c:v>147.2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1E5-4CB2-B4A7-7D32A9E34EA5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E$6</c:f>
                <c:numCache>
                  <c:formatCode>General</c:formatCode>
                  <c:ptCount val="1"/>
                  <c:pt idx="0">
                    <c:v>3.883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E$5</c:f>
              <c:numCache>
                <c:formatCode>General</c:formatCode>
                <c:ptCount val="1"/>
                <c:pt idx="0">
                  <c:v>122.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1E5-4CB2-B4A7-7D32A9E34E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B$8</c:f>
                <c:numCache>
                  <c:formatCode>General</c:formatCode>
                  <c:ptCount val="1"/>
                  <c:pt idx="0">
                    <c:v>15.4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B$7</c:f>
              <c:numCache>
                <c:formatCode>General</c:formatCode>
                <c:ptCount val="1"/>
                <c:pt idx="0">
                  <c:v>249.133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46-4E5A-A77B-C2DF907191A1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C$8</c:f>
                <c:numCache>
                  <c:formatCode>General</c:formatCode>
                  <c:ptCount val="1"/>
                  <c:pt idx="0">
                    <c:v>20.6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C$7</c:f>
              <c:numCache>
                <c:formatCode>General</c:formatCode>
                <c:ptCount val="1"/>
                <c:pt idx="0">
                  <c:v>68.382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046-4E5A-A77B-C2DF907191A1}"/>
            </c:ext>
          </c:extLst>
        </c:ser>
        <c:ser>
          <c:idx val="2"/>
          <c:order val="2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8</c:f>
                <c:numCache>
                  <c:formatCode>General</c:formatCode>
                  <c:ptCount val="1"/>
                  <c:pt idx="0">
                    <c:v>26.774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D$7</c:f>
              <c:numCache>
                <c:formatCode>General</c:formatCode>
                <c:ptCount val="1"/>
                <c:pt idx="0">
                  <c:v>342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046-4E5A-A77B-C2DF907191A1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E$8</c:f>
                <c:numCache>
                  <c:formatCode>General</c:formatCode>
                  <c:ptCount val="1"/>
                  <c:pt idx="0">
                    <c:v>8.51800000000000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E$7</c:f>
              <c:numCache>
                <c:formatCode>General</c:formatCode>
                <c:ptCount val="1"/>
                <c:pt idx="0">
                  <c:v>43.542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046-4E5A-A77B-C2DF907191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B$13</c:f>
                <c:numCache>
                  <c:formatCode>General</c:formatCode>
                  <c:ptCount val="1"/>
                  <c:pt idx="0">
                    <c:v>2.279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B$12</c:f>
              <c:numCache>
                <c:formatCode>General</c:formatCode>
                <c:ptCount val="1"/>
                <c:pt idx="0">
                  <c:v>52.093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FA-4E75-AAD0-7CCB439700AB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C$13</c:f>
                <c:numCache>
                  <c:formatCode>General</c:formatCode>
                  <c:ptCount val="1"/>
                  <c:pt idx="0">
                    <c:v>1.693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C$12</c:f>
              <c:numCache>
                <c:formatCode>General</c:formatCode>
                <c:ptCount val="1"/>
                <c:pt idx="0">
                  <c:v>52.057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FA-4E75-AAD0-7CCB439700AB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13</c:f>
                <c:numCache>
                  <c:formatCode>General</c:formatCode>
                  <c:ptCount val="1"/>
                  <c:pt idx="0">
                    <c:v>2.956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D$12</c:f>
              <c:numCache>
                <c:formatCode>General</c:formatCode>
                <c:ptCount val="1"/>
                <c:pt idx="0">
                  <c:v>53.807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FFA-4E75-AAD0-7CCB439700AB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E$13</c:f>
                <c:numCache>
                  <c:formatCode>General</c:formatCode>
                  <c:ptCount val="1"/>
                  <c:pt idx="0">
                    <c:v>2.474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E$12</c:f>
              <c:numCache>
                <c:formatCode>General</c:formatCode>
                <c:ptCount val="1"/>
                <c:pt idx="0">
                  <c:v>43.307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FFA-4E75-AAD0-7CCB439700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B$17</c:f>
                <c:numCache>
                  <c:formatCode>General</c:formatCode>
                  <c:ptCount val="1"/>
                  <c:pt idx="0">
                    <c:v>0.454736972639915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B$16</c:f>
              <c:numCache>
                <c:formatCode>0.00</c:formatCode>
                <c:ptCount val="1"/>
                <c:pt idx="0">
                  <c:v>7.649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E5-4A12-9F92-E19F85CF5A90}"/>
            </c:ext>
          </c:extLst>
        </c:ser>
        <c:ser>
          <c:idx val="1"/>
          <c:order val="1"/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C$17</c:f>
                <c:numCache>
                  <c:formatCode>General</c:formatCode>
                  <c:ptCount val="1"/>
                  <c:pt idx="0">
                    <c:v>0.407205508963978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C$16</c:f>
              <c:numCache>
                <c:formatCode>0.00</c:formatCode>
                <c:ptCount val="1"/>
                <c:pt idx="0">
                  <c:v>7.07857142857142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E5-4A12-9F92-E19F85CF5A90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D$17</c:f>
                <c:numCache>
                  <c:formatCode>General</c:formatCode>
                  <c:ptCount val="1"/>
                  <c:pt idx="0">
                    <c:v>0.338973122500557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D$16</c:f>
              <c:numCache>
                <c:formatCode>0.00</c:formatCode>
                <c:ptCount val="1"/>
                <c:pt idx="0">
                  <c:v>7.958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E5-4A12-9F92-E19F85CF5A90}"/>
            </c:ext>
          </c:extLst>
        </c:ser>
        <c:ser>
          <c:idx val="3"/>
          <c:order val="3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E$17</c:f>
                <c:numCache>
                  <c:formatCode>General</c:formatCode>
                  <c:ptCount val="1"/>
                  <c:pt idx="0">
                    <c:v>0.457055795281060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A$2</c:f>
              <c:numCache>
                <c:formatCode>General</c:formatCode>
                <c:ptCount val="1"/>
              </c:numCache>
            </c:numRef>
          </c:cat>
          <c:val>
            <c:numRef>
              <c:f>Feuil1!$E$16</c:f>
              <c:numCache>
                <c:formatCode>0.00</c:formatCode>
                <c:ptCount val="1"/>
                <c:pt idx="0">
                  <c:v>6.52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E5-4A12-9F92-E19F85CF5A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88470885583746"/>
          <c:y val="0.21754311291583636"/>
          <c:w val="0.68547331583552051"/>
          <c:h val="0.611098339442869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A19-4AD1-81D3-FCB39821E459}"/>
              </c:ext>
            </c:extLst>
          </c:dPt>
          <c:errBars>
            <c:errBarType val="plus"/>
            <c:errValType val="cust"/>
            <c:noEndCap val="0"/>
            <c:plus>
              <c:numRef>
                <c:f>Feuil1!$O$6:$P$6</c:f>
                <c:numCache>
                  <c:formatCode>General</c:formatCode>
                  <c:ptCount val="2"/>
                  <c:pt idx="0">
                    <c:v>0.30571959014995409</c:v>
                  </c:pt>
                  <c:pt idx="1">
                    <c:v>0.194108108340071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O$1:$P$1</c:f>
              <c:numCache>
                <c:formatCode>General</c:formatCode>
                <c:ptCount val="2"/>
              </c:numCache>
            </c:numRef>
          </c:cat>
          <c:val>
            <c:numRef>
              <c:f>(Feuil1!$O$3,Feuil1!$P$3)</c:f>
              <c:numCache>
                <c:formatCode>0.0000</c:formatCode>
                <c:ptCount val="2"/>
                <c:pt idx="0">
                  <c:v>1.7668318905594522</c:v>
                </c:pt>
                <c:pt idx="1">
                  <c:v>2.56301457086034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A19-4AD1-81D3-FCB39821E459}"/>
            </c:ext>
          </c:extLst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BA19-4AD1-81D3-FCB39821E459}"/>
              </c:ext>
            </c:extLst>
          </c:dPt>
          <c:errBars>
            <c:errBarType val="plus"/>
            <c:errValType val="cust"/>
            <c:noEndCap val="0"/>
            <c:plus>
              <c:numRef>
                <c:f>Feuil1!$O$7:$P$7</c:f>
                <c:numCache>
                  <c:formatCode>General</c:formatCode>
                  <c:ptCount val="2"/>
                  <c:pt idx="0">
                    <c:v>0.20104253664076061</c:v>
                  </c:pt>
                  <c:pt idx="1">
                    <c:v>0.166595107605927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O$1:$P$1</c:f>
              <c:numCache>
                <c:formatCode>General</c:formatCode>
                <c:ptCount val="2"/>
              </c:numCache>
            </c:numRef>
          </c:cat>
          <c:val>
            <c:numRef>
              <c:f>Feuil1!$O$4:$P$4</c:f>
              <c:numCache>
                <c:formatCode>0.0000</c:formatCode>
                <c:ptCount val="2"/>
                <c:pt idx="0">
                  <c:v>0.82511905088137405</c:v>
                </c:pt>
                <c:pt idx="1">
                  <c:v>0.72796078983799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A19-4AD1-81D3-FCB39821E459}"/>
            </c:ext>
          </c:extLst>
        </c:ser>
        <c:ser>
          <c:idx val="2"/>
          <c:order val="2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euil1!$O$8:$P$8</c:f>
                <c:numCache>
                  <c:formatCode>General</c:formatCode>
                  <c:ptCount val="2"/>
                  <c:pt idx="0">
                    <c:v>0.29160000000000003</c:v>
                  </c:pt>
                  <c:pt idx="1">
                    <c:v>0.141513962206908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Feuil1!$O$1:$P$1</c:f>
              <c:numCache>
                <c:formatCode>General</c:formatCode>
                <c:ptCount val="2"/>
              </c:numCache>
            </c:numRef>
          </c:cat>
          <c:val>
            <c:numRef>
              <c:f>Feuil1!$O$5:$P$5</c:f>
              <c:numCache>
                <c:formatCode>0.0000</c:formatCode>
                <c:ptCount val="2"/>
                <c:pt idx="0">
                  <c:v>1.1665000000000001</c:v>
                </c:pt>
                <c:pt idx="1">
                  <c:v>0.915835950364823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A19-4AD1-81D3-FCB39821E4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78304"/>
        <c:axId val="92179840"/>
      </c:barChart>
      <c:catAx>
        <c:axId val="92178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fr-FR"/>
          </a:p>
        </c:txPr>
        <c:crossAx val="92179840"/>
        <c:crosses val="autoZero"/>
        <c:auto val="1"/>
        <c:lblAlgn val="ctr"/>
        <c:lblOffset val="100"/>
        <c:noMultiLvlLbl val="0"/>
      </c:catAx>
      <c:valAx>
        <c:axId val="9217984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fr-FR"/>
          </a:p>
        </c:txPr>
        <c:crossAx val="92178304"/>
        <c:crosses val="autoZero"/>
        <c:crossBetween val="between"/>
        <c:majorUnit val="1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136</cdr:x>
      <cdr:y>0.23609</cdr:y>
    </cdr:from>
    <cdr:to>
      <cdr:x>0.90457</cdr:x>
      <cdr:y>0.44075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672117" y="476742"/>
          <a:ext cx="318722" cy="4132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 anchor="ctr"/>
        <a:lstStyle xmlns:a="http://schemas.openxmlformats.org/drawingml/2006/main"/>
        <a:p xmlns:a="http://schemas.openxmlformats.org/drawingml/2006/main">
          <a:pPr algn="ctr"/>
          <a:r>
            <a:rPr lang="fr-FR" sz="10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  <a:p xmlns:a="http://schemas.openxmlformats.org/drawingml/2006/main">
          <a:pPr algn="ctr"/>
          <a:r>
            <a:rPr lang="fr-FR" sz="900" b="1" dirty="0">
              <a:latin typeface="Arial" panose="020B0604020202020204" pitchFamily="34" charset="0"/>
              <a:cs typeface="Arial" panose="020B0604020202020204" pitchFamily="34" charset="0"/>
            </a:rPr>
            <a:t>$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6911</cdr:x>
      <cdr:y>0.41069</cdr:y>
    </cdr:from>
    <cdr:to>
      <cdr:x>0.93822</cdr:x>
      <cdr:y>0.52294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805531" y="739322"/>
          <a:ext cx="288032" cy="2020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800" b="1" dirty="0">
              <a:latin typeface="Arial" panose="020B0604020202020204" pitchFamily="34" charset="0"/>
              <a:cs typeface="Arial" panose="020B0604020202020204" pitchFamily="34" charset="0"/>
            </a:rPr>
            <a:t>$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4927</cdr:x>
      <cdr:y>0.15774</cdr:y>
    </cdr:from>
    <cdr:to>
      <cdr:x>0.83326</cdr:x>
      <cdr:y>0.39365</cdr:y>
    </cdr:to>
    <cdr:sp macro="" textlink="">
      <cdr:nvSpPr>
        <cdr:cNvPr id="3" name="ZoneTexte 1"/>
        <cdr:cNvSpPr txBox="1"/>
      </cdr:nvSpPr>
      <cdr:spPr>
        <a:xfrm xmlns:a="http://schemas.openxmlformats.org/drawingml/2006/main" rot="16200000">
          <a:off x="496496" y="273850"/>
          <a:ext cx="414641" cy="4214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000" b="1" dirty="0" smtClean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5003</cdr:x>
      <cdr:y>0.17736</cdr:y>
    </cdr:from>
    <cdr:to>
      <cdr:x>0.61952</cdr:x>
      <cdr:y>0.44556</cdr:y>
    </cdr:to>
    <cdr:sp macro="" textlink="">
      <cdr:nvSpPr>
        <cdr:cNvPr id="2" name="ZoneTexte 1"/>
        <cdr:cNvSpPr txBox="1"/>
      </cdr:nvSpPr>
      <cdr:spPr>
        <a:xfrm xmlns:a="http://schemas.openxmlformats.org/drawingml/2006/main" rot="16200000">
          <a:off x="296371" y="399541"/>
          <a:ext cx="471389" cy="2957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 anchor="ctr"/>
        <a:lstStyle xmlns:a="http://schemas.openxmlformats.org/drawingml/2006/main"/>
        <a:p xmlns:a="http://schemas.openxmlformats.org/drawingml/2006/main">
          <a:pPr algn="ctr"/>
          <a:r>
            <a:rPr lang="fr-FR" sz="900" b="1" dirty="0" smtClean="0">
              <a:latin typeface="Arial" panose="020B0604020202020204" pitchFamily="34" charset="0"/>
              <a:cs typeface="Arial" panose="020B0604020202020204" pitchFamily="34" charset="0"/>
            </a:rPr>
            <a:t>$$$</a:t>
          </a:r>
          <a:endParaRPr lang="fr-FR" sz="9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694</cdr:x>
      <cdr:y>0.18947</cdr:y>
    </cdr:from>
    <cdr:to>
      <cdr:x>0.1536</cdr:x>
      <cdr:y>0.36443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363141" y="458402"/>
          <a:ext cx="440612" cy="4232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fr-FR" sz="900" b="1">
              <a:latin typeface="Arial" panose="020B0604020202020204" pitchFamily="34" charset="0"/>
              <a:cs typeface="Arial" panose="020B0604020202020204" pitchFamily="34" charset="0"/>
            </a:rPr>
            <a:t>***</a:t>
          </a:r>
        </a:p>
        <a:p xmlns:a="http://schemas.openxmlformats.org/drawingml/2006/main">
          <a:pPr algn="ctr"/>
          <a:r>
            <a:rPr lang="fr-FR" sz="900" b="1">
              <a:latin typeface="Arial" panose="020B0604020202020204" pitchFamily="34" charset="0"/>
              <a:cs typeface="Arial" panose="020B0604020202020204" pitchFamily="34" charset="0"/>
            </a:rPr>
            <a:t>$$</a:t>
          </a:r>
          <a:r>
            <a:rPr lang="fr-FR" sz="900" b="1" baseline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endParaRPr lang="fr-FR" sz="9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21948</cdr:x>
      <cdr:y>0.16663</cdr:y>
    </cdr:from>
    <cdr:to>
      <cdr:x>0.34243</cdr:x>
      <cdr:y>0.2313</cdr:y>
    </cdr:to>
    <cdr:sp macro="" textlink="">
      <cdr:nvSpPr>
        <cdr:cNvPr id="6" name="ZoneTexte 1"/>
        <cdr:cNvSpPr txBox="1"/>
      </cdr:nvSpPr>
      <cdr:spPr>
        <a:xfrm xmlns:a="http://schemas.openxmlformats.org/drawingml/2006/main">
          <a:off x="1152675" y="403126"/>
          <a:ext cx="645715" cy="1564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900" b="1" dirty="0" smtClean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fr-FR" sz="900" b="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1615</cdr:x>
      <cdr:y>0.14403</cdr:y>
    </cdr:from>
    <cdr:to>
      <cdr:x>0.48554</cdr:x>
      <cdr:y>0.31899</cdr:y>
    </cdr:to>
    <cdr:sp macro="" textlink="">
      <cdr:nvSpPr>
        <cdr:cNvPr id="7" name="ZoneTexte 1"/>
        <cdr:cNvSpPr txBox="1"/>
      </cdr:nvSpPr>
      <cdr:spPr>
        <a:xfrm xmlns:a="http://schemas.openxmlformats.org/drawingml/2006/main">
          <a:off x="2212312" y="348462"/>
          <a:ext cx="368887" cy="4232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900" b="1">
              <a:latin typeface="Arial" panose="020B0604020202020204" pitchFamily="34" charset="0"/>
              <a:cs typeface="Arial" panose="020B0604020202020204" pitchFamily="34" charset="0"/>
            </a:rPr>
            <a:t>***</a:t>
          </a:r>
        </a:p>
        <a:p xmlns:a="http://schemas.openxmlformats.org/drawingml/2006/main">
          <a:pPr algn="ctr"/>
          <a:r>
            <a:rPr lang="fr-FR" sz="900" b="1">
              <a:latin typeface="Arial" panose="020B0604020202020204" pitchFamily="34" charset="0"/>
              <a:cs typeface="Arial" panose="020B0604020202020204" pitchFamily="34" charset="0"/>
            </a:rPr>
            <a:t>$</a:t>
          </a:r>
          <a:r>
            <a:rPr lang="fr-FR" sz="900" b="1" baseline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endParaRPr lang="fr-FR" sz="9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6102</cdr:x>
      <cdr:y>0.09777</cdr:y>
    </cdr:from>
    <cdr:to>
      <cdr:x>0.67008</cdr:x>
      <cdr:y>0.23541</cdr:y>
    </cdr:to>
    <cdr:sp macro="" textlink="">
      <cdr:nvSpPr>
        <cdr:cNvPr id="8" name="ZoneTexte 1"/>
        <cdr:cNvSpPr txBox="1"/>
      </cdr:nvSpPr>
      <cdr:spPr>
        <a:xfrm xmlns:a="http://schemas.openxmlformats.org/drawingml/2006/main">
          <a:off x="2935704" y="236545"/>
          <a:ext cx="570687" cy="333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900" b="1">
              <a:latin typeface="Arial" panose="020B0604020202020204" pitchFamily="34" charset="0"/>
              <a:cs typeface="Arial" panose="020B0604020202020204" pitchFamily="34" charset="0"/>
            </a:rPr>
            <a:t>* </a:t>
          </a:r>
          <a:endParaRPr lang="fr-FR" sz="900" b="0">
            <a:latin typeface="Arial" panose="020B0604020202020204" pitchFamily="34" charset="0"/>
            <a:cs typeface="Arial" panose="020B0604020202020204" pitchFamily="34" charset="0"/>
          </a:endParaRPr>
        </a:p>
        <a:p xmlns:a="http://schemas.openxmlformats.org/drawingml/2006/main">
          <a:pPr algn="ctr"/>
          <a:r>
            <a:rPr lang="fr-FR" sz="900" b="1">
              <a:latin typeface="Arial" panose="020B0604020202020204" pitchFamily="34" charset="0"/>
              <a:cs typeface="Arial" panose="020B0604020202020204" pitchFamily="34" charset="0"/>
            </a:rPr>
            <a:t>$</a:t>
          </a:r>
          <a:endParaRPr lang="fr-FR" sz="900" b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413</cdr:x>
      <cdr:y>0.24852</cdr:y>
    </cdr:from>
    <cdr:to>
      <cdr:x>0.76223</cdr:x>
      <cdr:y>0.36483</cdr:y>
    </cdr:to>
    <cdr:sp macro="" textlink="">
      <cdr:nvSpPr>
        <cdr:cNvPr id="11" name="ZoneTexte 1"/>
        <cdr:cNvSpPr txBox="1"/>
      </cdr:nvSpPr>
      <cdr:spPr>
        <a:xfrm xmlns:a="http://schemas.openxmlformats.org/drawingml/2006/main">
          <a:off x="3355778" y="601265"/>
          <a:ext cx="632817" cy="2813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900" b="1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fr-FR" sz="900" b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7757</cdr:x>
      <cdr:y>0.1614</cdr:y>
    </cdr:from>
    <cdr:to>
      <cdr:x>0.31902</cdr:x>
      <cdr:y>0.26249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467896" y="309435"/>
          <a:ext cx="372749" cy="1937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fr-FR" sz="1000" b="1" dirty="0" smtClean="0">
              <a:latin typeface="Arial" panose="020B0604020202020204" pitchFamily="34" charset="0"/>
              <a:cs typeface="Arial" panose="020B0604020202020204" pitchFamily="34" charset="0"/>
            </a:rPr>
            <a:t>$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4971</cdr:x>
      <cdr:y>0.26038</cdr:y>
    </cdr:from>
    <cdr:to>
      <cdr:x>0.95947</cdr:x>
      <cdr:y>0.74117</cdr:y>
    </cdr:to>
    <cdr:sp macro="" textlink="">
      <cdr:nvSpPr>
        <cdr:cNvPr id="3" name="ZoneTexte 1"/>
        <cdr:cNvSpPr txBox="1"/>
      </cdr:nvSpPr>
      <cdr:spPr>
        <a:xfrm xmlns:a="http://schemas.openxmlformats.org/drawingml/2006/main" rot="16200000">
          <a:off x="1767853" y="689784"/>
          <a:ext cx="788179" cy="26232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900" b="1" dirty="0" smtClean="0">
              <a:latin typeface="Arial" panose="020B0604020202020204" pitchFamily="34" charset="0"/>
              <a:cs typeface="Arial" panose="020B0604020202020204" pitchFamily="34" charset="0"/>
            </a:rPr>
            <a:t>$ </a:t>
          </a:r>
          <a:r>
            <a:rPr lang="fr-FR" sz="900" b="0" dirty="0" smtClean="0">
              <a:latin typeface="Arial" panose="020B0604020202020204" pitchFamily="34" charset="0"/>
              <a:cs typeface="Arial" panose="020B0604020202020204" pitchFamily="34" charset="0"/>
            </a:rPr>
            <a:t>p=0.09</a:t>
          </a:r>
          <a:endParaRPr lang="fr-FR" sz="900" b="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9978</cdr:x>
      <cdr:y>0.16784</cdr:y>
    </cdr:from>
    <cdr:to>
      <cdr:x>0.87705</cdr:x>
      <cdr:y>0.58348</cdr:y>
    </cdr:to>
    <cdr:sp macro="" textlink="">
      <cdr:nvSpPr>
        <cdr:cNvPr id="4" name="ZoneTexte 1"/>
        <cdr:cNvSpPr txBox="1"/>
      </cdr:nvSpPr>
      <cdr:spPr>
        <a:xfrm xmlns:a="http://schemas.openxmlformats.org/drawingml/2006/main" rot="16200000">
          <a:off x="1663088" y="523500"/>
          <a:ext cx="681382" cy="1846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900" b="0" dirty="0" smtClean="0">
              <a:latin typeface="Arial" panose="020B0604020202020204" pitchFamily="34" charset="0"/>
              <a:cs typeface="Arial" panose="020B0604020202020204" pitchFamily="34" charset="0"/>
            </a:rPr>
            <a:t>* p=0.09</a:t>
          </a:r>
          <a:r>
            <a:rPr lang="fr-FR" sz="900" b="0" baseline="0" dirty="0" smtClean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endParaRPr lang="fr-FR" sz="900" b="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22539</cdr:x>
      <cdr:y>0.07905</cdr:y>
    </cdr:from>
    <cdr:to>
      <cdr:x>0.46891</cdr:x>
      <cdr:y>0.20687</cdr:y>
    </cdr:to>
    <cdr:sp macro="" textlink="">
      <cdr:nvSpPr>
        <cdr:cNvPr id="7" name="ZoneTexte 1"/>
        <cdr:cNvSpPr txBox="1"/>
      </cdr:nvSpPr>
      <cdr:spPr>
        <a:xfrm xmlns:a="http://schemas.openxmlformats.org/drawingml/2006/main">
          <a:off x="593906" y="151548"/>
          <a:ext cx="641689" cy="2450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000" b="1" dirty="0" smtClean="0">
              <a:latin typeface="Arial" panose="020B0604020202020204" pitchFamily="34" charset="0"/>
              <a:cs typeface="Arial" panose="020B0604020202020204" pitchFamily="34" charset="0"/>
            </a:rPr>
            <a:t>$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2899</cdr:x>
      <cdr:y>0.49677</cdr:y>
    </cdr:from>
    <cdr:to>
      <cdr:x>0.85226</cdr:x>
      <cdr:y>0.60818</cdr:y>
    </cdr:to>
    <cdr:sp macro="" textlink="">
      <cdr:nvSpPr>
        <cdr:cNvPr id="8" name="ZoneTexte 1"/>
        <cdr:cNvSpPr txBox="1"/>
      </cdr:nvSpPr>
      <cdr:spPr>
        <a:xfrm xmlns:a="http://schemas.openxmlformats.org/drawingml/2006/main">
          <a:off x="1742272" y="814388"/>
          <a:ext cx="294606" cy="1826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000" b="1" dirty="0" smtClean="0">
              <a:latin typeface="Arial" panose="020B0604020202020204" pitchFamily="34" charset="0"/>
              <a:cs typeface="Arial" panose="020B0604020202020204" pitchFamily="34" charset="0"/>
            </a:rPr>
            <a:t>$$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46246</cdr:x>
      <cdr:y>0.07282</cdr:y>
    </cdr:from>
    <cdr:to>
      <cdr:x>0.60791</cdr:x>
      <cdr:y>0.17518</cdr:y>
    </cdr:to>
    <cdr:sp macro="" textlink="">
      <cdr:nvSpPr>
        <cdr:cNvPr id="7" name="ZoneTexte 1"/>
        <cdr:cNvSpPr txBox="1"/>
      </cdr:nvSpPr>
      <cdr:spPr>
        <a:xfrm xmlns:a="http://schemas.openxmlformats.org/drawingml/2006/main">
          <a:off x="457030" y="104519"/>
          <a:ext cx="143743" cy="1469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000" b="1" dirty="0" smtClean="0">
              <a:latin typeface="Arial" panose="020B0604020202020204" pitchFamily="34" charset="0"/>
              <a:cs typeface="Arial" panose="020B0604020202020204" pitchFamily="34" charset="0"/>
            </a:rPr>
            <a:t>$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41736</cdr:x>
      <cdr:y>0.10618</cdr:y>
    </cdr:from>
    <cdr:to>
      <cdr:x>0.56572</cdr:x>
      <cdr:y>0.19908</cdr:y>
    </cdr:to>
    <cdr:sp macro="" textlink="">
      <cdr:nvSpPr>
        <cdr:cNvPr id="7" name="ZoneTexte 1"/>
        <cdr:cNvSpPr txBox="1"/>
      </cdr:nvSpPr>
      <cdr:spPr>
        <a:xfrm xmlns:a="http://schemas.openxmlformats.org/drawingml/2006/main">
          <a:off x="383328" y="152400"/>
          <a:ext cx="136260" cy="1333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000" b="1" dirty="0" smtClean="0">
              <a:latin typeface="Arial" panose="020B0604020202020204" pitchFamily="34" charset="0"/>
              <a:cs typeface="Arial" panose="020B0604020202020204" pitchFamily="34" charset="0"/>
            </a:rPr>
            <a:t>$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5949</cdr:x>
      <cdr:y>0.01614</cdr:y>
    </cdr:from>
    <cdr:to>
      <cdr:x>0.80493</cdr:x>
      <cdr:y>0.1185</cdr:y>
    </cdr:to>
    <cdr:sp macro="" textlink="">
      <cdr:nvSpPr>
        <cdr:cNvPr id="3" name="ZoneTexte 1"/>
        <cdr:cNvSpPr txBox="1"/>
      </cdr:nvSpPr>
      <cdr:spPr>
        <a:xfrm xmlns:a="http://schemas.openxmlformats.org/drawingml/2006/main">
          <a:off x="857623" y="39595"/>
          <a:ext cx="189149" cy="2510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ctr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000" b="1" dirty="0" smtClean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2774</cdr:x>
      <cdr:y>0</cdr:y>
    </cdr:from>
    <cdr:to>
      <cdr:x>0.99226</cdr:x>
      <cdr:y>0.11885</cdr:y>
    </cdr:to>
    <cdr:sp macro="" textlink="">
      <cdr:nvSpPr>
        <cdr:cNvPr id="2" name="ZoneTexte 77"/>
        <cdr:cNvSpPr txBox="1"/>
      </cdr:nvSpPr>
      <cdr:spPr>
        <a:xfrm xmlns:a="http://schemas.openxmlformats.org/drawingml/2006/main">
          <a:off x="304251" y="-3766331"/>
          <a:ext cx="784045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fr-FR"/>
          </a:defPPr>
          <a:lvl1pPr marL="0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521528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1043056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564584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2086112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607640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3129168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650696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4172224" algn="l" defTabSz="1043056" rtl="0" eaLnBrk="1" latinLnBrk="0" hangingPunct="1">
            <a:defRPr sz="21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fr-FR" sz="1000" b="1" smtClean="0">
              <a:latin typeface="Arial" panose="020B0604020202020204" pitchFamily="34" charset="0"/>
              <a:cs typeface="Arial" panose="020B0604020202020204" pitchFamily="34" charset="0"/>
            </a:rPr>
            <a:t>exercise</a:t>
          </a:r>
          <a:endParaRPr lang="fr-FR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67673</cdr:x>
      <cdr:y>0.06907</cdr:y>
    </cdr:from>
    <cdr:to>
      <cdr:x>0.87213</cdr:x>
      <cdr:y>0.18831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1033406" y="135857"/>
          <a:ext cx="298387" cy="2345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 anchor="ctr"/>
        <a:lstStyle xmlns:a="http://schemas.openxmlformats.org/drawingml/2006/main"/>
        <a:p xmlns:a="http://schemas.openxmlformats.org/drawingml/2006/main">
          <a:pPr algn="ctr"/>
          <a:r>
            <a:rPr lang="fr-FR" sz="800" b="1" dirty="0">
              <a:latin typeface="Arial" panose="020B0604020202020204" pitchFamily="34" charset="0"/>
              <a:cs typeface="Arial" panose="020B0604020202020204" pitchFamily="34" charset="0"/>
            </a:rPr>
            <a:t>$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67673</cdr:x>
      <cdr:y>0.06907</cdr:y>
    </cdr:from>
    <cdr:to>
      <cdr:x>0.87213</cdr:x>
      <cdr:y>0.18831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1033406" y="135857"/>
          <a:ext cx="298387" cy="2345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 anchor="ctr"/>
        <a:lstStyle xmlns:a="http://schemas.openxmlformats.org/drawingml/2006/main"/>
        <a:p xmlns:a="http://schemas.openxmlformats.org/drawingml/2006/main">
          <a:pPr algn="ctr"/>
          <a:r>
            <a:rPr lang="fr-FR" sz="800" b="1">
              <a:latin typeface="Arial" panose="020B0604020202020204" pitchFamily="34" charset="0"/>
              <a:cs typeface="Arial" panose="020B0604020202020204" pitchFamily="34" charset="0"/>
            </a:rPr>
            <a:t>$</a:t>
          </a:r>
          <a:endParaRPr lang="fr-FR" sz="10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887186" cy="496332"/>
          </a:xfrm>
          <a:prstGeom prst="rect">
            <a:avLst/>
          </a:prstGeom>
        </p:spPr>
        <p:txBody>
          <a:bodyPr vert="horz" lIns="94789" tIns="47394" rIns="94789" bIns="47394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4010" y="1"/>
            <a:ext cx="2887186" cy="496332"/>
          </a:xfrm>
          <a:prstGeom prst="rect">
            <a:avLst/>
          </a:prstGeom>
        </p:spPr>
        <p:txBody>
          <a:bodyPr vert="horz" lIns="94789" tIns="47394" rIns="94789" bIns="47394" rtlCol="0"/>
          <a:lstStyle>
            <a:lvl1pPr algn="r">
              <a:defRPr sz="1200"/>
            </a:lvl1pPr>
          </a:lstStyle>
          <a:p>
            <a:fld id="{72C08729-8FF2-4982-ACEC-E37213756563}" type="datetimeFigureOut">
              <a:rPr lang="fr-FR" smtClean="0"/>
              <a:t>03/05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16125" y="744538"/>
            <a:ext cx="263048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89" tIns="47394" rIns="94789" bIns="47394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274" y="4715153"/>
            <a:ext cx="5330190" cy="4466987"/>
          </a:xfrm>
          <a:prstGeom prst="rect">
            <a:avLst/>
          </a:prstGeom>
        </p:spPr>
        <p:txBody>
          <a:bodyPr vert="horz" lIns="94789" tIns="47394" rIns="94789" bIns="47394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887186" cy="496332"/>
          </a:xfrm>
          <a:prstGeom prst="rect">
            <a:avLst/>
          </a:prstGeom>
        </p:spPr>
        <p:txBody>
          <a:bodyPr vert="horz" lIns="94789" tIns="47394" rIns="94789" bIns="47394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4010" y="9428584"/>
            <a:ext cx="2887186" cy="496332"/>
          </a:xfrm>
          <a:prstGeom prst="rect">
            <a:avLst/>
          </a:prstGeom>
        </p:spPr>
        <p:txBody>
          <a:bodyPr vert="horz" lIns="94789" tIns="47394" rIns="94789" bIns="47394" rtlCol="0" anchor="b"/>
          <a:lstStyle>
            <a:lvl1pPr algn="r">
              <a:defRPr sz="1200"/>
            </a:lvl1pPr>
          </a:lstStyle>
          <a:p>
            <a:fld id="{24A860D9-CE86-4ED3-A22D-39DBC3483EF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38098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521528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1043056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564584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2086112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607640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3129168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650696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4172224" algn="l" defTabSz="104305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C0E4B93-1C07-4981-8E9E-69A5AA6767E1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67474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87407D-9B1F-488F-806F-F9249C9F133F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10545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7095" y="3321887"/>
            <a:ext cx="6427074" cy="2292150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15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30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45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6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07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291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506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722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481916" y="428234"/>
            <a:ext cx="1701284" cy="9124044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8063" y="428234"/>
            <a:ext cx="4977831" cy="9124044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7288" y="6871500"/>
            <a:ext cx="6427074" cy="2123828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7288" y="4532321"/>
            <a:ext cx="6427074" cy="2339180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152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305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458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611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076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291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5069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722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8063" y="2495129"/>
            <a:ext cx="3339558" cy="7057149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843642" y="2495129"/>
            <a:ext cx="3339558" cy="7057149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4" y="2393639"/>
            <a:ext cx="3340871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528" indent="0">
              <a:buNone/>
              <a:defRPr sz="2300" b="1"/>
            </a:lvl2pPr>
            <a:lvl3pPr marL="1043056" indent="0">
              <a:buNone/>
              <a:defRPr sz="2100" b="1"/>
            </a:lvl3pPr>
            <a:lvl4pPr marL="1564584" indent="0">
              <a:buNone/>
              <a:defRPr sz="1800" b="1"/>
            </a:lvl4pPr>
            <a:lvl5pPr marL="2086112" indent="0">
              <a:buNone/>
              <a:defRPr sz="1800" b="1"/>
            </a:lvl5pPr>
            <a:lvl6pPr marL="2607640" indent="0">
              <a:buNone/>
              <a:defRPr sz="1800" b="1"/>
            </a:lvl6pPr>
            <a:lvl7pPr marL="3129168" indent="0">
              <a:buNone/>
              <a:defRPr sz="1800" b="1"/>
            </a:lvl7pPr>
            <a:lvl8pPr marL="3650696" indent="0">
              <a:buNone/>
              <a:defRPr sz="1800" b="1"/>
            </a:lvl8pPr>
            <a:lvl9pPr marL="4172224" indent="0">
              <a:buNone/>
              <a:defRPr sz="18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064" y="3391194"/>
            <a:ext cx="3340871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528" indent="0">
              <a:buNone/>
              <a:defRPr sz="2300" b="1"/>
            </a:lvl2pPr>
            <a:lvl3pPr marL="1043056" indent="0">
              <a:buNone/>
              <a:defRPr sz="2100" b="1"/>
            </a:lvl3pPr>
            <a:lvl4pPr marL="1564584" indent="0">
              <a:buNone/>
              <a:defRPr sz="1800" b="1"/>
            </a:lvl4pPr>
            <a:lvl5pPr marL="2086112" indent="0">
              <a:buNone/>
              <a:defRPr sz="1800" b="1"/>
            </a:lvl5pPr>
            <a:lvl6pPr marL="2607640" indent="0">
              <a:buNone/>
              <a:defRPr sz="1800" b="1"/>
            </a:lvl6pPr>
            <a:lvl7pPr marL="3129168" indent="0">
              <a:buNone/>
              <a:defRPr sz="1800" b="1"/>
            </a:lvl7pPr>
            <a:lvl8pPr marL="3650696" indent="0">
              <a:buNone/>
              <a:defRPr sz="1800" b="1"/>
            </a:lvl8pPr>
            <a:lvl9pPr marL="4172224" indent="0">
              <a:buNone/>
              <a:defRPr sz="18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4" cy="1811937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56244" y="425757"/>
            <a:ext cx="4226957" cy="912652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4" cy="7314584"/>
          </a:xfrm>
        </p:spPr>
        <p:txBody>
          <a:bodyPr/>
          <a:lstStyle>
            <a:lvl1pPr marL="0" indent="0">
              <a:buNone/>
              <a:defRPr sz="1600"/>
            </a:lvl1pPr>
            <a:lvl2pPr marL="521528" indent="0">
              <a:buNone/>
              <a:defRPr sz="1400"/>
            </a:lvl2pPr>
            <a:lvl3pPr marL="1043056" indent="0">
              <a:buNone/>
              <a:defRPr sz="1100"/>
            </a:lvl3pPr>
            <a:lvl4pPr marL="1564584" indent="0">
              <a:buNone/>
              <a:defRPr sz="1000"/>
            </a:lvl4pPr>
            <a:lvl5pPr marL="2086112" indent="0">
              <a:buNone/>
              <a:defRPr sz="1000"/>
            </a:lvl5pPr>
            <a:lvl6pPr marL="2607640" indent="0">
              <a:buNone/>
              <a:defRPr sz="1000"/>
            </a:lvl6pPr>
            <a:lvl7pPr marL="3129168" indent="0">
              <a:buNone/>
              <a:defRPr sz="1000"/>
            </a:lvl7pPr>
            <a:lvl8pPr marL="3650696" indent="0">
              <a:buNone/>
              <a:defRPr sz="1000"/>
            </a:lvl8pPr>
            <a:lvl9pPr marL="4172224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2060" y="7485381"/>
            <a:ext cx="4536758" cy="883692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700"/>
            </a:lvl1pPr>
            <a:lvl2pPr marL="521528" indent="0">
              <a:buNone/>
              <a:defRPr sz="3200"/>
            </a:lvl2pPr>
            <a:lvl3pPr marL="1043056" indent="0">
              <a:buNone/>
              <a:defRPr sz="2700"/>
            </a:lvl3pPr>
            <a:lvl4pPr marL="1564584" indent="0">
              <a:buNone/>
              <a:defRPr sz="2300"/>
            </a:lvl4pPr>
            <a:lvl5pPr marL="2086112" indent="0">
              <a:buNone/>
              <a:defRPr sz="2300"/>
            </a:lvl5pPr>
            <a:lvl6pPr marL="2607640" indent="0">
              <a:buNone/>
              <a:defRPr sz="2300"/>
            </a:lvl6pPr>
            <a:lvl7pPr marL="3129168" indent="0">
              <a:buNone/>
              <a:defRPr sz="2300"/>
            </a:lvl7pPr>
            <a:lvl8pPr marL="3650696" indent="0">
              <a:buNone/>
              <a:defRPr sz="2300"/>
            </a:lvl8pPr>
            <a:lvl9pPr marL="4172224" indent="0">
              <a:buNone/>
              <a:defRPr sz="23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2060" y="8369073"/>
            <a:ext cx="4536758" cy="1254988"/>
          </a:xfrm>
        </p:spPr>
        <p:txBody>
          <a:bodyPr/>
          <a:lstStyle>
            <a:lvl1pPr marL="0" indent="0">
              <a:buNone/>
              <a:defRPr sz="1600"/>
            </a:lvl1pPr>
            <a:lvl2pPr marL="521528" indent="0">
              <a:buNone/>
              <a:defRPr sz="1400"/>
            </a:lvl2pPr>
            <a:lvl3pPr marL="1043056" indent="0">
              <a:buNone/>
              <a:defRPr sz="1100"/>
            </a:lvl3pPr>
            <a:lvl4pPr marL="1564584" indent="0">
              <a:buNone/>
              <a:defRPr sz="1000"/>
            </a:lvl4pPr>
            <a:lvl5pPr marL="2086112" indent="0">
              <a:buNone/>
              <a:defRPr sz="1000"/>
            </a:lvl5pPr>
            <a:lvl6pPr marL="2607640" indent="0">
              <a:buNone/>
              <a:defRPr sz="1000"/>
            </a:lvl6pPr>
            <a:lvl7pPr marL="3129168" indent="0">
              <a:buNone/>
              <a:defRPr sz="1000"/>
            </a:lvl7pPr>
            <a:lvl8pPr marL="3650696" indent="0">
              <a:buNone/>
              <a:defRPr sz="1000"/>
            </a:lvl8pPr>
            <a:lvl9pPr marL="4172224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104306" tIns="52153" rIns="104306" bIns="52153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495129"/>
            <a:ext cx="6805137" cy="7057149"/>
          </a:xfrm>
          <a:prstGeom prst="rect">
            <a:avLst/>
          </a:prstGeom>
        </p:spPr>
        <p:txBody>
          <a:bodyPr vert="horz" lIns="104306" tIns="52153" rIns="104306" bIns="52153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063" y="9911199"/>
            <a:ext cx="1764295" cy="569324"/>
          </a:xfrm>
          <a:prstGeom prst="rect">
            <a:avLst/>
          </a:prstGeom>
        </p:spPr>
        <p:txBody>
          <a:bodyPr vert="horz" lIns="104306" tIns="52153" rIns="104306" bIns="52153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t>03/05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3432" y="9911199"/>
            <a:ext cx="2394400" cy="569324"/>
          </a:xfrm>
          <a:prstGeom prst="rect">
            <a:avLst/>
          </a:prstGeom>
        </p:spPr>
        <p:txBody>
          <a:bodyPr vert="horz" lIns="104306" tIns="52153" rIns="104306" bIns="52153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18905" y="9911199"/>
            <a:ext cx="1764295" cy="569324"/>
          </a:xfrm>
          <a:prstGeom prst="rect">
            <a:avLst/>
          </a:prstGeom>
        </p:spPr>
        <p:txBody>
          <a:bodyPr vert="horz" lIns="104306" tIns="52153" rIns="104306" bIns="52153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43056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1146" indent="-391146" algn="l" defTabSz="1043056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47483" indent="-325955" algn="l" defTabSz="1043056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3820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5348" indent="-260764" algn="l" defTabSz="1043056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6876" indent="-260764" algn="l" defTabSz="1043056" rtl="0" eaLnBrk="1" latinLnBrk="0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68404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89932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11460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2988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1528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3056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4584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6112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07640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9168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0696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72224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8.png"/><Relationship Id="rId18" Type="http://schemas.openxmlformats.org/officeDocument/2006/relationships/chart" Target="../charts/chart8.xml"/><Relationship Id="rId3" Type="http://schemas.openxmlformats.org/officeDocument/2006/relationships/chart" Target="../charts/chart1.xml"/><Relationship Id="rId7" Type="http://schemas.openxmlformats.org/officeDocument/2006/relationships/chart" Target="../charts/chart3.xml"/><Relationship Id="rId12" Type="http://schemas.openxmlformats.org/officeDocument/2006/relationships/image" Target="../media/image7.png"/><Relationship Id="rId17" Type="http://schemas.openxmlformats.org/officeDocument/2006/relationships/chart" Target="../charts/chart7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6.xml"/><Relationship Id="rId20" Type="http://schemas.openxmlformats.org/officeDocument/2006/relationships/chart" Target="../charts/chart1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tiff"/><Relationship Id="rId11" Type="http://schemas.openxmlformats.org/officeDocument/2006/relationships/image" Target="../media/image6.png"/><Relationship Id="rId5" Type="http://schemas.openxmlformats.org/officeDocument/2006/relationships/image" Target="../media/image1.tiff"/><Relationship Id="rId15" Type="http://schemas.openxmlformats.org/officeDocument/2006/relationships/chart" Target="../charts/chart5.xml"/><Relationship Id="rId10" Type="http://schemas.openxmlformats.org/officeDocument/2006/relationships/image" Target="../media/image5.png"/><Relationship Id="rId19" Type="http://schemas.openxmlformats.org/officeDocument/2006/relationships/chart" Target="../charts/chart9.xml"/><Relationship Id="rId4" Type="http://schemas.openxmlformats.org/officeDocument/2006/relationships/chart" Target="../charts/chart2.xml"/><Relationship Id="rId9" Type="http://schemas.openxmlformats.org/officeDocument/2006/relationships/image" Target="../media/image4.png"/><Relationship Id="rId14" Type="http://schemas.openxmlformats.org/officeDocument/2006/relationships/chart" Target="../charts/chart4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9.xml"/><Relationship Id="rId3" Type="http://schemas.openxmlformats.org/officeDocument/2006/relationships/chart" Target="../charts/chart28.xml"/><Relationship Id="rId7" Type="http://schemas.openxmlformats.org/officeDocument/2006/relationships/image" Target="../media/image12.tiff"/><Relationship Id="rId2" Type="http://schemas.openxmlformats.org/officeDocument/2006/relationships/chart" Target="../charts/chart2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6.xml"/><Relationship Id="rId5" Type="http://schemas.openxmlformats.org/officeDocument/2006/relationships/chart" Target="../charts/chart15.xml"/><Relationship Id="rId4" Type="http://schemas.openxmlformats.org/officeDocument/2006/relationships/chart" Target="../charts/chart14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13" Type="http://schemas.openxmlformats.org/officeDocument/2006/relationships/image" Target="../media/image18.tiff"/><Relationship Id="rId3" Type="http://schemas.microsoft.com/office/2007/relationships/hdphoto" Target="../media/hdphoto1.wdp"/><Relationship Id="rId7" Type="http://schemas.openxmlformats.org/officeDocument/2006/relationships/image" Target="../media/image13.tiff"/><Relationship Id="rId12" Type="http://schemas.openxmlformats.org/officeDocument/2006/relationships/image" Target="../media/image17.tiff"/><Relationship Id="rId2" Type="http://schemas.openxmlformats.org/officeDocument/2006/relationships/image" Target="../media/image9.png"/><Relationship Id="rId16" Type="http://schemas.openxmlformats.org/officeDocument/2006/relationships/chart" Target="../charts/chart1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11" Type="http://schemas.openxmlformats.org/officeDocument/2006/relationships/image" Target="../media/image16.tiff"/><Relationship Id="rId5" Type="http://schemas.openxmlformats.org/officeDocument/2006/relationships/image" Target="../media/image11.tiff"/><Relationship Id="rId15" Type="http://schemas.microsoft.com/office/2007/relationships/hdphoto" Target="../media/hdphoto2.wdp"/><Relationship Id="rId10" Type="http://schemas.openxmlformats.org/officeDocument/2006/relationships/image" Target="../media/image15.tiff"/><Relationship Id="rId4" Type="http://schemas.openxmlformats.org/officeDocument/2006/relationships/image" Target="../media/image10.tiff"/><Relationship Id="rId9" Type="http://schemas.openxmlformats.org/officeDocument/2006/relationships/chart" Target="../charts/chart17.xml"/><Relationship Id="rId14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tiff"/><Relationship Id="rId13" Type="http://schemas.openxmlformats.org/officeDocument/2006/relationships/image" Target="../media/image36.tiff"/><Relationship Id="rId3" Type="http://schemas.openxmlformats.org/officeDocument/2006/relationships/image" Target="../media/image26.tiff"/><Relationship Id="rId7" Type="http://schemas.openxmlformats.org/officeDocument/2006/relationships/image" Target="../media/image30.tiff"/><Relationship Id="rId12" Type="http://schemas.openxmlformats.org/officeDocument/2006/relationships/image" Target="../media/image35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tiff"/><Relationship Id="rId11" Type="http://schemas.openxmlformats.org/officeDocument/2006/relationships/image" Target="../media/image34.tiff"/><Relationship Id="rId5" Type="http://schemas.openxmlformats.org/officeDocument/2006/relationships/image" Target="../media/image28.tiff"/><Relationship Id="rId15" Type="http://schemas.openxmlformats.org/officeDocument/2006/relationships/image" Target="../media/image38.png"/><Relationship Id="rId10" Type="http://schemas.openxmlformats.org/officeDocument/2006/relationships/image" Target="../media/image33.tiff"/><Relationship Id="rId4" Type="http://schemas.openxmlformats.org/officeDocument/2006/relationships/image" Target="../media/image27.tiff"/><Relationship Id="rId9" Type="http://schemas.openxmlformats.org/officeDocument/2006/relationships/image" Target="../media/image32.tiff"/><Relationship Id="rId14" Type="http://schemas.openxmlformats.org/officeDocument/2006/relationships/image" Target="../media/image3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tiff"/><Relationship Id="rId2" Type="http://schemas.openxmlformats.org/officeDocument/2006/relationships/chart" Target="../charts/chart2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4" name="Graphique 133"/>
          <p:cNvGraphicFramePr>
            <a:graphicFrameLocks/>
          </p:cNvGraphicFramePr>
          <p:nvPr>
            <p:extLst/>
          </p:nvPr>
        </p:nvGraphicFramePr>
        <p:xfrm>
          <a:off x="3573691" y="2397280"/>
          <a:ext cx="1097542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4" name="Graphique 53"/>
          <p:cNvGraphicFramePr>
            <a:graphicFrameLocks/>
          </p:cNvGraphicFramePr>
          <p:nvPr>
            <p:extLst/>
          </p:nvPr>
        </p:nvGraphicFramePr>
        <p:xfrm>
          <a:off x="3410974" y="85366"/>
          <a:ext cx="1186536" cy="201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35" name="Groupe 34"/>
          <p:cNvGrpSpPr/>
          <p:nvPr/>
        </p:nvGrpSpPr>
        <p:grpSpPr>
          <a:xfrm>
            <a:off x="854857" y="741730"/>
            <a:ext cx="2451811" cy="956254"/>
            <a:chOff x="3716535" y="1978754"/>
            <a:chExt cx="2451447" cy="956112"/>
          </a:xfrm>
        </p:grpSpPr>
        <p:grpSp>
          <p:nvGrpSpPr>
            <p:cNvPr id="36" name="Groupe 35"/>
            <p:cNvGrpSpPr/>
            <p:nvPr/>
          </p:nvGrpSpPr>
          <p:grpSpPr>
            <a:xfrm>
              <a:off x="5785545" y="2459385"/>
              <a:ext cx="328433" cy="230832"/>
              <a:chOff x="5795070" y="2459385"/>
              <a:chExt cx="328433" cy="230832"/>
            </a:xfrm>
          </p:grpSpPr>
          <p:cxnSp>
            <p:nvCxnSpPr>
              <p:cNvPr id="52" name="Connecteur droit 51"/>
              <p:cNvCxnSpPr/>
              <p:nvPr/>
            </p:nvCxnSpPr>
            <p:spPr>
              <a:xfrm>
                <a:off x="5795070" y="2578405"/>
                <a:ext cx="7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ZoneTexte 52"/>
              <p:cNvSpPr txBox="1"/>
              <p:nvPr/>
            </p:nvSpPr>
            <p:spPr>
              <a:xfrm>
                <a:off x="5810597" y="2459385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2</a:t>
                </a:r>
              </a:p>
            </p:txBody>
          </p:sp>
        </p:grpSp>
        <p:grpSp>
          <p:nvGrpSpPr>
            <p:cNvPr id="37" name="Groupe 36"/>
            <p:cNvGrpSpPr/>
            <p:nvPr/>
          </p:nvGrpSpPr>
          <p:grpSpPr>
            <a:xfrm>
              <a:off x="3716535" y="1978754"/>
              <a:ext cx="2451447" cy="956112"/>
              <a:chOff x="3716535" y="1978754"/>
              <a:chExt cx="2451447" cy="956112"/>
            </a:xfrm>
          </p:grpSpPr>
          <p:grpSp>
            <p:nvGrpSpPr>
              <p:cNvPr id="38" name="Groupe 37"/>
              <p:cNvGrpSpPr/>
              <p:nvPr/>
            </p:nvGrpSpPr>
            <p:grpSpPr>
              <a:xfrm>
                <a:off x="3716535" y="1978754"/>
                <a:ext cx="2374907" cy="942299"/>
                <a:chOff x="2840045" y="168591"/>
                <a:chExt cx="2377761" cy="942299"/>
              </a:xfrm>
            </p:grpSpPr>
            <p:sp>
              <p:nvSpPr>
                <p:cNvPr id="45" name="ZoneTexte 115"/>
                <p:cNvSpPr txBox="1">
                  <a:spLocks noChangeArrowheads="1"/>
                </p:cNvSpPr>
                <p:nvPr/>
              </p:nvSpPr>
              <p:spPr bwMode="auto">
                <a:xfrm>
                  <a:off x="3748376" y="168591"/>
                  <a:ext cx="523296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latin typeface="Arial" charset="0"/>
                    </a:rPr>
                    <a:t>WT</a:t>
                  </a:r>
                </a:p>
              </p:txBody>
            </p:sp>
            <p:sp>
              <p:nvSpPr>
                <p:cNvPr id="46" name="ZoneTexte 3"/>
                <p:cNvSpPr txBox="1">
                  <a:spLocks noChangeArrowheads="1"/>
                </p:cNvSpPr>
                <p:nvPr/>
              </p:nvSpPr>
              <p:spPr bwMode="auto">
                <a:xfrm>
                  <a:off x="3091690" y="411686"/>
                  <a:ext cx="2126116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 err="1">
                      <a:latin typeface="Arial" charset="0"/>
                    </a:rPr>
                    <a:t>hypoxia</a:t>
                  </a:r>
                  <a:r>
                    <a:rPr lang="fr-FR" altLang="fr-FR" sz="900" b="1" dirty="0">
                      <a:latin typeface="Arial" charset="0"/>
                    </a:rPr>
                    <a:t>       -        +       -        +</a:t>
                  </a:r>
                </a:p>
              </p:txBody>
            </p:sp>
            <p:sp>
              <p:nvSpPr>
                <p:cNvPr id="47" name="ZoneTexte 117"/>
                <p:cNvSpPr txBox="1">
                  <a:spLocks noChangeArrowheads="1"/>
                </p:cNvSpPr>
                <p:nvPr/>
              </p:nvSpPr>
              <p:spPr bwMode="auto">
                <a:xfrm>
                  <a:off x="2840045" y="635316"/>
                  <a:ext cx="883115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>
                      <a:latin typeface="Arial" charset="0"/>
                    </a:rPr>
                    <a:t>p-AMPK</a:t>
                  </a:r>
                </a:p>
              </p:txBody>
            </p:sp>
            <p:sp>
              <p:nvSpPr>
                <p:cNvPr id="48" name="ZoneTexte 119"/>
                <p:cNvSpPr txBox="1">
                  <a:spLocks noChangeArrowheads="1"/>
                </p:cNvSpPr>
                <p:nvPr/>
              </p:nvSpPr>
              <p:spPr bwMode="auto">
                <a:xfrm>
                  <a:off x="2954345" y="880058"/>
                  <a:ext cx="768815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latin typeface="Arial" charset="0"/>
                    </a:rPr>
                    <a:t>AMPK</a:t>
                  </a:r>
                </a:p>
              </p:txBody>
            </p:sp>
            <p:cxnSp>
              <p:nvCxnSpPr>
                <p:cNvPr id="49" name="Connecteur droit 48"/>
                <p:cNvCxnSpPr/>
                <p:nvPr/>
              </p:nvCxnSpPr>
              <p:spPr>
                <a:xfrm>
                  <a:off x="3744523" y="406930"/>
                  <a:ext cx="51094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Connecteur droit 49"/>
                <p:cNvCxnSpPr/>
                <p:nvPr/>
              </p:nvCxnSpPr>
              <p:spPr>
                <a:xfrm>
                  <a:off x="4363069" y="406930"/>
                  <a:ext cx="50847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ZoneTexte 115"/>
                <p:cNvSpPr txBox="1">
                  <a:spLocks noChangeArrowheads="1"/>
                </p:cNvSpPr>
                <p:nvPr/>
              </p:nvSpPr>
              <p:spPr bwMode="auto">
                <a:xfrm>
                  <a:off x="4385972" y="168591"/>
                  <a:ext cx="518822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>
                      <a:latin typeface="Arial" charset="0"/>
                    </a:rPr>
                    <a:t>KO</a:t>
                  </a:r>
                </a:p>
              </p:txBody>
            </p:sp>
          </p:grpSp>
          <p:pic>
            <p:nvPicPr>
              <p:cNvPr id="39" name="Picture 2" descr="D:\Documents\redd1\hypoxie\western blot\photos\AMPK phospho.tiff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124" t="13243" r="25602" b="77297"/>
              <a:stretch/>
            </p:blipFill>
            <p:spPr bwMode="auto">
              <a:xfrm>
                <a:off x="4561545" y="2465498"/>
                <a:ext cx="1224000" cy="18771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0" name="Picture 3" descr="D:\Documents\redd1\hypoxie\western blot\photos\AMPK tot court.tiff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577" t="11733" r="29639" b="76043"/>
              <a:stretch/>
            </p:blipFill>
            <p:spPr bwMode="auto">
              <a:xfrm>
                <a:off x="4560685" y="2725691"/>
                <a:ext cx="1224000" cy="17894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41" name="Groupe 40"/>
              <p:cNvGrpSpPr/>
              <p:nvPr/>
            </p:nvGrpSpPr>
            <p:grpSpPr>
              <a:xfrm>
                <a:off x="5785545" y="2704034"/>
                <a:ext cx="328433" cy="230832"/>
                <a:chOff x="5805264" y="2684984"/>
                <a:chExt cx="328433" cy="230832"/>
              </a:xfrm>
            </p:grpSpPr>
            <p:cxnSp>
              <p:nvCxnSpPr>
                <p:cNvPr id="43" name="Connecteur droit 42"/>
                <p:cNvCxnSpPr/>
                <p:nvPr/>
              </p:nvCxnSpPr>
              <p:spPr>
                <a:xfrm>
                  <a:off x="5805264" y="2804004"/>
                  <a:ext cx="7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ZoneTexte 43"/>
                <p:cNvSpPr txBox="1"/>
                <p:nvPr/>
              </p:nvSpPr>
              <p:spPr>
                <a:xfrm>
                  <a:off x="5820791" y="2684984"/>
                  <a:ext cx="31290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2</a:t>
                  </a:r>
                </a:p>
              </p:txBody>
            </p:sp>
          </p:grpSp>
          <p:sp>
            <p:nvSpPr>
              <p:cNvPr id="42" name="Rectangle 41"/>
              <p:cNvSpPr/>
              <p:nvPr/>
            </p:nvSpPr>
            <p:spPr>
              <a:xfrm>
                <a:off x="5778132" y="2257909"/>
                <a:ext cx="389850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/>
                <a:r>
                  <a:rPr lang="fr-FR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</a:p>
            </p:txBody>
          </p:sp>
        </p:grpSp>
      </p:grpSp>
      <p:sp>
        <p:nvSpPr>
          <p:cNvPr id="29" name="ZoneTexte 3"/>
          <p:cNvSpPr txBox="1">
            <a:spLocks noChangeArrowheads="1"/>
          </p:cNvSpPr>
          <p:nvPr/>
        </p:nvSpPr>
        <p:spPr bwMode="auto">
          <a:xfrm>
            <a:off x="3266965" y="179698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 err="1">
                <a:latin typeface="Arial" charset="0"/>
              </a:rPr>
              <a:t>hypoxia</a:t>
            </a:r>
            <a:r>
              <a:rPr lang="fr-FR" altLang="fr-FR" sz="900" b="1" dirty="0">
                <a:latin typeface="Arial" charset="0"/>
              </a:rPr>
              <a:t>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  <p:sp>
        <p:nvSpPr>
          <p:cNvPr id="30" name="ZoneTexte 115"/>
          <p:cNvSpPr txBox="1">
            <a:spLocks noChangeArrowheads="1"/>
          </p:cNvSpPr>
          <p:nvPr/>
        </p:nvSpPr>
        <p:spPr bwMode="auto">
          <a:xfrm>
            <a:off x="3761401" y="2030839"/>
            <a:ext cx="693907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 </a:t>
            </a:r>
            <a:r>
              <a:rPr lang="fr-FR" altLang="fr-FR" sz="700" b="1" dirty="0">
                <a:latin typeface="Arial" charset="0"/>
              </a:rPr>
              <a:t>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31" name="Connecteur droit 30"/>
          <p:cNvCxnSpPr/>
          <p:nvPr/>
        </p:nvCxnSpPr>
        <p:spPr>
          <a:xfrm>
            <a:off x="3859416" y="2027834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/>
          <p:cNvCxnSpPr/>
          <p:nvPr/>
        </p:nvCxnSpPr>
        <p:spPr>
          <a:xfrm>
            <a:off x="4126153" y="2027834"/>
            <a:ext cx="218037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10"/>
          <p:cNvSpPr txBox="1"/>
          <p:nvPr/>
        </p:nvSpPr>
        <p:spPr>
          <a:xfrm rot="16200000">
            <a:off x="2801567" y="1083326"/>
            <a:ext cx="1212371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-to-total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9"/>
          <p:cNvSpPr txBox="1"/>
          <p:nvPr/>
        </p:nvSpPr>
        <p:spPr>
          <a:xfrm>
            <a:off x="3595485" y="361597"/>
            <a:ext cx="908018" cy="23984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AMPK T172</a:t>
            </a:r>
          </a:p>
        </p:txBody>
      </p:sp>
      <p:sp>
        <p:nvSpPr>
          <p:cNvPr id="55" name="ZoneTexte 115"/>
          <p:cNvSpPr txBox="1">
            <a:spLocks noChangeArrowheads="1"/>
          </p:cNvSpPr>
          <p:nvPr/>
        </p:nvSpPr>
        <p:spPr bwMode="auto">
          <a:xfrm>
            <a:off x="5544153" y="2018138"/>
            <a:ext cx="864396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</a:t>
            </a:r>
            <a:r>
              <a:rPr lang="fr-FR" altLang="fr-FR" sz="700" b="1" dirty="0">
                <a:latin typeface="Arial" charset="0"/>
              </a:rPr>
              <a:t>  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57" name="Connecteur droit 56"/>
          <p:cNvCxnSpPr/>
          <p:nvPr/>
        </p:nvCxnSpPr>
        <p:spPr>
          <a:xfrm>
            <a:off x="5604320" y="2024148"/>
            <a:ext cx="214528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57"/>
          <p:cNvCxnSpPr/>
          <p:nvPr/>
        </p:nvCxnSpPr>
        <p:spPr>
          <a:xfrm>
            <a:off x="5875568" y="2026158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87"/>
          <p:cNvSpPr txBox="1"/>
          <p:nvPr/>
        </p:nvSpPr>
        <p:spPr>
          <a:xfrm rot="16200000">
            <a:off x="4529329" y="994978"/>
            <a:ext cx="1321257" cy="230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mg/g</a:t>
            </a:r>
          </a:p>
        </p:txBody>
      </p:sp>
      <p:graphicFrame>
        <p:nvGraphicFramePr>
          <p:cNvPr id="60" name="Graphique 59"/>
          <p:cNvGraphicFramePr>
            <a:graphicFrameLocks/>
          </p:cNvGraphicFramePr>
          <p:nvPr>
            <p:extLst/>
          </p:nvPr>
        </p:nvGraphicFramePr>
        <p:xfrm>
          <a:off x="5250339" y="328196"/>
          <a:ext cx="1097542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61" name="ZoneTexte 8"/>
          <p:cNvSpPr txBox="1"/>
          <p:nvPr/>
        </p:nvSpPr>
        <p:spPr>
          <a:xfrm>
            <a:off x="5251727" y="364601"/>
            <a:ext cx="1244493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ycogen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content</a:t>
            </a:r>
          </a:p>
        </p:txBody>
      </p:sp>
      <p:grpSp>
        <p:nvGrpSpPr>
          <p:cNvPr id="65" name="Groupe 64"/>
          <p:cNvGrpSpPr/>
          <p:nvPr/>
        </p:nvGrpSpPr>
        <p:grpSpPr>
          <a:xfrm>
            <a:off x="-59243" y="4764521"/>
            <a:ext cx="3087178" cy="1418006"/>
            <a:chOff x="3370974" y="3150373"/>
            <a:chExt cx="3086720" cy="1417795"/>
          </a:xfrm>
        </p:grpSpPr>
        <p:grpSp>
          <p:nvGrpSpPr>
            <p:cNvPr id="66" name="Groupe 65"/>
            <p:cNvGrpSpPr/>
            <p:nvPr/>
          </p:nvGrpSpPr>
          <p:grpSpPr>
            <a:xfrm>
              <a:off x="3370974" y="3150373"/>
              <a:ext cx="3033446" cy="1417795"/>
              <a:chOff x="3370974" y="3150373"/>
              <a:chExt cx="3033446" cy="1417795"/>
            </a:xfrm>
          </p:grpSpPr>
          <p:grpSp>
            <p:nvGrpSpPr>
              <p:cNvPr id="68" name="Groupe 67"/>
              <p:cNvGrpSpPr/>
              <p:nvPr/>
            </p:nvGrpSpPr>
            <p:grpSpPr>
              <a:xfrm>
                <a:off x="3370974" y="3150373"/>
                <a:ext cx="2946529" cy="1417795"/>
                <a:chOff x="2494666" y="1426068"/>
                <a:chExt cx="2954427" cy="1417795"/>
              </a:xfrm>
            </p:grpSpPr>
            <p:pic>
              <p:nvPicPr>
                <p:cNvPr id="80" name="Picture 3" descr="D:\Documents\redd1\métabolisme\exercice\exo 90'\Photos\Phospho ULK série 1.tiff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35" t="1" b="-1"/>
                <a:stretch/>
              </p:blipFill>
              <p:spPr bwMode="auto">
                <a:xfrm>
                  <a:off x="3322764" y="2133119"/>
                  <a:ext cx="1180478" cy="1986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81" name="Picture 9" descr="D:\Documents\redd1\métabolisme\exercice\exo 90'\Photos\AMPK phospho long.tiff"/>
                <p:cNvPicPr>
                  <a:picLocks noChangeArrowheads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" r="4200" b="-1"/>
                <a:stretch/>
              </p:blipFill>
              <p:spPr bwMode="auto">
                <a:xfrm>
                  <a:off x="3331849" y="2382357"/>
                  <a:ext cx="1174797" cy="1873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82" name="Picture 10" descr="D:\Documents\redd1\métabolisme\exercice\exo 90'\Photos\AMPK tot long.tiff"/>
                <p:cNvPicPr>
                  <a:picLocks noChangeArrowheads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" r="3451" b="-1"/>
                <a:stretch/>
              </p:blipFill>
              <p:spPr bwMode="auto">
                <a:xfrm>
                  <a:off x="3322764" y="2639288"/>
                  <a:ext cx="1183882" cy="1873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83" name="ZoneTexte 110"/>
                <p:cNvSpPr txBox="1">
                  <a:spLocks noChangeArrowheads="1"/>
                </p:cNvSpPr>
                <p:nvPr/>
              </p:nvSpPr>
              <p:spPr bwMode="auto">
                <a:xfrm>
                  <a:off x="2674053" y="2108952"/>
                  <a:ext cx="701796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latin typeface="Arial" charset="0"/>
                    </a:rPr>
                    <a:t>REDD1</a:t>
                  </a:r>
                </a:p>
              </p:txBody>
            </p:sp>
            <p:pic>
              <p:nvPicPr>
                <p:cNvPr id="84" name="Picture 2" descr="D:\Documents\redd1\jeûne\photos\REDD1 + phospho AMPK.tiff"/>
                <p:cNvPicPr>
                  <a:picLocks noChangeAspect="1" noChangeArrowheads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5512" r="5656" b="16385"/>
                <a:stretch/>
              </p:blipFill>
              <p:spPr bwMode="auto">
                <a:xfrm>
                  <a:off x="4529717" y="2138371"/>
                  <a:ext cx="688118" cy="18811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85" name="Picture 3" descr="D:\Documents\redd1\jeûne\photos\REDD1 + phospho AMPK.tiff"/>
                <p:cNvPicPr>
                  <a:picLocks noChangeAspect="1" noChangeArrowheads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4283" r="5656" b="21432"/>
                <a:stretch/>
              </p:blipFill>
              <p:spPr bwMode="auto">
                <a:xfrm>
                  <a:off x="4529717" y="2369671"/>
                  <a:ext cx="688118" cy="2143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86" name="Picture 4" descr="D:\Documents\redd1\jeûne\photos\ampk tot + ACC tot.tiff"/>
                <p:cNvPicPr>
                  <a:picLocks noChangeAspect="1" noChangeArrowheads="1"/>
                </p:cNvPicPr>
                <p:nvPr/>
              </p:nvPicPr>
              <p:blipFill rotWithShape="1"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22" t="6875" r="5656" b="29633"/>
                <a:stretch/>
              </p:blipFill>
              <p:spPr bwMode="auto">
                <a:xfrm>
                  <a:off x="4529717" y="2639288"/>
                  <a:ext cx="688118" cy="1905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87" name="ZoneTexte 115"/>
                <p:cNvSpPr txBox="1">
                  <a:spLocks noChangeArrowheads="1"/>
                </p:cNvSpPr>
                <p:nvPr/>
              </p:nvSpPr>
              <p:spPr bwMode="auto">
                <a:xfrm>
                  <a:off x="3058372" y="1426068"/>
                  <a:ext cx="1727932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latin typeface="Arial" charset="0"/>
                    </a:rPr>
                    <a:t>WT             KO</a:t>
                  </a:r>
                </a:p>
              </p:txBody>
            </p:sp>
            <p:cxnSp>
              <p:nvCxnSpPr>
                <p:cNvPr id="88" name="Connecteur droit 87"/>
                <p:cNvCxnSpPr/>
                <p:nvPr/>
              </p:nvCxnSpPr>
              <p:spPr>
                <a:xfrm>
                  <a:off x="3367153" y="1658633"/>
                  <a:ext cx="5069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Connecteur droit 88"/>
                <p:cNvCxnSpPr/>
                <p:nvPr/>
              </p:nvCxnSpPr>
              <p:spPr>
                <a:xfrm>
                  <a:off x="3973610" y="1658633"/>
                  <a:ext cx="50326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0" name="ZoneTexte 3"/>
                <p:cNvSpPr txBox="1">
                  <a:spLocks noChangeArrowheads="1"/>
                </p:cNvSpPr>
                <p:nvPr/>
              </p:nvSpPr>
              <p:spPr bwMode="auto">
                <a:xfrm>
                  <a:off x="2650244" y="1658633"/>
                  <a:ext cx="773387" cy="40780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 err="1">
                      <a:latin typeface="Arial" charset="0"/>
                    </a:rPr>
                    <a:t>exercise</a:t>
                  </a:r>
                  <a:endParaRPr lang="fr-FR" altLang="fr-FR" sz="900" b="1" dirty="0">
                    <a:latin typeface="Arial" charset="0"/>
                  </a:endParaRPr>
                </a:p>
                <a:p>
                  <a:pPr algn="r">
                    <a:spcBef>
                      <a:spcPts val="300"/>
                    </a:spcBef>
                  </a:pPr>
                  <a:r>
                    <a:rPr lang="fr-FR" altLang="fr-FR" sz="900" b="1" dirty="0" err="1">
                      <a:latin typeface="Arial" charset="0"/>
                    </a:rPr>
                    <a:t>fasting</a:t>
                  </a:r>
                  <a:endParaRPr lang="fr-FR" altLang="fr-FR" sz="900" b="1" dirty="0">
                    <a:latin typeface="Arial" charset="0"/>
                  </a:endParaRPr>
                </a:p>
              </p:txBody>
            </p:sp>
            <p:sp>
              <p:nvSpPr>
                <p:cNvPr id="91" name="ZoneTexte 3"/>
                <p:cNvSpPr txBox="1">
                  <a:spLocks noChangeArrowheads="1"/>
                </p:cNvSpPr>
                <p:nvPr/>
              </p:nvSpPr>
              <p:spPr bwMode="auto">
                <a:xfrm>
                  <a:off x="3329994" y="1660009"/>
                  <a:ext cx="2119099" cy="4693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1050" b="1" dirty="0">
                      <a:latin typeface="Arial" charset="0"/>
                    </a:rPr>
                    <a:t> -       +      -      +</a:t>
                  </a:r>
                </a:p>
                <a:p>
                  <a:pPr>
                    <a:spcBef>
                      <a:spcPts val="300"/>
                    </a:spcBef>
                  </a:pPr>
                  <a:r>
                    <a:rPr lang="fr-FR" altLang="fr-FR" sz="1050" b="1" dirty="0">
                      <a:latin typeface="Arial" charset="0"/>
                    </a:rPr>
                    <a:t> -       -       -      -       +        +</a:t>
                  </a:r>
                </a:p>
              </p:txBody>
            </p:sp>
            <p:sp>
              <p:nvSpPr>
                <p:cNvPr id="92" name="ZoneTexte 115"/>
                <p:cNvSpPr txBox="1">
                  <a:spLocks noChangeArrowheads="1"/>
                </p:cNvSpPr>
                <p:nvPr/>
              </p:nvSpPr>
              <p:spPr bwMode="auto">
                <a:xfrm>
                  <a:off x="4476878" y="1426068"/>
                  <a:ext cx="819609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latin typeface="Arial" charset="0"/>
                    </a:rPr>
                    <a:t>WT      KO</a:t>
                  </a:r>
                </a:p>
              </p:txBody>
            </p:sp>
            <p:cxnSp>
              <p:nvCxnSpPr>
                <p:cNvPr id="93" name="Connecteur droit 92"/>
                <p:cNvCxnSpPr/>
                <p:nvPr/>
              </p:nvCxnSpPr>
              <p:spPr>
                <a:xfrm>
                  <a:off x="4553531" y="1658633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Connecteur droit 93"/>
                <p:cNvCxnSpPr/>
                <p:nvPr/>
              </p:nvCxnSpPr>
              <p:spPr>
                <a:xfrm>
                  <a:off x="4928779" y="1658633"/>
                  <a:ext cx="29166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5" name="ZoneTexte 117"/>
                <p:cNvSpPr txBox="1">
                  <a:spLocks noChangeArrowheads="1"/>
                </p:cNvSpPr>
                <p:nvPr/>
              </p:nvSpPr>
              <p:spPr bwMode="auto">
                <a:xfrm>
                  <a:off x="2494666" y="2357944"/>
                  <a:ext cx="881184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latin typeface="Arial" charset="0"/>
                    </a:rPr>
                    <a:t>p-AMPK</a:t>
                  </a:r>
                </a:p>
              </p:txBody>
            </p:sp>
            <p:sp>
              <p:nvSpPr>
                <p:cNvPr id="96" name="ZoneTexte 119"/>
                <p:cNvSpPr txBox="1">
                  <a:spLocks noChangeArrowheads="1"/>
                </p:cNvSpPr>
                <p:nvPr/>
              </p:nvSpPr>
              <p:spPr bwMode="auto">
                <a:xfrm>
                  <a:off x="2608966" y="2613031"/>
                  <a:ext cx="766884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latin typeface="Arial" charset="0"/>
                    </a:rPr>
                    <a:t>AMPK</a:t>
                  </a:r>
                </a:p>
              </p:txBody>
            </p:sp>
          </p:grpSp>
          <p:sp>
            <p:nvSpPr>
              <p:cNvPr id="69" name="ZoneTexte 68"/>
              <p:cNvSpPr txBox="1"/>
              <p:nvPr/>
            </p:nvSpPr>
            <p:spPr>
              <a:xfrm>
                <a:off x="5387099" y="3381980"/>
                <a:ext cx="288701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0" name="ZoneTexte 69"/>
              <p:cNvSpPr txBox="1"/>
              <p:nvPr/>
            </p:nvSpPr>
            <p:spPr>
              <a:xfrm>
                <a:off x="5763320" y="3381980"/>
                <a:ext cx="288701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grpSp>
            <p:nvGrpSpPr>
              <p:cNvPr id="71" name="Groupe 70"/>
              <p:cNvGrpSpPr/>
              <p:nvPr/>
            </p:nvGrpSpPr>
            <p:grpSpPr>
              <a:xfrm>
                <a:off x="6075987" y="4084908"/>
                <a:ext cx="328433" cy="230832"/>
                <a:chOff x="5763066" y="2684984"/>
                <a:chExt cx="328433" cy="230832"/>
              </a:xfrm>
            </p:grpSpPr>
            <p:cxnSp>
              <p:nvCxnSpPr>
                <p:cNvPr id="78" name="Connecteur droit 77"/>
                <p:cNvCxnSpPr/>
                <p:nvPr/>
              </p:nvCxnSpPr>
              <p:spPr>
                <a:xfrm>
                  <a:off x="5763066" y="2804004"/>
                  <a:ext cx="7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" name="ZoneTexte 78"/>
                <p:cNvSpPr txBox="1"/>
                <p:nvPr/>
              </p:nvSpPr>
              <p:spPr>
                <a:xfrm>
                  <a:off x="5778593" y="2684984"/>
                  <a:ext cx="31290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2</a:t>
                  </a:r>
                </a:p>
              </p:txBody>
            </p:sp>
          </p:grpSp>
          <p:grpSp>
            <p:nvGrpSpPr>
              <p:cNvPr id="72" name="Groupe 71"/>
              <p:cNvGrpSpPr/>
              <p:nvPr/>
            </p:nvGrpSpPr>
            <p:grpSpPr>
              <a:xfrm>
                <a:off x="6071009" y="4332558"/>
                <a:ext cx="328433" cy="230832"/>
                <a:chOff x="5763066" y="2684984"/>
                <a:chExt cx="328433" cy="230832"/>
              </a:xfrm>
            </p:grpSpPr>
            <p:cxnSp>
              <p:nvCxnSpPr>
                <p:cNvPr id="76" name="Connecteur droit 75"/>
                <p:cNvCxnSpPr/>
                <p:nvPr/>
              </p:nvCxnSpPr>
              <p:spPr>
                <a:xfrm>
                  <a:off x="5763066" y="2804004"/>
                  <a:ext cx="7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ZoneTexte 76"/>
                <p:cNvSpPr txBox="1"/>
                <p:nvPr/>
              </p:nvSpPr>
              <p:spPr>
                <a:xfrm>
                  <a:off x="5778593" y="2684984"/>
                  <a:ext cx="31290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2</a:t>
                  </a:r>
                </a:p>
              </p:txBody>
            </p:sp>
          </p:grpSp>
          <p:grpSp>
            <p:nvGrpSpPr>
              <p:cNvPr id="73" name="Groupe 72"/>
              <p:cNvGrpSpPr/>
              <p:nvPr/>
            </p:nvGrpSpPr>
            <p:grpSpPr>
              <a:xfrm>
                <a:off x="6072008" y="3834534"/>
                <a:ext cx="328433" cy="230832"/>
                <a:chOff x="5763066" y="2684984"/>
                <a:chExt cx="328433" cy="230832"/>
              </a:xfrm>
            </p:grpSpPr>
            <p:cxnSp>
              <p:nvCxnSpPr>
                <p:cNvPr id="74" name="Connecteur droit 73"/>
                <p:cNvCxnSpPr/>
                <p:nvPr/>
              </p:nvCxnSpPr>
              <p:spPr>
                <a:xfrm>
                  <a:off x="5763066" y="2804004"/>
                  <a:ext cx="7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ZoneTexte 74"/>
                <p:cNvSpPr txBox="1"/>
                <p:nvPr/>
              </p:nvSpPr>
              <p:spPr>
                <a:xfrm>
                  <a:off x="5778593" y="2684984"/>
                  <a:ext cx="31290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2</a:t>
                  </a:r>
                </a:p>
              </p:txBody>
            </p:sp>
          </p:grpSp>
        </p:grpSp>
        <p:sp>
          <p:nvSpPr>
            <p:cNvPr id="67" name="Rectangle 66"/>
            <p:cNvSpPr/>
            <p:nvPr/>
          </p:nvSpPr>
          <p:spPr>
            <a:xfrm>
              <a:off x="6067844" y="3648710"/>
              <a:ext cx="38985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fr-F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</p:grpSp>
      <p:graphicFrame>
        <p:nvGraphicFramePr>
          <p:cNvPr id="106" name="Graphique 105"/>
          <p:cNvGraphicFramePr>
            <a:graphicFrameLocks/>
          </p:cNvGraphicFramePr>
          <p:nvPr>
            <p:extLst/>
          </p:nvPr>
        </p:nvGraphicFramePr>
        <p:xfrm>
          <a:off x="1731950" y="6758365"/>
          <a:ext cx="1097542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07" name="Graphique 106"/>
          <p:cNvGraphicFramePr>
            <a:graphicFrameLocks/>
          </p:cNvGraphicFramePr>
          <p:nvPr>
            <p:extLst/>
          </p:nvPr>
        </p:nvGraphicFramePr>
        <p:xfrm>
          <a:off x="3268878" y="6758365"/>
          <a:ext cx="1097542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08" name="Graphique 107"/>
          <p:cNvGraphicFramePr>
            <a:graphicFrameLocks/>
          </p:cNvGraphicFramePr>
          <p:nvPr>
            <p:extLst/>
          </p:nvPr>
        </p:nvGraphicFramePr>
        <p:xfrm>
          <a:off x="4856614" y="6758365"/>
          <a:ext cx="1097542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109" name="ZoneTexte 3"/>
          <p:cNvSpPr txBox="1">
            <a:spLocks noChangeArrowheads="1"/>
          </p:cNvSpPr>
          <p:nvPr/>
        </p:nvSpPr>
        <p:spPr bwMode="auto">
          <a:xfrm>
            <a:off x="1539678" y="819651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 </a:t>
            </a:r>
            <a:r>
              <a:rPr lang="fr-FR" altLang="fr-FR" sz="900" b="1" dirty="0" err="1">
                <a:latin typeface="Arial" charset="0"/>
              </a:rPr>
              <a:t>fasting</a:t>
            </a:r>
            <a:r>
              <a:rPr lang="fr-FR" altLang="fr-FR" sz="9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  <p:sp>
        <p:nvSpPr>
          <p:cNvPr id="110" name="ZoneTexte 115"/>
          <p:cNvSpPr txBox="1">
            <a:spLocks noChangeArrowheads="1"/>
          </p:cNvSpPr>
          <p:nvPr/>
        </p:nvSpPr>
        <p:spPr bwMode="auto">
          <a:xfrm>
            <a:off x="2034114" y="8417667"/>
            <a:ext cx="693907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 </a:t>
            </a:r>
            <a:r>
              <a:rPr lang="fr-FR" altLang="fr-FR" sz="700" b="1" dirty="0">
                <a:latin typeface="Arial" charset="0"/>
              </a:rPr>
              <a:t>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111" name="Connecteur droit 110"/>
          <p:cNvCxnSpPr/>
          <p:nvPr/>
        </p:nvCxnSpPr>
        <p:spPr>
          <a:xfrm>
            <a:off x="2142172" y="8417667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Connecteur droit 111"/>
          <p:cNvCxnSpPr/>
          <p:nvPr/>
        </p:nvCxnSpPr>
        <p:spPr>
          <a:xfrm>
            <a:off x="2408909" y="8417667"/>
            <a:ext cx="218037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ZoneTexte 3"/>
          <p:cNvSpPr txBox="1">
            <a:spLocks noChangeArrowheads="1"/>
          </p:cNvSpPr>
          <p:nvPr/>
        </p:nvSpPr>
        <p:spPr bwMode="auto">
          <a:xfrm>
            <a:off x="3150912" y="819651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 </a:t>
            </a:r>
            <a:r>
              <a:rPr lang="fr-FR" altLang="fr-FR" sz="900" b="1" dirty="0" err="1">
                <a:latin typeface="Arial" charset="0"/>
              </a:rPr>
              <a:t>fasting</a:t>
            </a:r>
            <a:r>
              <a:rPr lang="fr-FR" altLang="fr-FR" sz="9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  <p:sp>
        <p:nvSpPr>
          <p:cNvPr id="114" name="ZoneTexte 115"/>
          <p:cNvSpPr txBox="1">
            <a:spLocks noChangeArrowheads="1"/>
          </p:cNvSpPr>
          <p:nvPr/>
        </p:nvSpPr>
        <p:spPr bwMode="auto">
          <a:xfrm>
            <a:off x="3645348" y="8417667"/>
            <a:ext cx="693907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 </a:t>
            </a:r>
            <a:r>
              <a:rPr lang="fr-FR" altLang="fr-FR" sz="700" b="1" dirty="0">
                <a:latin typeface="Arial" charset="0"/>
              </a:rPr>
              <a:t>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115" name="Connecteur droit 114"/>
          <p:cNvCxnSpPr/>
          <p:nvPr/>
        </p:nvCxnSpPr>
        <p:spPr>
          <a:xfrm>
            <a:off x="3753406" y="8417667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cteur droit 115"/>
          <p:cNvCxnSpPr/>
          <p:nvPr/>
        </p:nvCxnSpPr>
        <p:spPr>
          <a:xfrm>
            <a:off x="4020143" y="8417667"/>
            <a:ext cx="218037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ZoneTexte 3"/>
          <p:cNvSpPr txBox="1">
            <a:spLocks noChangeArrowheads="1"/>
          </p:cNvSpPr>
          <p:nvPr/>
        </p:nvSpPr>
        <p:spPr bwMode="auto">
          <a:xfrm>
            <a:off x="4729121" y="819651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 </a:t>
            </a:r>
            <a:r>
              <a:rPr lang="fr-FR" altLang="fr-FR" sz="900" b="1" dirty="0" err="1">
                <a:latin typeface="Arial" charset="0"/>
              </a:rPr>
              <a:t>fasting</a:t>
            </a:r>
            <a:r>
              <a:rPr lang="fr-FR" altLang="fr-FR" sz="9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  <p:sp>
        <p:nvSpPr>
          <p:cNvPr id="118" name="ZoneTexte 115"/>
          <p:cNvSpPr txBox="1">
            <a:spLocks noChangeArrowheads="1"/>
          </p:cNvSpPr>
          <p:nvPr/>
        </p:nvSpPr>
        <p:spPr bwMode="auto">
          <a:xfrm>
            <a:off x="5223557" y="8417667"/>
            <a:ext cx="693907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 </a:t>
            </a:r>
            <a:r>
              <a:rPr lang="fr-FR" altLang="fr-FR" sz="700" b="1" dirty="0">
                <a:latin typeface="Arial" charset="0"/>
              </a:rPr>
              <a:t>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119" name="Connecteur droit 118"/>
          <p:cNvCxnSpPr/>
          <p:nvPr/>
        </p:nvCxnSpPr>
        <p:spPr>
          <a:xfrm>
            <a:off x="5331615" y="8417667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Connecteur droit 119"/>
          <p:cNvCxnSpPr/>
          <p:nvPr/>
        </p:nvCxnSpPr>
        <p:spPr>
          <a:xfrm>
            <a:off x="5598353" y="8417667"/>
            <a:ext cx="218037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ZoneTexte 9"/>
          <p:cNvSpPr txBox="1"/>
          <p:nvPr/>
        </p:nvSpPr>
        <p:spPr>
          <a:xfrm>
            <a:off x="2001371" y="6777548"/>
            <a:ext cx="648439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</a:p>
        </p:txBody>
      </p:sp>
      <p:sp>
        <p:nvSpPr>
          <p:cNvPr id="125" name="ZoneTexte 9"/>
          <p:cNvSpPr txBox="1"/>
          <p:nvPr/>
        </p:nvSpPr>
        <p:spPr>
          <a:xfrm>
            <a:off x="3573690" y="6777548"/>
            <a:ext cx="765565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</a:p>
        </p:txBody>
      </p:sp>
      <p:sp>
        <p:nvSpPr>
          <p:cNvPr id="126" name="ZoneTexte 9"/>
          <p:cNvSpPr txBox="1"/>
          <p:nvPr/>
        </p:nvSpPr>
        <p:spPr>
          <a:xfrm>
            <a:off x="5179550" y="6777548"/>
            <a:ext cx="737914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fat mass</a:t>
            </a:r>
          </a:p>
        </p:txBody>
      </p:sp>
      <p:sp>
        <p:nvSpPr>
          <p:cNvPr id="127" name="ZoneTexte 126"/>
          <p:cNvSpPr txBox="1"/>
          <p:nvPr/>
        </p:nvSpPr>
        <p:spPr>
          <a:xfrm>
            <a:off x="999053" y="136328"/>
            <a:ext cx="255236" cy="246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4977919" y="136328"/>
            <a:ext cx="263253" cy="246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1307074" y="2384562"/>
            <a:ext cx="255236" cy="246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ZoneTexte 129"/>
          <p:cNvSpPr txBox="1"/>
          <p:nvPr/>
        </p:nvSpPr>
        <p:spPr>
          <a:xfrm>
            <a:off x="174777" y="4481959"/>
            <a:ext cx="263253" cy="246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2" name="Graphique 131"/>
          <p:cNvGraphicFramePr>
            <a:graphicFrameLocks/>
          </p:cNvGraphicFramePr>
          <p:nvPr>
            <p:extLst/>
          </p:nvPr>
        </p:nvGraphicFramePr>
        <p:xfrm>
          <a:off x="1836708" y="2397280"/>
          <a:ext cx="1097542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133" name="Graphique 132"/>
          <p:cNvGraphicFramePr>
            <a:graphicFrameLocks/>
          </p:cNvGraphicFramePr>
          <p:nvPr>
            <p:extLst/>
          </p:nvPr>
        </p:nvGraphicFramePr>
        <p:xfrm>
          <a:off x="5199532" y="2397280"/>
          <a:ext cx="1097542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135" name="ZoneTexte 87"/>
          <p:cNvSpPr txBox="1"/>
          <p:nvPr/>
        </p:nvSpPr>
        <p:spPr>
          <a:xfrm rot="16200000">
            <a:off x="1141756" y="3135666"/>
            <a:ext cx="1087184" cy="3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muscle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(mg)</a:t>
            </a:r>
          </a:p>
        </p:txBody>
      </p:sp>
      <p:sp>
        <p:nvSpPr>
          <p:cNvPr id="137" name="ZoneTexte 87"/>
          <p:cNvSpPr txBox="1"/>
          <p:nvPr/>
        </p:nvSpPr>
        <p:spPr>
          <a:xfrm rot="16200000">
            <a:off x="4574441" y="3135666"/>
            <a:ext cx="1087184" cy="3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muscle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(mg)</a:t>
            </a:r>
          </a:p>
        </p:txBody>
      </p:sp>
      <p:sp>
        <p:nvSpPr>
          <p:cNvPr id="138" name="ZoneTexte 3"/>
          <p:cNvSpPr txBox="1">
            <a:spLocks noChangeArrowheads="1"/>
          </p:cNvSpPr>
          <p:nvPr/>
        </p:nvSpPr>
        <p:spPr bwMode="auto">
          <a:xfrm>
            <a:off x="1643832" y="384304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 err="1">
                <a:latin typeface="Arial" charset="0"/>
              </a:rPr>
              <a:t>hypoxia</a:t>
            </a:r>
            <a:r>
              <a:rPr lang="fr-FR" altLang="fr-FR" sz="900" b="1" dirty="0">
                <a:latin typeface="Arial" charset="0"/>
              </a:rPr>
              <a:t>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  <p:sp>
        <p:nvSpPr>
          <p:cNvPr id="139" name="ZoneTexte 115"/>
          <p:cNvSpPr txBox="1">
            <a:spLocks noChangeArrowheads="1"/>
          </p:cNvSpPr>
          <p:nvPr/>
        </p:nvSpPr>
        <p:spPr bwMode="auto">
          <a:xfrm>
            <a:off x="2138268" y="4064197"/>
            <a:ext cx="693907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 </a:t>
            </a:r>
            <a:r>
              <a:rPr lang="fr-FR" altLang="fr-FR" sz="700" b="1" dirty="0">
                <a:latin typeface="Arial" charset="0"/>
              </a:rPr>
              <a:t>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140" name="Connecteur droit 139"/>
          <p:cNvCxnSpPr/>
          <p:nvPr/>
        </p:nvCxnSpPr>
        <p:spPr>
          <a:xfrm>
            <a:off x="2236283" y="4061192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Connecteur droit 140"/>
          <p:cNvCxnSpPr/>
          <p:nvPr/>
        </p:nvCxnSpPr>
        <p:spPr>
          <a:xfrm>
            <a:off x="2503020" y="4061192"/>
            <a:ext cx="218037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ZoneTexte 3"/>
          <p:cNvSpPr txBox="1">
            <a:spLocks noChangeArrowheads="1"/>
          </p:cNvSpPr>
          <p:nvPr/>
        </p:nvSpPr>
        <p:spPr bwMode="auto">
          <a:xfrm>
            <a:off x="3447286" y="385534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 err="1">
                <a:latin typeface="Arial" charset="0"/>
              </a:rPr>
              <a:t>hypoxia</a:t>
            </a:r>
            <a:r>
              <a:rPr lang="fr-FR" altLang="fr-FR" sz="900" b="1" dirty="0">
                <a:latin typeface="Arial" charset="0"/>
              </a:rPr>
              <a:t>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  <p:sp>
        <p:nvSpPr>
          <p:cNvPr id="143" name="ZoneTexte 115"/>
          <p:cNvSpPr txBox="1">
            <a:spLocks noChangeArrowheads="1"/>
          </p:cNvSpPr>
          <p:nvPr/>
        </p:nvSpPr>
        <p:spPr bwMode="auto">
          <a:xfrm>
            <a:off x="3941722" y="4076498"/>
            <a:ext cx="693907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 </a:t>
            </a:r>
            <a:r>
              <a:rPr lang="fr-FR" altLang="fr-FR" sz="700" b="1" dirty="0">
                <a:latin typeface="Arial" charset="0"/>
              </a:rPr>
              <a:t>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144" name="Connecteur droit 143"/>
          <p:cNvCxnSpPr/>
          <p:nvPr/>
        </p:nvCxnSpPr>
        <p:spPr>
          <a:xfrm>
            <a:off x="4039737" y="4073493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Connecteur droit 144"/>
          <p:cNvCxnSpPr/>
          <p:nvPr/>
        </p:nvCxnSpPr>
        <p:spPr>
          <a:xfrm>
            <a:off x="4306474" y="4073493"/>
            <a:ext cx="218037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ZoneTexte 3"/>
          <p:cNvSpPr txBox="1">
            <a:spLocks noChangeArrowheads="1"/>
          </p:cNvSpPr>
          <p:nvPr/>
        </p:nvSpPr>
        <p:spPr bwMode="auto">
          <a:xfrm>
            <a:off x="5013735" y="384304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 err="1">
                <a:latin typeface="Arial" charset="0"/>
              </a:rPr>
              <a:t>hypoxia</a:t>
            </a:r>
            <a:r>
              <a:rPr lang="fr-FR" altLang="fr-FR" sz="900" b="1" dirty="0">
                <a:latin typeface="Arial" charset="0"/>
              </a:rPr>
              <a:t>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  <p:sp>
        <p:nvSpPr>
          <p:cNvPr id="147" name="ZoneTexte 115"/>
          <p:cNvSpPr txBox="1">
            <a:spLocks noChangeArrowheads="1"/>
          </p:cNvSpPr>
          <p:nvPr/>
        </p:nvSpPr>
        <p:spPr bwMode="auto">
          <a:xfrm>
            <a:off x="5508171" y="4064197"/>
            <a:ext cx="693907" cy="230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>
                <a:latin typeface="Arial" charset="0"/>
              </a:rPr>
              <a:t>WT </a:t>
            </a:r>
            <a:r>
              <a:rPr lang="fr-FR" altLang="fr-FR" sz="700" b="1" dirty="0">
                <a:latin typeface="Arial" charset="0"/>
              </a:rPr>
              <a:t>  </a:t>
            </a:r>
            <a:r>
              <a:rPr lang="fr-FR" altLang="fr-FR" sz="900" b="1" dirty="0">
                <a:latin typeface="Arial" charset="0"/>
              </a:rPr>
              <a:t>KO</a:t>
            </a:r>
          </a:p>
        </p:txBody>
      </p:sp>
      <p:cxnSp>
        <p:nvCxnSpPr>
          <p:cNvPr id="148" name="Connecteur droit 147"/>
          <p:cNvCxnSpPr/>
          <p:nvPr/>
        </p:nvCxnSpPr>
        <p:spPr>
          <a:xfrm>
            <a:off x="5606186" y="4061192"/>
            <a:ext cx="216032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necteur droit 148"/>
          <p:cNvCxnSpPr/>
          <p:nvPr/>
        </p:nvCxnSpPr>
        <p:spPr>
          <a:xfrm>
            <a:off x="5872923" y="4061192"/>
            <a:ext cx="218037" cy="0"/>
          </a:xfrm>
          <a:prstGeom prst="line">
            <a:avLst/>
          </a:prstGeom>
          <a:ln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ZoneTexte 1"/>
          <p:cNvSpPr txBox="1"/>
          <p:nvPr/>
        </p:nvSpPr>
        <p:spPr>
          <a:xfrm>
            <a:off x="4326317" y="2759419"/>
            <a:ext cx="328593" cy="65855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ZoneTexte 1"/>
          <p:cNvSpPr txBox="1"/>
          <p:nvPr/>
        </p:nvSpPr>
        <p:spPr>
          <a:xfrm>
            <a:off x="2513666" y="2627132"/>
            <a:ext cx="349775" cy="60985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ZoneTexte 1"/>
          <p:cNvSpPr txBox="1"/>
          <p:nvPr/>
        </p:nvSpPr>
        <p:spPr>
          <a:xfrm>
            <a:off x="5867182" y="2857378"/>
            <a:ext cx="349775" cy="14888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$ </a:t>
            </a:r>
            <a:endParaRPr lang="fr-FR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ZoneTexte 1"/>
          <p:cNvSpPr txBox="1"/>
          <p:nvPr/>
        </p:nvSpPr>
        <p:spPr>
          <a:xfrm>
            <a:off x="4012153" y="7292752"/>
            <a:ext cx="3497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 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ZoneTexte 1"/>
          <p:cNvSpPr txBox="1"/>
          <p:nvPr/>
        </p:nvSpPr>
        <p:spPr>
          <a:xfrm>
            <a:off x="2404416" y="7237053"/>
            <a:ext cx="3497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ZoneTexte 1"/>
          <p:cNvSpPr txBox="1"/>
          <p:nvPr/>
        </p:nvSpPr>
        <p:spPr>
          <a:xfrm rot="16200000">
            <a:off x="5530226" y="7720611"/>
            <a:ext cx="666526" cy="38320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$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ZoneTexte 1"/>
          <p:cNvSpPr txBox="1"/>
          <p:nvPr/>
        </p:nvSpPr>
        <p:spPr>
          <a:xfrm rot="16200000">
            <a:off x="5184683" y="7730897"/>
            <a:ext cx="641232" cy="22668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$ 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ZoneTexte 1"/>
          <p:cNvSpPr txBox="1"/>
          <p:nvPr/>
        </p:nvSpPr>
        <p:spPr>
          <a:xfrm>
            <a:off x="5446490" y="6986105"/>
            <a:ext cx="369900" cy="12322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ZoneTexte 159"/>
          <p:cNvSpPr txBox="1"/>
          <p:nvPr/>
        </p:nvSpPr>
        <p:spPr>
          <a:xfrm>
            <a:off x="1494362" y="6666192"/>
            <a:ext cx="227982" cy="246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ZoneTexte 9"/>
          <p:cNvSpPr txBox="1"/>
          <p:nvPr/>
        </p:nvSpPr>
        <p:spPr>
          <a:xfrm>
            <a:off x="2172467" y="2455903"/>
            <a:ext cx="570511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</a:p>
        </p:txBody>
      </p:sp>
      <p:sp>
        <p:nvSpPr>
          <p:cNvPr id="162" name="ZoneTexte 9"/>
          <p:cNvSpPr txBox="1"/>
          <p:nvPr/>
        </p:nvSpPr>
        <p:spPr>
          <a:xfrm>
            <a:off x="3983756" y="2455903"/>
            <a:ext cx="570511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GAS</a:t>
            </a:r>
          </a:p>
        </p:txBody>
      </p:sp>
      <p:sp>
        <p:nvSpPr>
          <p:cNvPr id="163" name="ZoneTexte 9"/>
          <p:cNvSpPr txBox="1"/>
          <p:nvPr/>
        </p:nvSpPr>
        <p:spPr>
          <a:xfrm>
            <a:off x="5561438" y="2455903"/>
            <a:ext cx="570511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SOL</a:t>
            </a:r>
          </a:p>
        </p:txBody>
      </p:sp>
      <p:graphicFrame>
        <p:nvGraphicFramePr>
          <p:cNvPr id="131" name="Graphique 130"/>
          <p:cNvGraphicFramePr>
            <a:graphicFrameLocks/>
          </p:cNvGraphicFramePr>
          <p:nvPr>
            <p:extLst/>
          </p:nvPr>
        </p:nvGraphicFramePr>
        <p:xfrm>
          <a:off x="5316295" y="4586186"/>
          <a:ext cx="1980196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168" name="ZoneTexte 87"/>
          <p:cNvSpPr txBox="1"/>
          <p:nvPr/>
        </p:nvSpPr>
        <p:spPr>
          <a:xfrm rot="16200000">
            <a:off x="4846904" y="5391562"/>
            <a:ext cx="1062063" cy="230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mg/g</a:t>
            </a:r>
          </a:p>
        </p:txBody>
      </p:sp>
      <p:sp>
        <p:nvSpPr>
          <p:cNvPr id="169" name="ZoneTexte 8"/>
          <p:cNvSpPr txBox="1"/>
          <p:nvPr/>
        </p:nvSpPr>
        <p:spPr>
          <a:xfrm>
            <a:off x="5686196" y="4553540"/>
            <a:ext cx="1366733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ycogen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content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5170795" y="6028623"/>
            <a:ext cx="2237812" cy="580744"/>
            <a:chOff x="5030095" y="6511121"/>
            <a:chExt cx="2237480" cy="580658"/>
          </a:xfrm>
        </p:grpSpPr>
        <p:sp>
          <p:nvSpPr>
            <p:cNvPr id="170" name="ZoneTexte 3"/>
            <p:cNvSpPr txBox="1">
              <a:spLocks noChangeArrowheads="1"/>
            </p:cNvSpPr>
            <p:nvPr/>
          </p:nvSpPr>
          <p:spPr bwMode="auto">
            <a:xfrm>
              <a:off x="5044672" y="6511121"/>
              <a:ext cx="2222903" cy="247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900" b="1" dirty="0" err="1">
                  <a:latin typeface="Arial" charset="0"/>
                </a:rPr>
                <a:t>exercise</a:t>
              </a:r>
              <a:r>
                <a:rPr lang="fr-FR" altLang="fr-FR" sz="900" b="1" dirty="0">
                  <a:latin typeface="Arial" charset="0"/>
                </a:rPr>
                <a:t>     </a:t>
              </a:r>
              <a:r>
                <a:rPr lang="fr-FR" altLang="fr-FR" sz="1000" b="1" dirty="0">
                  <a:latin typeface="Arial" charset="0"/>
                </a:rPr>
                <a:t>-   +</a:t>
              </a:r>
              <a:r>
                <a:rPr lang="fr-FR" altLang="fr-FR" sz="600" b="1" dirty="0">
                  <a:latin typeface="Arial" charset="0"/>
                </a:rPr>
                <a:t>    </a:t>
              </a:r>
              <a:r>
                <a:rPr lang="fr-FR" altLang="fr-FR" sz="1000" b="1" dirty="0">
                  <a:latin typeface="Arial" charset="0"/>
                </a:rPr>
                <a:t>-     </a:t>
              </a:r>
              <a:r>
                <a:rPr lang="fr-FR" altLang="fr-FR" sz="900" b="1" dirty="0">
                  <a:latin typeface="Arial" charset="0"/>
                </a:rPr>
                <a:t> 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+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-</a:t>
              </a:r>
            </a:p>
          </p:txBody>
        </p:sp>
        <p:sp>
          <p:nvSpPr>
            <p:cNvPr id="171" name="ZoneTexte 115"/>
            <p:cNvSpPr txBox="1">
              <a:spLocks noChangeArrowheads="1"/>
            </p:cNvSpPr>
            <p:nvPr/>
          </p:nvSpPr>
          <p:spPr bwMode="auto">
            <a:xfrm>
              <a:off x="5706517" y="6860947"/>
              <a:ext cx="110407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900" b="1" dirty="0">
                  <a:latin typeface="Arial" charset="0"/>
                </a:rPr>
                <a:t>WT              </a:t>
              </a:r>
              <a:r>
                <a:rPr lang="fr-FR" altLang="fr-FR" sz="700" b="1" dirty="0">
                  <a:latin typeface="Arial" charset="0"/>
                </a:rPr>
                <a:t>  </a:t>
              </a:r>
              <a:r>
                <a:rPr lang="fr-FR" altLang="fr-FR" sz="900" b="1" dirty="0">
                  <a:latin typeface="Arial" charset="0"/>
                </a:rPr>
                <a:t>KO</a:t>
              </a:r>
            </a:p>
          </p:txBody>
        </p:sp>
        <p:cxnSp>
          <p:nvCxnSpPr>
            <p:cNvPr id="172" name="Connecteur droit 171"/>
            <p:cNvCxnSpPr/>
            <p:nvPr/>
          </p:nvCxnSpPr>
          <p:spPr>
            <a:xfrm>
              <a:off x="5706517" y="6880233"/>
              <a:ext cx="435030" cy="0"/>
            </a:xfrm>
            <a:prstGeom prst="line">
              <a:avLst/>
            </a:prstGeom>
            <a:ln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ZoneTexte 3"/>
            <p:cNvSpPr txBox="1">
              <a:spLocks noChangeArrowheads="1"/>
            </p:cNvSpPr>
            <p:nvPr/>
          </p:nvSpPr>
          <p:spPr bwMode="auto">
            <a:xfrm>
              <a:off x="5030095" y="6671472"/>
              <a:ext cx="2222903" cy="247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900" b="1" dirty="0">
                  <a:latin typeface="Arial" charset="0"/>
                </a:rPr>
                <a:t>   </a:t>
              </a:r>
              <a:r>
                <a:rPr lang="fr-FR" altLang="fr-FR" sz="900" b="1" dirty="0" err="1">
                  <a:latin typeface="Arial" charset="0"/>
                </a:rPr>
                <a:t>fasting</a:t>
              </a:r>
              <a:r>
                <a:rPr lang="fr-FR" altLang="fr-FR" sz="900" b="1" dirty="0">
                  <a:latin typeface="Arial" charset="0"/>
                </a:rPr>
                <a:t> 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900" b="1" dirty="0">
                  <a:latin typeface="Arial" charset="0"/>
                </a:rPr>
                <a:t>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+        </a:t>
              </a:r>
              <a:r>
                <a:rPr lang="fr-FR" altLang="fr-FR" sz="900" b="1" dirty="0">
                  <a:latin typeface="Arial" charset="0"/>
                </a:rPr>
                <a:t>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700" b="1" dirty="0">
                  <a:latin typeface="Arial" charset="0"/>
                </a:rPr>
                <a:t>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+</a:t>
              </a:r>
            </a:p>
          </p:txBody>
        </p:sp>
        <p:cxnSp>
          <p:nvCxnSpPr>
            <p:cNvPr id="175" name="Connecteur droit 174"/>
            <p:cNvCxnSpPr/>
            <p:nvPr/>
          </p:nvCxnSpPr>
          <p:spPr>
            <a:xfrm>
              <a:off x="6375561" y="6880233"/>
              <a:ext cx="435030" cy="0"/>
            </a:xfrm>
            <a:prstGeom prst="line">
              <a:avLst/>
            </a:prstGeom>
            <a:ln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6" name="Groupe 175"/>
          <p:cNvGrpSpPr/>
          <p:nvPr/>
        </p:nvGrpSpPr>
        <p:grpSpPr>
          <a:xfrm>
            <a:off x="2953155" y="6028623"/>
            <a:ext cx="2237812" cy="580744"/>
            <a:chOff x="5030095" y="6511121"/>
            <a:chExt cx="2237480" cy="580658"/>
          </a:xfrm>
        </p:grpSpPr>
        <p:sp>
          <p:nvSpPr>
            <p:cNvPr id="177" name="ZoneTexte 3"/>
            <p:cNvSpPr txBox="1">
              <a:spLocks noChangeArrowheads="1"/>
            </p:cNvSpPr>
            <p:nvPr/>
          </p:nvSpPr>
          <p:spPr bwMode="auto">
            <a:xfrm>
              <a:off x="5044672" y="6511121"/>
              <a:ext cx="2222903" cy="247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900" b="1" dirty="0" err="1">
                  <a:latin typeface="Arial" charset="0"/>
                </a:rPr>
                <a:t>exercise</a:t>
              </a:r>
              <a:r>
                <a:rPr lang="fr-FR" altLang="fr-FR" sz="900" b="1" dirty="0">
                  <a:latin typeface="Arial" charset="0"/>
                </a:rPr>
                <a:t>     </a:t>
              </a:r>
              <a:r>
                <a:rPr lang="fr-FR" altLang="fr-FR" sz="1000" b="1" dirty="0">
                  <a:latin typeface="Arial" charset="0"/>
                </a:rPr>
                <a:t>-   +</a:t>
              </a:r>
              <a:r>
                <a:rPr lang="fr-FR" altLang="fr-FR" sz="600" b="1" dirty="0">
                  <a:latin typeface="Arial" charset="0"/>
                </a:rPr>
                <a:t>    </a:t>
              </a:r>
              <a:r>
                <a:rPr lang="fr-FR" altLang="fr-FR" sz="1000" b="1" dirty="0">
                  <a:latin typeface="Arial" charset="0"/>
                </a:rPr>
                <a:t>-     </a:t>
              </a:r>
              <a:r>
                <a:rPr lang="fr-FR" altLang="fr-FR" sz="900" b="1" dirty="0">
                  <a:latin typeface="Arial" charset="0"/>
                </a:rPr>
                <a:t> 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+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-</a:t>
              </a:r>
            </a:p>
          </p:txBody>
        </p:sp>
        <p:sp>
          <p:nvSpPr>
            <p:cNvPr id="178" name="ZoneTexte 115"/>
            <p:cNvSpPr txBox="1">
              <a:spLocks noChangeArrowheads="1"/>
            </p:cNvSpPr>
            <p:nvPr/>
          </p:nvSpPr>
          <p:spPr bwMode="auto">
            <a:xfrm>
              <a:off x="5706517" y="6860947"/>
              <a:ext cx="110407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900" b="1" dirty="0">
                  <a:latin typeface="Arial" charset="0"/>
                </a:rPr>
                <a:t>WT              </a:t>
              </a:r>
              <a:r>
                <a:rPr lang="fr-FR" altLang="fr-FR" sz="700" b="1" dirty="0">
                  <a:latin typeface="Arial" charset="0"/>
                </a:rPr>
                <a:t>  </a:t>
              </a:r>
              <a:r>
                <a:rPr lang="fr-FR" altLang="fr-FR" sz="900" b="1" dirty="0">
                  <a:latin typeface="Arial" charset="0"/>
                </a:rPr>
                <a:t>KO</a:t>
              </a:r>
            </a:p>
          </p:txBody>
        </p:sp>
        <p:cxnSp>
          <p:nvCxnSpPr>
            <p:cNvPr id="179" name="Connecteur droit 178"/>
            <p:cNvCxnSpPr/>
            <p:nvPr/>
          </p:nvCxnSpPr>
          <p:spPr>
            <a:xfrm>
              <a:off x="5706517" y="6880233"/>
              <a:ext cx="435030" cy="0"/>
            </a:xfrm>
            <a:prstGeom prst="line">
              <a:avLst/>
            </a:prstGeom>
            <a:ln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ZoneTexte 3"/>
            <p:cNvSpPr txBox="1">
              <a:spLocks noChangeArrowheads="1"/>
            </p:cNvSpPr>
            <p:nvPr/>
          </p:nvSpPr>
          <p:spPr bwMode="auto">
            <a:xfrm>
              <a:off x="5030095" y="6671472"/>
              <a:ext cx="2222903" cy="247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900" b="1" dirty="0">
                  <a:latin typeface="Arial" charset="0"/>
                </a:rPr>
                <a:t>   </a:t>
              </a:r>
              <a:r>
                <a:rPr lang="fr-FR" altLang="fr-FR" sz="900" b="1" dirty="0" err="1">
                  <a:latin typeface="Arial" charset="0"/>
                </a:rPr>
                <a:t>fasting</a:t>
              </a:r>
              <a:r>
                <a:rPr lang="fr-FR" altLang="fr-FR" sz="900" b="1" dirty="0">
                  <a:latin typeface="Arial" charset="0"/>
                </a:rPr>
                <a:t> 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900" b="1" dirty="0">
                  <a:latin typeface="Arial" charset="0"/>
                </a:rPr>
                <a:t>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+        </a:t>
              </a:r>
              <a:r>
                <a:rPr lang="fr-FR" altLang="fr-FR" sz="900" b="1" dirty="0">
                  <a:latin typeface="Arial" charset="0"/>
                </a:rPr>
                <a:t>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700" b="1" dirty="0">
                  <a:latin typeface="Arial" charset="0"/>
                </a:rPr>
                <a:t>    </a:t>
              </a:r>
              <a:r>
                <a:rPr lang="fr-FR" altLang="fr-FR" sz="1000" b="1" dirty="0">
                  <a:latin typeface="Arial" charset="0"/>
                </a:rPr>
                <a:t>-</a:t>
              </a:r>
              <a:r>
                <a:rPr lang="fr-FR" altLang="fr-FR" sz="800" b="1" dirty="0">
                  <a:latin typeface="Arial" charset="0"/>
                </a:rPr>
                <a:t>   </a:t>
              </a:r>
              <a:r>
                <a:rPr lang="fr-FR" altLang="fr-FR" sz="1000" b="1" dirty="0">
                  <a:latin typeface="Arial" charset="0"/>
                </a:rPr>
                <a:t>+</a:t>
              </a:r>
            </a:p>
          </p:txBody>
        </p:sp>
        <p:cxnSp>
          <p:nvCxnSpPr>
            <p:cNvPr id="181" name="Connecteur droit 180"/>
            <p:cNvCxnSpPr/>
            <p:nvPr/>
          </p:nvCxnSpPr>
          <p:spPr>
            <a:xfrm>
              <a:off x="6375561" y="6880233"/>
              <a:ext cx="435030" cy="0"/>
            </a:xfrm>
            <a:prstGeom prst="line">
              <a:avLst/>
            </a:prstGeom>
            <a:ln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82" name="Graphique 181"/>
          <p:cNvGraphicFramePr>
            <a:graphicFrameLocks/>
          </p:cNvGraphicFramePr>
          <p:nvPr>
            <p:extLst/>
          </p:nvPr>
        </p:nvGraphicFramePr>
        <p:xfrm>
          <a:off x="3106480" y="4587975"/>
          <a:ext cx="1968280" cy="175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sp>
        <p:nvSpPr>
          <p:cNvPr id="184" name="ZoneTexte 8"/>
          <p:cNvSpPr txBox="1"/>
          <p:nvPr/>
        </p:nvSpPr>
        <p:spPr>
          <a:xfrm>
            <a:off x="3526487" y="4553540"/>
            <a:ext cx="1366733" cy="23086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AMPK T172</a:t>
            </a:r>
          </a:p>
        </p:txBody>
      </p:sp>
      <p:sp>
        <p:nvSpPr>
          <p:cNvPr id="185" name="ZoneTexte 184"/>
          <p:cNvSpPr txBox="1"/>
          <p:nvPr/>
        </p:nvSpPr>
        <p:spPr>
          <a:xfrm>
            <a:off x="5144389" y="4481959"/>
            <a:ext cx="263253" cy="2462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ZoneTexte 87"/>
          <p:cNvSpPr txBox="1"/>
          <p:nvPr/>
        </p:nvSpPr>
        <p:spPr>
          <a:xfrm rot="16200000">
            <a:off x="2897792" y="3135666"/>
            <a:ext cx="1087184" cy="3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muscle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(mg)</a:t>
            </a:r>
          </a:p>
        </p:txBody>
      </p:sp>
      <p:sp>
        <p:nvSpPr>
          <p:cNvPr id="165" name="ZoneTexte 87"/>
          <p:cNvSpPr txBox="1"/>
          <p:nvPr/>
        </p:nvSpPr>
        <p:spPr>
          <a:xfrm rot="16200000">
            <a:off x="983958" y="7485642"/>
            <a:ext cx="1087184" cy="3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muscle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(mg)</a:t>
            </a:r>
          </a:p>
        </p:txBody>
      </p:sp>
      <p:sp>
        <p:nvSpPr>
          <p:cNvPr id="166" name="ZoneTexte 87"/>
          <p:cNvSpPr txBox="1"/>
          <p:nvPr/>
        </p:nvSpPr>
        <p:spPr>
          <a:xfrm rot="16200000">
            <a:off x="2536657" y="7496543"/>
            <a:ext cx="1087184" cy="3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muscle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(mg)</a:t>
            </a:r>
          </a:p>
        </p:txBody>
      </p:sp>
      <p:sp>
        <p:nvSpPr>
          <p:cNvPr id="167" name="ZoneTexte 87"/>
          <p:cNvSpPr txBox="1"/>
          <p:nvPr/>
        </p:nvSpPr>
        <p:spPr>
          <a:xfrm rot="16200000">
            <a:off x="4146217" y="7485643"/>
            <a:ext cx="1087184" cy="3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WAT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(mg)</a:t>
            </a:r>
          </a:p>
        </p:txBody>
      </p:sp>
      <p:sp>
        <p:nvSpPr>
          <p:cNvPr id="173" name="ZoneTexte 1"/>
          <p:cNvSpPr txBox="1"/>
          <p:nvPr/>
        </p:nvSpPr>
        <p:spPr>
          <a:xfrm>
            <a:off x="4345911" y="4946579"/>
            <a:ext cx="3497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ZoneTexte 1"/>
          <p:cNvSpPr txBox="1"/>
          <p:nvPr/>
        </p:nvSpPr>
        <p:spPr>
          <a:xfrm>
            <a:off x="4499214" y="5394105"/>
            <a:ext cx="3497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ZoneTexte 1"/>
          <p:cNvSpPr txBox="1"/>
          <p:nvPr/>
        </p:nvSpPr>
        <p:spPr>
          <a:xfrm>
            <a:off x="6703154" y="5432210"/>
            <a:ext cx="3709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$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ZoneTexte 1"/>
          <p:cNvSpPr txBox="1"/>
          <p:nvPr/>
        </p:nvSpPr>
        <p:spPr>
          <a:xfrm>
            <a:off x="6399437" y="4830197"/>
            <a:ext cx="3709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ZoneTexte 1"/>
          <p:cNvSpPr txBox="1"/>
          <p:nvPr/>
        </p:nvSpPr>
        <p:spPr>
          <a:xfrm>
            <a:off x="6027397" y="5300003"/>
            <a:ext cx="3709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ZoneTexte 1"/>
          <p:cNvSpPr txBox="1"/>
          <p:nvPr/>
        </p:nvSpPr>
        <p:spPr>
          <a:xfrm>
            <a:off x="6560258" y="5527474"/>
            <a:ext cx="37097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$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ZoneTexte 1"/>
          <p:cNvSpPr txBox="1"/>
          <p:nvPr/>
        </p:nvSpPr>
        <p:spPr>
          <a:xfrm>
            <a:off x="5836868" y="5452425"/>
            <a:ext cx="460205" cy="35889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$$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45740" y="8683698"/>
            <a:ext cx="746532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r>
              <a:rPr lang="fr-F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 Fig.1 </a:t>
            </a:r>
            <a:r>
              <a:rPr lang="fr-FR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on-</a:t>
            </a:r>
            <a:r>
              <a:rPr lang="fr-FR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fr-FR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s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roups</a:t>
            </a:r>
            <a:r>
              <a:rPr lang="fr-F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fr-F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) AMPK phosphorylation, b)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glycogen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tent and c) muscle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eight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gastrocnemiu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GAS),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ibiali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nterior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TA) and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oleu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SOL) in 6-m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l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T and REDD1 K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c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=7/group, </a:t>
            </a:r>
            <a:r>
              <a:rPr lang="fr-FR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xcept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for 1b </a:t>
            </a:r>
            <a:r>
              <a:rPr lang="fr-FR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hypoxic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KO n=6)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xpos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o 2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eek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hypobaric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hypoxia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6,500 m). d) AMPK phosphorylation and e)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glycogen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tent in 6-m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l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T and REDD1 K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c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n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spons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ither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90-min running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xercis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r 16h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oo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eprivation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f)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eight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gastrocnemiu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GAS),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ibiali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nterior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TA) and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erigonadal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hite adipose tissue (WAT) in 6-m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l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T and REDD1 K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c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in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spons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o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oo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eprivation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or 48h 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n=8/group,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xcept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or 1f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ast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T n=6 and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ast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KO 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=7)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*p&lt;0.05, **p&lt;0.01 and ***p&lt;0.001 vs. corresponding WT group; $p&lt;0.05, $$p&lt;0.01 and $$$p&lt;0.001 vs. corresponding CTRL group (same genotype) by two-way ANOVA and Fisher post-hoc test.</a:t>
            </a:r>
          </a:p>
        </p:txBody>
      </p:sp>
      <p:sp>
        <p:nvSpPr>
          <p:cNvPr id="150" name="ZoneTexte 3"/>
          <p:cNvSpPr txBox="1">
            <a:spLocks noChangeArrowheads="1"/>
          </p:cNvSpPr>
          <p:nvPr/>
        </p:nvSpPr>
        <p:spPr bwMode="auto">
          <a:xfrm>
            <a:off x="5019672" y="1796980"/>
            <a:ext cx="1377822" cy="247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900" b="1" dirty="0" err="1">
                <a:latin typeface="Arial" charset="0"/>
              </a:rPr>
              <a:t>hypoxia</a:t>
            </a:r>
            <a:r>
              <a:rPr lang="fr-FR" altLang="fr-FR" sz="900" b="1" dirty="0">
                <a:latin typeface="Arial" charset="0"/>
              </a:rPr>
              <a:t>   </a:t>
            </a:r>
            <a:r>
              <a:rPr lang="fr-FR" altLang="fr-FR" sz="1000" b="1" dirty="0">
                <a:latin typeface="Arial" charset="0"/>
              </a:rPr>
              <a:t>-  +</a:t>
            </a:r>
            <a:r>
              <a:rPr lang="fr-FR" altLang="fr-FR" sz="600" b="1" dirty="0">
                <a:latin typeface="Arial" charset="0"/>
              </a:rPr>
              <a:t>    </a:t>
            </a:r>
            <a:r>
              <a:rPr lang="fr-FR" altLang="fr-FR" sz="1000" b="1" dirty="0">
                <a:latin typeface="Arial" charset="0"/>
              </a:rPr>
              <a:t>-  +</a:t>
            </a:r>
          </a:p>
        </p:txBody>
      </p:sp>
    </p:spTree>
    <p:extLst>
      <p:ext uri="{BB962C8B-B14F-4D97-AF65-F5344CB8AC3E}">
        <p14:creationId xmlns:p14="http://schemas.microsoft.com/office/powerpoint/2010/main" val="3277065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4" r="59431"/>
          <a:stretch/>
        </p:blipFill>
        <p:spPr bwMode="auto">
          <a:xfrm>
            <a:off x="4276083" y="1396253"/>
            <a:ext cx="2161210" cy="1421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ZoneTexte 4"/>
          <p:cNvSpPr txBox="1"/>
          <p:nvPr/>
        </p:nvSpPr>
        <p:spPr>
          <a:xfrm rot="16200000">
            <a:off x="3170158" y="1874031"/>
            <a:ext cx="1961977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OCR </a:t>
            </a:r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s/million </a:t>
            </a:r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5601576" y="1622865"/>
            <a:ext cx="4213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6248179" y="1847277"/>
            <a:ext cx="2710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3799780" y="906253"/>
            <a:ext cx="466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Connecteur droit 9"/>
          <p:cNvCxnSpPr/>
          <p:nvPr/>
        </p:nvCxnSpPr>
        <p:spPr>
          <a:xfrm>
            <a:off x="4998827" y="1889897"/>
            <a:ext cx="1260000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 flipV="1">
            <a:off x="5682594" y="2050152"/>
            <a:ext cx="576000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5386261" y="1655631"/>
            <a:ext cx="288000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/>
          <p:cNvCxnSpPr/>
          <p:nvPr/>
        </p:nvCxnSpPr>
        <p:spPr>
          <a:xfrm>
            <a:off x="5643856" y="1656227"/>
            <a:ext cx="0" cy="2268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/>
          <p:nvPr/>
        </p:nvCxnSpPr>
        <p:spPr>
          <a:xfrm>
            <a:off x="6191349" y="1880468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 flipV="1">
            <a:off x="5275243" y="1820498"/>
            <a:ext cx="0" cy="7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5250482" y="2288366"/>
            <a:ext cx="7447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-DG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428703" y="2721842"/>
            <a:ext cx="203185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400"/>
              </a:spcAft>
            </a:pP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972319" y="956680"/>
            <a:ext cx="3553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Image 1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6" r="72774"/>
          <a:stretch/>
        </p:blipFill>
        <p:spPr bwMode="auto">
          <a:xfrm>
            <a:off x="1455653" y="1396253"/>
            <a:ext cx="1586194" cy="14483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ZoneTexte 19"/>
          <p:cNvSpPr txBox="1"/>
          <p:nvPr/>
        </p:nvSpPr>
        <p:spPr>
          <a:xfrm>
            <a:off x="2124447" y="1708303"/>
            <a:ext cx="8471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2020540" y="2217786"/>
            <a:ext cx="8471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rin1</a:t>
            </a:r>
            <a:endParaRPr lang="fr-FR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ZoneTexte 21"/>
          <p:cNvSpPr txBox="1"/>
          <p:nvPr/>
        </p:nvSpPr>
        <p:spPr>
          <a:xfrm rot="16200000">
            <a:off x="551457" y="1798680"/>
            <a:ext cx="164862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CR </a:t>
            </a:r>
            <a:r>
              <a:rPr lang="fr-F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s/million </a:t>
            </a:r>
            <a:r>
              <a:rPr lang="fr-F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2036420" y="2685768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98963" y="3402484"/>
            <a:ext cx="6694035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0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mTOR and HKII activity correlates with basal O</a:t>
            </a:r>
            <a:r>
              <a:rPr lang="en-US" sz="1100" b="1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sumption of myoblasts.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) Representative plot of mitochondrial respiration on C2C12 cells incubated with DMSO or Torin1 (250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M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for 16h. b) O</a:t>
            </a:r>
            <a:r>
              <a:rPr lang="en-US" sz="1100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sumption rate (OCR) of C2C12 muscle cells in presence of 2-deoxyglucose (2-DG), a HKII substrate. 2-DG led to a fast rise in OCR due to the transient activation of HKII (A), while accumulation of phospho-2DG, which resulted in a negative feedback on HKII activity, decreased OCR (B)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64109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449022" y="761156"/>
            <a:ext cx="682486" cy="239809"/>
          </a:xfrm>
          <a:prstGeom prst="rect">
            <a:avLst/>
          </a:prstGeom>
        </p:spPr>
        <p:txBody>
          <a:bodyPr wrap="square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400"/>
              </a:spcAft>
            </a:pPr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5" name="Rectangle 4"/>
          <p:cNvSpPr/>
          <p:nvPr/>
        </p:nvSpPr>
        <p:spPr>
          <a:xfrm>
            <a:off x="4314984" y="830386"/>
            <a:ext cx="108000" cy="108000"/>
          </a:xfrm>
          <a:prstGeom prst="rect">
            <a:avLst/>
          </a:prstGeom>
          <a:solidFill>
            <a:schemeClr val="tx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fr-FR"/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0097924"/>
              </p:ext>
            </p:extLst>
          </p:nvPr>
        </p:nvGraphicFramePr>
        <p:xfrm>
          <a:off x="4410550" y="1707869"/>
          <a:ext cx="1353902" cy="1694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ZoneTexte 4"/>
          <p:cNvSpPr txBox="1"/>
          <p:nvPr/>
        </p:nvSpPr>
        <p:spPr>
          <a:xfrm>
            <a:off x="4325813" y="1524236"/>
            <a:ext cx="1543050" cy="23980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ULK1 S317</a:t>
            </a:r>
          </a:p>
        </p:txBody>
      </p:sp>
      <p:sp>
        <p:nvSpPr>
          <p:cNvPr id="8" name="ZoneTexte 5"/>
          <p:cNvSpPr txBox="1"/>
          <p:nvPr/>
        </p:nvSpPr>
        <p:spPr>
          <a:xfrm rot="16200000">
            <a:off x="3712050" y="2375371"/>
            <a:ext cx="1371602" cy="30480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change</a:t>
            </a:r>
          </a:p>
        </p:txBody>
      </p:sp>
      <p:sp>
        <p:nvSpPr>
          <p:cNvPr id="9" name="Rectangle 8"/>
          <p:cNvSpPr/>
          <p:nvPr/>
        </p:nvSpPr>
        <p:spPr>
          <a:xfrm>
            <a:off x="4312912" y="1058573"/>
            <a:ext cx="108000" cy="108000"/>
          </a:xfrm>
          <a:prstGeom prst="rect">
            <a:avLst/>
          </a:prstGeom>
          <a:solidFill>
            <a:schemeClr val="bg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4449022" y="1010876"/>
            <a:ext cx="871257" cy="239809"/>
          </a:xfrm>
          <a:prstGeom prst="rect">
            <a:avLst/>
          </a:prstGeom>
        </p:spPr>
        <p:txBody>
          <a:bodyPr wrap="square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400"/>
              </a:spcAft>
            </a:pP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EXERCISE</a:t>
            </a:r>
          </a:p>
        </p:txBody>
      </p:sp>
      <p:graphicFrame>
        <p:nvGraphicFramePr>
          <p:cNvPr id="11" name="Graphique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3865010"/>
              </p:ext>
            </p:extLst>
          </p:nvPr>
        </p:nvGraphicFramePr>
        <p:xfrm>
          <a:off x="2839834" y="1707869"/>
          <a:ext cx="1353902" cy="1694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ZoneTexte 9"/>
          <p:cNvSpPr txBox="1"/>
          <p:nvPr/>
        </p:nvSpPr>
        <p:spPr>
          <a:xfrm>
            <a:off x="2805196" y="1524237"/>
            <a:ext cx="1402773" cy="23980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BNIP3</a:t>
            </a:r>
          </a:p>
        </p:txBody>
      </p:sp>
      <p:sp>
        <p:nvSpPr>
          <p:cNvPr id="13" name="ZoneTexte 5"/>
          <p:cNvSpPr txBox="1"/>
          <p:nvPr/>
        </p:nvSpPr>
        <p:spPr>
          <a:xfrm rot="16200000">
            <a:off x="1967125" y="2369137"/>
            <a:ext cx="1676142" cy="30480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change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55311" y="1556347"/>
            <a:ext cx="2285160" cy="1627448"/>
            <a:chOff x="-539849" y="2581933"/>
            <a:chExt cx="2285160" cy="1627448"/>
          </a:xfrm>
        </p:grpSpPr>
        <p:pic>
          <p:nvPicPr>
            <p:cNvPr id="1026" name="Picture 2" descr="E:\projet REDD\Exercice aigu\blots LLN\BNIP3-mbne3+4.ti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61" t="46111" r="48764" b="45269"/>
            <a:stretch/>
          </p:blipFill>
          <p:spPr bwMode="auto">
            <a:xfrm flipH="1">
              <a:off x="348230" y="3551784"/>
              <a:ext cx="1119632" cy="3779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8" name="Groupe 27"/>
            <p:cNvGrpSpPr/>
            <p:nvPr/>
          </p:nvGrpSpPr>
          <p:grpSpPr>
            <a:xfrm>
              <a:off x="-539849" y="2581933"/>
              <a:ext cx="2285160" cy="1627448"/>
              <a:chOff x="-729728" y="4170350"/>
              <a:chExt cx="2285160" cy="1627448"/>
            </a:xfrm>
          </p:grpSpPr>
          <p:grpSp>
            <p:nvGrpSpPr>
              <p:cNvPr id="27" name="Groupe 26"/>
              <p:cNvGrpSpPr/>
              <p:nvPr/>
            </p:nvGrpSpPr>
            <p:grpSpPr>
              <a:xfrm>
                <a:off x="-729728" y="4170350"/>
                <a:ext cx="2285160" cy="1627448"/>
                <a:chOff x="2709024" y="3320532"/>
                <a:chExt cx="2285160" cy="1627448"/>
              </a:xfrm>
            </p:grpSpPr>
            <p:sp>
              <p:nvSpPr>
                <p:cNvPr id="14" name="ZoneTexte 120"/>
                <p:cNvSpPr txBox="1">
                  <a:spLocks noChangeArrowheads="1"/>
                </p:cNvSpPr>
                <p:nvPr/>
              </p:nvSpPr>
              <p:spPr bwMode="auto">
                <a:xfrm>
                  <a:off x="2713998" y="3790206"/>
                  <a:ext cx="898856" cy="247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1000" b="1" dirty="0">
                      <a:solidFill>
                        <a:schemeClr val="tx1"/>
                      </a:solidFill>
                      <a:latin typeface="Arial" charset="0"/>
                    </a:rPr>
                    <a:t>ULK1 S317</a:t>
                  </a:r>
                </a:p>
              </p:txBody>
            </p:sp>
            <p:pic>
              <p:nvPicPr>
                <p:cNvPr id="15" name="Picture 3" descr="D:\Documents\redd1\métabolisme\exercice\exo 90'\Photos\ULK tot + akt 308 série 3 et 4.tiff"/>
                <p:cNvPicPr>
                  <a:picLocks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90895" y="4050556"/>
                  <a:ext cx="1151074" cy="1873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6" name="ZoneTexte 122"/>
                <p:cNvSpPr txBox="1">
                  <a:spLocks noChangeArrowheads="1"/>
                </p:cNvSpPr>
                <p:nvPr/>
              </p:nvSpPr>
              <p:spPr bwMode="auto">
                <a:xfrm>
                  <a:off x="2713998" y="4020394"/>
                  <a:ext cx="898856" cy="2398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1000" b="1" dirty="0">
                      <a:solidFill>
                        <a:schemeClr val="tx1"/>
                      </a:solidFill>
                      <a:latin typeface="Arial" charset="0"/>
                    </a:rPr>
                    <a:t>ULK1 </a:t>
                  </a:r>
                </a:p>
              </p:txBody>
            </p:sp>
            <p:pic>
              <p:nvPicPr>
                <p:cNvPr id="17" name="Picture 4" descr="D:\Documents\redd1\métabolisme\exercice\exo 90'\Photos\ULK1 S317-mbne9 long bis.tif"/>
                <p:cNvPicPr>
                  <a:picLocks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90895" y="3799731"/>
                  <a:ext cx="1149496" cy="1873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8" name="ZoneTexte 94"/>
                <p:cNvSpPr txBox="1"/>
                <p:nvPr/>
              </p:nvSpPr>
              <p:spPr>
                <a:xfrm>
                  <a:off x="3546975" y="3564001"/>
                  <a:ext cx="1447209" cy="2137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fr-FR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   -      +       -     +</a:t>
                  </a:r>
                </a:p>
              </p:txBody>
            </p:sp>
            <p:sp>
              <p:nvSpPr>
                <p:cNvPr id="19" name="ZoneTexte 91"/>
                <p:cNvSpPr txBox="1"/>
                <p:nvPr/>
              </p:nvSpPr>
              <p:spPr>
                <a:xfrm>
                  <a:off x="3593840" y="3320532"/>
                  <a:ext cx="589363" cy="1755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20" name="ZoneTexte 92"/>
                <p:cNvSpPr txBox="1"/>
                <p:nvPr/>
              </p:nvSpPr>
              <p:spPr>
                <a:xfrm>
                  <a:off x="4132030" y="3320532"/>
                  <a:ext cx="678677" cy="1838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</a:p>
              </p:txBody>
            </p:sp>
            <p:sp>
              <p:nvSpPr>
                <p:cNvPr id="21" name="ZoneTexte 93"/>
                <p:cNvSpPr txBox="1"/>
                <p:nvPr/>
              </p:nvSpPr>
              <p:spPr>
                <a:xfrm>
                  <a:off x="2856480" y="3570151"/>
                  <a:ext cx="82995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XERCISE</a:t>
                  </a:r>
                </a:p>
              </p:txBody>
            </p:sp>
            <p:cxnSp>
              <p:nvCxnSpPr>
                <p:cNvPr id="23" name="Connecteur droit 22"/>
                <p:cNvCxnSpPr/>
                <p:nvPr/>
              </p:nvCxnSpPr>
              <p:spPr>
                <a:xfrm>
                  <a:off x="3636615" y="3564001"/>
                  <a:ext cx="46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Connecteur droit 23"/>
                <p:cNvCxnSpPr/>
                <p:nvPr/>
              </p:nvCxnSpPr>
              <p:spPr>
                <a:xfrm>
                  <a:off x="4248735" y="3565550"/>
                  <a:ext cx="46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25" name="Picture 7" descr="D:\Documents\redd1\métabolisme\exercice\exo 90'\Photos\GSK tot + 14-3-3.tiff"/>
                <p:cNvPicPr>
                  <a:picLocks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>
                  <a:off x="3597103" y="4730922"/>
                  <a:ext cx="1138658" cy="187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6" name="ZoneTexte 15"/>
                <p:cNvSpPr txBox="1"/>
                <p:nvPr/>
              </p:nvSpPr>
              <p:spPr>
                <a:xfrm>
                  <a:off x="2709024" y="4708171"/>
                  <a:ext cx="898814" cy="2398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/>
                  <a:r>
                    <a:rPr lang="fr-FR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tubulin</a:t>
                  </a:r>
                </a:p>
              </p:txBody>
            </p:sp>
          </p:grpSp>
          <p:sp>
            <p:nvSpPr>
              <p:cNvPr id="29" name="ZoneTexte 122"/>
              <p:cNvSpPr txBox="1">
                <a:spLocks noChangeArrowheads="1"/>
              </p:cNvSpPr>
              <p:nvPr/>
            </p:nvSpPr>
            <p:spPr bwMode="auto">
              <a:xfrm>
                <a:off x="-724754" y="5197949"/>
                <a:ext cx="898856" cy="2398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no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1000" b="1" dirty="0" smtClean="0">
                    <a:solidFill>
                      <a:schemeClr val="tx1"/>
                    </a:solidFill>
                    <a:latin typeface="Arial" charset="0"/>
                  </a:rPr>
                  <a:t>BNIP3</a:t>
                </a:r>
                <a:endParaRPr lang="fr-FR" altLang="fr-FR" sz="1000" b="1" dirty="0">
                  <a:solidFill>
                    <a:schemeClr val="tx1"/>
                  </a:solidFill>
                  <a:latin typeface="Arial" charset="0"/>
                </a:endParaRPr>
              </a:p>
            </p:txBody>
          </p:sp>
        </p:grpSp>
      </p:grpSp>
      <p:sp>
        <p:nvSpPr>
          <p:cNvPr id="32" name="ZoneTexte 31"/>
          <p:cNvSpPr txBox="1"/>
          <p:nvPr/>
        </p:nvSpPr>
        <p:spPr>
          <a:xfrm>
            <a:off x="1627820" y="2022695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50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1566166" y="2940262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50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1627820" y="2273533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50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1566166" y="2580222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25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Graphique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4531164"/>
              </p:ext>
            </p:extLst>
          </p:nvPr>
        </p:nvGraphicFramePr>
        <p:xfrm>
          <a:off x="6071444" y="1584810"/>
          <a:ext cx="1165570" cy="1800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7" name="ZoneTexte 4"/>
          <p:cNvSpPr txBox="1"/>
          <p:nvPr/>
        </p:nvSpPr>
        <p:spPr>
          <a:xfrm>
            <a:off x="5940871" y="1525502"/>
            <a:ext cx="1543050" cy="23980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itochondrial DNA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5"/>
          <p:cNvSpPr txBox="1"/>
          <p:nvPr/>
        </p:nvSpPr>
        <p:spPr>
          <a:xfrm rot="16200000">
            <a:off x="5299644" y="2370301"/>
            <a:ext cx="1371602" cy="30480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change</a:t>
            </a:r>
          </a:p>
        </p:txBody>
      </p:sp>
      <p:sp>
        <p:nvSpPr>
          <p:cNvPr id="2" name="Rectangle 1"/>
          <p:cNvSpPr/>
          <p:nvPr/>
        </p:nvSpPr>
        <p:spPr>
          <a:xfrm>
            <a:off x="309646" y="3841875"/>
            <a:ext cx="6927367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1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crease in </a:t>
            </a:r>
            <a:r>
              <a:rPr lang="en-US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tophagy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arkers following intense running exercise in REDD1 KO mice.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NIP3 protein expression, AMPK-dependent UNC-51-like kinase 1 (ULK1) S317 phosphorylation and mitochondrial DNA in skeletal muscle of WT and REDD1 KO mice. Gastrocnemius muscle was removed immediately after a 90 min bout of running exercise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(WT n=8/group; KO n=7/group).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$p&lt;0.05 vs. corresponding CTRL group (same genotype)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58274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Graphique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3148981"/>
              </p:ext>
            </p:extLst>
          </p:nvPr>
        </p:nvGraphicFramePr>
        <p:xfrm>
          <a:off x="557112" y="1797325"/>
          <a:ext cx="5790405" cy="28292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4" name="ZoneTexte 29"/>
          <p:cNvSpPr txBox="1"/>
          <p:nvPr/>
        </p:nvSpPr>
        <p:spPr>
          <a:xfrm rot="16200000">
            <a:off x="-2297" y="2787618"/>
            <a:ext cx="1002533" cy="27460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59" name="ZoneTexte 27"/>
          <p:cNvSpPr txBox="1"/>
          <p:nvPr/>
        </p:nvSpPr>
        <p:spPr>
          <a:xfrm>
            <a:off x="843123" y="1544698"/>
            <a:ext cx="5398667" cy="27460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</p:txBody>
      </p:sp>
      <p:sp>
        <p:nvSpPr>
          <p:cNvPr id="60" name="Rectangle 59"/>
          <p:cNvSpPr/>
          <p:nvPr/>
        </p:nvSpPr>
        <p:spPr>
          <a:xfrm>
            <a:off x="6458524" y="2565827"/>
            <a:ext cx="119075" cy="126300"/>
          </a:xfrm>
          <a:prstGeom prst="rect">
            <a:avLst/>
          </a:prstGeom>
          <a:solidFill>
            <a:schemeClr val="tx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61" name="Rectangle 60"/>
          <p:cNvSpPr/>
          <p:nvPr/>
        </p:nvSpPr>
        <p:spPr>
          <a:xfrm>
            <a:off x="6458524" y="2799745"/>
            <a:ext cx="119075" cy="126300"/>
          </a:xfrm>
          <a:prstGeom prst="rect">
            <a:avLst/>
          </a:prstGeom>
          <a:pattFill prst="wdDnDiag">
            <a:fgClr>
              <a:schemeClr val="tx1"/>
            </a:fgClr>
            <a:bgClr>
              <a:schemeClr val="bg1"/>
            </a:bgClr>
          </a:patt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62" name="Rectangle 61"/>
          <p:cNvSpPr/>
          <p:nvPr/>
        </p:nvSpPr>
        <p:spPr>
          <a:xfrm>
            <a:off x="6458524" y="3022524"/>
            <a:ext cx="119075" cy="126300"/>
          </a:xfrm>
          <a:prstGeom prst="rect">
            <a:avLst/>
          </a:prstGeom>
          <a:solidFill>
            <a:schemeClr val="bg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63" name="Rectangle 62"/>
          <p:cNvSpPr/>
          <p:nvPr/>
        </p:nvSpPr>
        <p:spPr>
          <a:xfrm>
            <a:off x="6458524" y="3245303"/>
            <a:ext cx="119075" cy="126300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64" name="ZoneTexte 51"/>
          <p:cNvSpPr txBox="1"/>
          <p:nvPr/>
        </p:nvSpPr>
        <p:spPr>
          <a:xfrm>
            <a:off x="6595045" y="2489740"/>
            <a:ext cx="1123689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WT-N</a:t>
            </a:r>
          </a:p>
        </p:txBody>
      </p:sp>
      <p:sp>
        <p:nvSpPr>
          <p:cNvPr id="65" name="ZoneTexte 52"/>
          <p:cNvSpPr txBox="1"/>
          <p:nvPr/>
        </p:nvSpPr>
        <p:spPr>
          <a:xfrm>
            <a:off x="6595046" y="2723658"/>
            <a:ext cx="1134191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WT-H</a:t>
            </a:r>
          </a:p>
        </p:txBody>
      </p:sp>
      <p:sp>
        <p:nvSpPr>
          <p:cNvPr id="66" name="ZoneTexte 53"/>
          <p:cNvSpPr txBox="1"/>
          <p:nvPr/>
        </p:nvSpPr>
        <p:spPr>
          <a:xfrm>
            <a:off x="6595046" y="2946437"/>
            <a:ext cx="1113187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KO-N</a:t>
            </a:r>
          </a:p>
        </p:txBody>
      </p:sp>
      <p:sp>
        <p:nvSpPr>
          <p:cNvPr id="67" name="ZoneTexte 54"/>
          <p:cNvSpPr txBox="1"/>
          <p:nvPr/>
        </p:nvSpPr>
        <p:spPr>
          <a:xfrm>
            <a:off x="6595046" y="3169217"/>
            <a:ext cx="1155194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KO-H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1348150" y="2568785"/>
            <a:ext cx="577402" cy="246220"/>
            <a:chOff x="1222759" y="1300165"/>
            <a:chExt cx="523698" cy="210545"/>
          </a:xfrm>
        </p:grpSpPr>
        <p:sp>
          <p:nvSpPr>
            <p:cNvPr id="2" name="ZoneTexte 1"/>
            <p:cNvSpPr txBox="1"/>
            <p:nvPr/>
          </p:nvSpPr>
          <p:spPr>
            <a:xfrm>
              <a:off x="1222759" y="1300165"/>
              <a:ext cx="523698" cy="210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06</a:t>
              </a:r>
            </a:p>
          </p:txBody>
        </p:sp>
        <p:cxnSp>
          <p:nvCxnSpPr>
            <p:cNvPr id="4" name="Connecteur droit 3"/>
            <p:cNvCxnSpPr/>
            <p:nvPr/>
          </p:nvCxnSpPr>
          <p:spPr>
            <a:xfrm flipH="1">
              <a:off x="1421588" y="1501847"/>
              <a:ext cx="14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e 4"/>
          <p:cNvGrpSpPr/>
          <p:nvPr/>
        </p:nvGrpSpPr>
        <p:grpSpPr>
          <a:xfrm>
            <a:off x="2279854" y="2588276"/>
            <a:ext cx="577402" cy="246220"/>
            <a:chOff x="2067807" y="1316832"/>
            <a:chExt cx="523698" cy="210545"/>
          </a:xfrm>
        </p:grpSpPr>
        <p:sp>
          <p:nvSpPr>
            <p:cNvPr id="16" name="ZoneTexte 15"/>
            <p:cNvSpPr txBox="1"/>
            <p:nvPr/>
          </p:nvSpPr>
          <p:spPr>
            <a:xfrm>
              <a:off x="2067807" y="1316832"/>
              <a:ext cx="523698" cy="210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07</a:t>
              </a:r>
            </a:p>
          </p:txBody>
        </p:sp>
        <p:cxnSp>
          <p:nvCxnSpPr>
            <p:cNvPr id="17" name="Connecteur droit 16"/>
            <p:cNvCxnSpPr/>
            <p:nvPr/>
          </p:nvCxnSpPr>
          <p:spPr>
            <a:xfrm flipH="1">
              <a:off x="2231055" y="1523854"/>
              <a:ext cx="21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Groupe 18"/>
          <p:cNvGrpSpPr/>
          <p:nvPr/>
        </p:nvGrpSpPr>
        <p:grpSpPr>
          <a:xfrm>
            <a:off x="1790579" y="2004990"/>
            <a:ext cx="577402" cy="246220"/>
            <a:chOff x="2067807" y="1316832"/>
            <a:chExt cx="523698" cy="210545"/>
          </a:xfrm>
        </p:grpSpPr>
        <p:sp>
          <p:nvSpPr>
            <p:cNvPr id="21" name="ZoneTexte 20"/>
            <p:cNvSpPr txBox="1"/>
            <p:nvPr/>
          </p:nvSpPr>
          <p:spPr>
            <a:xfrm>
              <a:off x="2067807" y="1316832"/>
              <a:ext cx="523698" cy="210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07</a:t>
              </a:r>
            </a:p>
          </p:txBody>
        </p:sp>
        <p:cxnSp>
          <p:nvCxnSpPr>
            <p:cNvPr id="22" name="Connecteur droit 21"/>
            <p:cNvCxnSpPr/>
            <p:nvPr/>
          </p:nvCxnSpPr>
          <p:spPr>
            <a:xfrm flipH="1">
              <a:off x="2231055" y="1523854"/>
              <a:ext cx="21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oupe 22"/>
          <p:cNvGrpSpPr/>
          <p:nvPr/>
        </p:nvGrpSpPr>
        <p:grpSpPr>
          <a:xfrm>
            <a:off x="3304280" y="2521384"/>
            <a:ext cx="577402" cy="246220"/>
            <a:chOff x="1222759" y="1300165"/>
            <a:chExt cx="523698" cy="210545"/>
          </a:xfrm>
        </p:grpSpPr>
        <p:sp>
          <p:nvSpPr>
            <p:cNvPr id="24" name="ZoneTexte 23"/>
            <p:cNvSpPr txBox="1"/>
            <p:nvPr/>
          </p:nvSpPr>
          <p:spPr>
            <a:xfrm>
              <a:off x="1222759" y="1300165"/>
              <a:ext cx="523698" cy="210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08</a:t>
              </a:r>
            </a:p>
          </p:txBody>
        </p:sp>
        <p:cxnSp>
          <p:nvCxnSpPr>
            <p:cNvPr id="25" name="Connecteur droit 24"/>
            <p:cNvCxnSpPr/>
            <p:nvPr/>
          </p:nvCxnSpPr>
          <p:spPr>
            <a:xfrm flipH="1">
              <a:off x="1421588" y="1501847"/>
              <a:ext cx="14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e 25"/>
          <p:cNvGrpSpPr/>
          <p:nvPr/>
        </p:nvGrpSpPr>
        <p:grpSpPr>
          <a:xfrm>
            <a:off x="5083081" y="2159803"/>
            <a:ext cx="577402" cy="246220"/>
            <a:chOff x="1222759" y="1300165"/>
            <a:chExt cx="523698" cy="210545"/>
          </a:xfrm>
        </p:grpSpPr>
        <p:sp>
          <p:nvSpPr>
            <p:cNvPr id="27" name="ZoneTexte 26"/>
            <p:cNvSpPr txBox="1"/>
            <p:nvPr/>
          </p:nvSpPr>
          <p:spPr>
            <a:xfrm>
              <a:off x="1222759" y="1300165"/>
              <a:ext cx="523698" cy="210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=0.08</a:t>
              </a:r>
            </a:p>
          </p:txBody>
        </p:sp>
        <p:cxnSp>
          <p:nvCxnSpPr>
            <p:cNvPr id="28" name="Connecteur droit 27"/>
            <p:cNvCxnSpPr/>
            <p:nvPr/>
          </p:nvCxnSpPr>
          <p:spPr>
            <a:xfrm flipH="1">
              <a:off x="1421588" y="1501847"/>
              <a:ext cx="14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Rectangle 2"/>
          <p:cNvSpPr/>
          <p:nvPr/>
        </p:nvSpPr>
        <p:spPr>
          <a:xfrm>
            <a:off x="361667" y="4730423"/>
            <a:ext cx="6803339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2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trophying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gene expression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 REDD1 KO muscles after hypoxia exposure.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RNA expression of genes related to ubiquitin proteasome system and autophagy, REDD1 and REDD2 in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ibialis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terior muscle of WT and REDD1 KO mice after 2 weeks at simulated altitude (equivalent to 6,500 m above sea level;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WT n=7; KO n=6/group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. FOXO: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orkhead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ox O;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AFbx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Muscle Atrophy F-box; MuRF1: Muscle RING-Finger 1; BNIP3: BCL2/Adenovirus E1B 19kDa Interacting Protein 3;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athL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athepsin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L;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Gabarapl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GABA(A) receptor-associated protein-like; LAMP2A: lysosome-associated membrane protein type 2A; LC3: Microtubule-associated protein 1A/1B-light chain 3. *p&lt;0.05 and ***p&lt;0.001 vs. corresponding WT group; $p&lt;0.05 and $$p&lt;0.01 vs. corresponding CTRL group (same genotype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 by two-way ANOVA and Fisher post-hoc test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80872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Graphique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038339"/>
              </p:ext>
            </p:extLst>
          </p:nvPr>
        </p:nvGraphicFramePr>
        <p:xfrm>
          <a:off x="2216101" y="3513771"/>
          <a:ext cx="2635054" cy="19171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Graphique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3892859"/>
              </p:ext>
            </p:extLst>
          </p:nvPr>
        </p:nvGraphicFramePr>
        <p:xfrm>
          <a:off x="1275309" y="1425846"/>
          <a:ext cx="1089609" cy="1678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Graphique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6592119"/>
              </p:ext>
            </p:extLst>
          </p:nvPr>
        </p:nvGraphicFramePr>
        <p:xfrm>
          <a:off x="4074025" y="1425845"/>
          <a:ext cx="1218203" cy="1670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Graphique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7846171"/>
              </p:ext>
            </p:extLst>
          </p:nvPr>
        </p:nvGraphicFramePr>
        <p:xfrm>
          <a:off x="5401972" y="1418129"/>
          <a:ext cx="1012640" cy="1678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5" name="Graphique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0038067"/>
              </p:ext>
            </p:extLst>
          </p:nvPr>
        </p:nvGraphicFramePr>
        <p:xfrm>
          <a:off x="2492153" y="1425846"/>
          <a:ext cx="1089609" cy="1678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6" name="ZoneTexte 14"/>
          <p:cNvSpPr txBox="1"/>
          <p:nvPr/>
        </p:nvSpPr>
        <p:spPr>
          <a:xfrm rot="16200000">
            <a:off x="1014060" y="2034623"/>
            <a:ext cx="415834" cy="27460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AU</a:t>
            </a:r>
          </a:p>
        </p:txBody>
      </p:sp>
      <p:sp>
        <p:nvSpPr>
          <p:cNvPr id="29" name="ZoneTexte 24"/>
          <p:cNvSpPr txBox="1"/>
          <p:nvPr/>
        </p:nvSpPr>
        <p:spPr>
          <a:xfrm>
            <a:off x="1497586" y="1197506"/>
            <a:ext cx="2301644" cy="280443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thiols &amp; carbonyls</a:t>
            </a:r>
          </a:p>
        </p:txBody>
      </p:sp>
      <p:sp>
        <p:nvSpPr>
          <p:cNvPr id="30" name="ZoneTexte 25"/>
          <p:cNvSpPr txBox="1"/>
          <p:nvPr/>
        </p:nvSpPr>
        <p:spPr>
          <a:xfrm rot="16200000">
            <a:off x="3408048" y="2031606"/>
            <a:ext cx="1188156" cy="27460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mU/mg prot</a:t>
            </a:r>
          </a:p>
        </p:txBody>
      </p:sp>
      <p:sp>
        <p:nvSpPr>
          <p:cNvPr id="31" name="ZoneTexte 26"/>
          <p:cNvSpPr txBox="1"/>
          <p:nvPr/>
        </p:nvSpPr>
        <p:spPr>
          <a:xfrm>
            <a:off x="4189278" y="1190068"/>
            <a:ext cx="2111119" cy="280443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enzymatic activity</a:t>
            </a:r>
          </a:p>
        </p:txBody>
      </p:sp>
      <p:sp>
        <p:nvSpPr>
          <p:cNvPr id="32" name="ZoneTexte 27"/>
          <p:cNvSpPr txBox="1"/>
          <p:nvPr/>
        </p:nvSpPr>
        <p:spPr>
          <a:xfrm>
            <a:off x="2603779" y="3445079"/>
            <a:ext cx="2173848" cy="280443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</a:p>
        </p:txBody>
      </p:sp>
      <p:sp>
        <p:nvSpPr>
          <p:cNvPr id="33" name="ZoneTexte 28"/>
          <p:cNvSpPr txBox="1"/>
          <p:nvPr/>
        </p:nvSpPr>
        <p:spPr>
          <a:xfrm rot="16200000">
            <a:off x="1570741" y="4284070"/>
            <a:ext cx="1002533" cy="27460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35" name="ZoneTexte 15"/>
          <p:cNvSpPr txBox="1"/>
          <p:nvPr/>
        </p:nvSpPr>
        <p:spPr>
          <a:xfrm rot="16200000">
            <a:off x="1948794" y="2011889"/>
            <a:ext cx="1002533" cy="27460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fold change</a:t>
            </a:r>
          </a:p>
        </p:txBody>
      </p:sp>
      <p:sp>
        <p:nvSpPr>
          <p:cNvPr id="38" name="ZoneTexte 38"/>
          <p:cNvSpPr txBox="1"/>
          <p:nvPr/>
        </p:nvSpPr>
        <p:spPr>
          <a:xfrm rot="16200000">
            <a:off x="4720769" y="2042745"/>
            <a:ext cx="1188156" cy="274602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mU/mg prot</a:t>
            </a:r>
          </a:p>
        </p:txBody>
      </p:sp>
      <p:sp>
        <p:nvSpPr>
          <p:cNvPr id="51" name="Rectangle 50"/>
          <p:cNvSpPr/>
          <p:nvPr/>
        </p:nvSpPr>
        <p:spPr>
          <a:xfrm>
            <a:off x="5368475" y="4075437"/>
            <a:ext cx="119075" cy="126300"/>
          </a:xfrm>
          <a:prstGeom prst="rect">
            <a:avLst/>
          </a:prstGeom>
          <a:solidFill>
            <a:schemeClr val="tx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52" name="Rectangle 51"/>
          <p:cNvSpPr/>
          <p:nvPr/>
        </p:nvSpPr>
        <p:spPr>
          <a:xfrm>
            <a:off x="5368475" y="4309355"/>
            <a:ext cx="119075" cy="126300"/>
          </a:xfrm>
          <a:prstGeom prst="rect">
            <a:avLst/>
          </a:prstGeom>
          <a:pattFill prst="wdDnDiag">
            <a:fgClr>
              <a:schemeClr val="tx1"/>
            </a:fgClr>
            <a:bgClr>
              <a:schemeClr val="bg1"/>
            </a:bgClr>
          </a:patt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53" name="Rectangle 52"/>
          <p:cNvSpPr/>
          <p:nvPr/>
        </p:nvSpPr>
        <p:spPr>
          <a:xfrm>
            <a:off x="5368475" y="4532134"/>
            <a:ext cx="119075" cy="126300"/>
          </a:xfrm>
          <a:prstGeom prst="rect">
            <a:avLst/>
          </a:prstGeom>
          <a:solidFill>
            <a:schemeClr val="bg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54" name="Rectangle 53"/>
          <p:cNvSpPr/>
          <p:nvPr/>
        </p:nvSpPr>
        <p:spPr>
          <a:xfrm>
            <a:off x="5368475" y="4754913"/>
            <a:ext cx="119075" cy="126300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55" name="ZoneTexte 51"/>
          <p:cNvSpPr txBox="1"/>
          <p:nvPr/>
        </p:nvSpPr>
        <p:spPr>
          <a:xfrm>
            <a:off x="5504996" y="3999350"/>
            <a:ext cx="1123689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WT-N</a:t>
            </a:r>
          </a:p>
        </p:txBody>
      </p:sp>
      <p:sp>
        <p:nvSpPr>
          <p:cNvPr id="56" name="ZoneTexte 52"/>
          <p:cNvSpPr txBox="1"/>
          <p:nvPr/>
        </p:nvSpPr>
        <p:spPr>
          <a:xfrm>
            <a:off x="5504997" y="4233268"/>
            <a:ext cx="1134191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WT-H</a:t>
            </a:r>
          </a:p>
        </p:txBody>
      </p:sp>
      <p:sp>
        <p:nvSpPr>
          <p:cNvPr id="57" name="ZoneTexte 53"/>
          <p:cNvSpPr txBox="1"/>
          <p:nvPr/>
        </p:nvSpPr>
        <p:spPr>
          <a:xfrm>
            <a:off x="5504997" y="4456047"/>
            <a:ext cx="1113187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>
                <a:latin typeface="Arial" panose="020B0604020202020204" pitchFamily="34" charset="0"/>
                <a:cs typeface="Arial" panose="020B0604020202020204" pitchFamily="34" charset="0"/>
              </a:rPr>
              <a:t>KO-N</a:t>
            </a:r>
          </a:p>
        </p:txBody>
      </p:sp>
      <p:sp>
        <p:nvSpPr>
          <p:cNvPr id="58" name="ZoneTexte 54"/>
          <p:cNvSpPr txBox="1"/>
          <p:nvPr/>
        </p:nvSpPr>
        <p:spPr>
          <a:xfrm>
            <a:off x="5504997" y="4678827"/>
            <a:ext cx="1155194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KO-H</a:t>
            </a:r>
          </a:p>
        </p:txBody>
      </p:sp>
      <p:sp>
        <p:nvSpPr>
          <p:cNvPr id="2" name="Rectangle 1"/>
          <p:cNvSpPr/>
          <p:nvPr/>
        </p:nvSpPr>
        <p:spPr>
          <a:xfrm>
            <a:off x="475793" y="5706740"/>
            <a:ext cx="6545198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3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DD1 deletion did not disrupt redox status of skeletal muscle in </a:t>
            </a:r>
            <a:r>
              <a:rPr lang="en-US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ormoxic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hypoxic mice.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nzymatic activity of glutathione peroxidase and superoxide dismutase, measurement of oxidized protein i.e. reduced thiol (SH) and carbonyls (gastrocnemius) and mRNA expression of genes involved in redox balance (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ibialis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terior;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=7/group except for mRNA expression of KO groups where n=6).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RX,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hioredoxin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; TXNIP,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hioredoxin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interacting protein. *p&lt;0.05 vs. corresponding WT group; $p&lt;0.05 and $$p&lt;0.01 vs. corresponding CTRL group (same genotype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by two-way ANOVA and Fisher post-hoc test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923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1"/>
          <p:cNvSpPr txBox="1"/>
          <p:nvPr/>
        </p:nvSpPr>
        <p:spPr>
          <a:xfrm>
            <a:off x="4645091" y="4725773"/>
            <a:ext cx="347669" cy="19999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$$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 rot="16200000">
            <a:off x="3247389" y="4633336"/>
            <a:ext cx="16833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% WT SED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5796855" y="4392829"/>
            <a:ext cx="119075" cy="126300"/>
          </a:xfrm>
          <a:prstGeom prst="rect">
            <a:avLst/>
          </a:prstGeom>
          <a:solidFill>
            <a:schemeClr val="tx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33" name="Rectangle 32"/>
          <p:cNvSpPr/>
          <p:nvPr/>
        </p:nvSpPr>
        <p:spPr>
          <a:xfrm>
            <a:off x="5796855" y="4626747"/>
            <a:ext cx="119075" cy="126300"/>
          </a:xfrm>
          <a:prstGeom prst="rect">
            <a:avLst/>
          </a:prstGeom>
          <a:pattFill prst="wdDnDiag">
            <a:fgClr>
              <a:schemeClr val="tx1"/>
            </a:fgClr>
            <a:bgClr>
              <a:schemeClr val="bg1"/>
            </a:bgClr>
          </a:patt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35" name="Rectangle 34"/>
          <p:cNvSpPr/>
          <p:nvPr/>
        </p:nvSpPr>
        <p:spPr>
          <a:xfrm>
            <a:off x="5796855" y="4849526"/>
            <a:ext cx="119075" cy="126300"/>
          </a:xfrm>
          <a:prstGeom prst="rect">
            <a:avLst/>
          </a:prstGeom>
          <a:solidFill>
            <a:schemeClr val="bg1"/>
          </a:solid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36" name="Rectangle 35"/>
          <p:cNvSpPr/>
          <p:nvPr/>
        </p:nvSpPr>
        <p:spPr>
          <a:xfrm>
            <a:off x="5796855" y="5072305"/>
            <a:ext cx="119075" cy="126300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3175">
            <a:solidFill>
              <a:sysClr val="windowText" lastClr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fr-FR" sz="1300"/>
          </a:p>
        </p:txBody>
      </p:sp>
      <p:sp>
        <p:nvSpPr>
          <p:cNvPr id="37" name="ZoneTexte 51"/>
          <p:cNvSpPr txBox="1"/>
          <p:nvPr/>
        </p:nvSpPr>
        <p:spPr>
          <a:xfrm>
            <a:off x="5933376" y="4316742"/>
            <a:ext cx="1123689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WT-SED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52"/>
          <p:cNvSpPr txBox="1"/>
          <p:nvPr/>
        </p:nvSpPr>
        <p:spPr>
          <a:xfrm>
            <a:off x="5933377" y="4550660"/>
            <a:ext cx="1134191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WT-EX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53"/>
          <p:cNvSpPr txBox="1"/>
          <p:nvPr/>
        </p:nvSpPr>
        <p:spPr>
          <a:xfrm>
            <a:off x="5933377" y="4773439"/>
            <a:ext cx="1113187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KO-SED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54"/>
          <p:cNvSpPr txBox="1"/>
          <p:nvPr/>
        </p:nvSpPr>
        <p:spPr>
          <a:xfrm>
            <a:off x="5933377" y="4996219"/>
            <a:ext cx="1155194" cy="27847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lIns="104306" tIns="52153" rIns="104306" bIns="52153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KO-EX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4" name="Groupe 103"/>
          <p:cNvGrpSpPr/>
          <p:nvPr/>
        </p:nvGrpSpPr>
        <p:grpSpPr>
          <a:xfrm>
            <a:off x="626340" y="4053027"/>
            <a:ext cx="2979795" cy="1443930"/>
            <a:chOff x="570602" y="3458060"/>
            <a:chExt cx="2979795" cy="1443930"/>
          </a:xfrm>
        </p:grpSpPr>
        <p:sp>
          <p:nvSpPr>
            <p:cNvPr id="34" name="ZoneTexte 33"/>
            <p:cNvSpPr txBox="1"/>
            <p:nvPr/>
          </p:nvSpPr>
          <p:spPr>
            <a:xfrm>
              <a:off x="570602" y="3923961"/>
              <a:ext cx="1528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dirty="0" smtClean="0"/>
                <a:t>REDD1</a:t>
              </a:r>
            </a:p>
          </p:txBody>
        </p:sp>
        <p:pic>
          <p:nvPicPr>
            <p:cNvPr id="27" name="Picture 2" descr="D:\Documents\redd1\métabolisme\exercice\exo 90'\Photos\ULK tot + akt 308 série 3 et 4.tiff"/>
            <p:cNvPicPr>
              <a:picLocks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14000"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092757" y="4207207"/>
              <a:ext cx="1144800" cy="187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ZoneTexte 27"/>
            <p:cNvSpPr txBox="1"/>
            <p:nvPr/>
          </p:nvSpPr>
          <p:spPr>
            <a:xfrm>
              <a:off x="1201102" y="4152178"/>
              <a:ext cx="8979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dirty="0" smtClean="0"/>
                <a:t>Akt T308</a:t>
              </a:r>
              <a:endParaRPr lang="fr-FR" sz="1200" dirty="0"/>
            </a:p>
          </p:txBody>
        </p:sp>
        <p:pic>
          <p:nvPicPr>
            <p:cNvPr id="29" name="Picture 3" descr="D:\Documents\redd1\métabolisme\exercice\exo 90'\Photos\Akt tot.tiff"/>
            <p:cNvPicPr>
              <a:picLocks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092757" y="4435708"/>
              <a:ext cx="1144800" cy="187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ZoneTexte 29"/>
            <p:cNvSpPr txBox="1"/>
            <p:nvPr/>
          </p:nvSpPr>
          <p:spPr>
            <a:xfrm>
              <a:off x="1632746" y="4363025"/>
              <a:ext cx="4662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dirty="0" err="1" smtClean="0"/>
                <a:t>Akt</a:t>
              </a:r>
              <a:endParaRPr lang="fr-FR" sz="1200" dirty="0"/>
            </a:p>
          </p:txBody>
        </p:sp>
        <p:pic>
          <p:nvPicPr>
            <p:cNvPr id="31" name="Picture 3" descr="D:\Documents\redd1\métabolisme\exercice\exo 90'\Photos\Phospho ULK série 1.tif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092757" y="3964813"/>
              <a:ext cx="1144940" cy="1869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0" name="Connecteur droit 19"/>
            <p:cNvCxnSpPr/>
            <p:nvPr/>
          </p:nvCxnSpPr>
          <p:spPr>
            <a:xfrm>
              <a:off x="2115907" y="3735059"/>
              <a:ext cx="507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20"/>
            <p:cNvCxnSpPr/>
            <p:nvPr/>
          </p:nvCxnSpPr>
          <p:spPr>
            <a:xfrm>
              <a:off x="2713867" y="3735059"/>
              <a:ext cx="50580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ZoneTexte 21"/>
            <p:cNvSpPr txBox="1"/>
            <p:nvPr/>
          </p:nvSpPr>
          <p:spPr>
            <a:xfrm>
              <a:off x="2025864" y="3474411"/>
              <a:ext cx="6827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/>
                <a:t>WT</a:t>
              </a:r>
              <a:endParaRPr lang="fr-FR" sz="1200" b="1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2657840" y="3458060"/>
              <a:ext cx="6827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/>
                <a:t>KO</a:t>
              </a:r>
              <a:endParaRPr lang="fr-FR" sz="1200" b="1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1315912" y="3693819"/>
              <a:ext cx="8355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/>
                <a:t>exercise</a:t>
              </a:r>
              <a:r>
                <a:rPr lang="fr-FR" sz="1200" dirty="0" smtClean="0"/>
                <a:t>:</a:t>
              </a:r>
              <a:endParaRPr lang="fr-FR" sz="12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2072492" y="3655565"/>
              <a:ext cx="14502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/>
                <a:t>   </a:t>
              </a:r>
              <a:r>
                <a:rPr lang="fr-FR" sz="1600" dirty="0" smtClean="0"/>
                <a:t>-     +   -    +</a:t>
              </a:r>
              <a:endParaRPr lang="fr-FR" sz="1000" dirty="0"/>
            </a:p>
          </p:txBody>
        </p:sp>
        <p:pic>
          <p:nvPicPr>
            <p:cNvPr id="51" name="Picture 7" descr="D:\Documents\redd1\métabolisme\exercice\exo 90'\Photos\GSK tot + 14-3-3.tiff"/>
            <p:cNvPicPr>
              <a:picLocks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081161" y="4694561"/>
              <a:ext cx="1144800" cy="187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2" name="ZoneTexte 51"/>
            <p:cNvSpPr txBox="1"/>
            <p:nvPr/>
          </p:nvSpPr>
          <p:spPr>
            <a:xfrm>
              <a:off x="1194205" y="4624991"/>
              <a:ext cx="904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dirty="0" smtClean="0"/>
                <a:t>α</a:t>
              </a:r>
              <a:r>
                <a:rPr lang="fr-FR" sz="1200" dirty="0" smtClean="0"/>
                <a:t>-</a:t>
              </a:r>
              <a:r>
                <a:rPr lang="fr-FR" sz="1200" dirty="0" err="1" smtClean="0"/>
                <a:t>tubulin</a:t>
              </a:r>
              <a:endParaRPr lang="fr-FR" sz="1200" dirty="0"/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2722305" y="3951329"/>
              <a:ext cx="828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32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2722305" y="4423235"/>
              <a:ext cx="828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2713554" y="4216150"/>
              <a:ext cx="828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2720092" y="4664309"/>
              <a:ext cx="828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5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9" name="Picture 4" descr="D:\Documents\Recherches et enseignements\redd1\jeûne\photos\4E-phospho bis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08" t="41181" r="56884" b="53977"/>
          <a:stretch/>
        </p:blipFill>
        <p:spPr bwMode="auto">
          <a:xfrm>
            <a:off x="2503247" y="1602284"/>
            <a:ext cx="597812" cy="2929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0" name="Picture 5" descr="D:\Documents\Recherches et enseignements\redd1\jeûne\photos\4EBP1 tot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43" t="27910" r="54349" b="68002"/>
          <a:stretch/>
        </p:blipFill>
        <p:spPr bwMode="auto">
          <a:xfrm>
            <a:off x="2503247" y="1943704"/>
            <a:ext cx="597812" cy="2473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1" name="ZoneTexte 80"/>
          <p:cNvSpPr txBox="1"/>
          <p:nvPr/>
        </p:nvSpPr>
        <p:spPr>
          <a:xfrm>
            <a:off x="1899562" y="1933132"/>
            <a:ext cx="642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EBP1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1476872" y="1608634"/>
            <a:ext cx="10679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EBP1 T37/46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1899065" y="2580199"/>
            <a:ext cx="642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1476375" y="2255701"/>
            <a:ext cx="10679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6 S240/244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7" name="Groupe 86"/>
          <p:cNvGrpSpPr/>
          <p:nvPr/>
        </p:nvGrpSpPr>
        <p:grpSpPr>
          <a:xfrm>
            <a:off x="2293779" y="787935"/>
            <a:ext cx="977960" cy="248920"/>
            <a:chOff x="1069146" y="921852"/>
            <a:chExt cx="977960" cy="248920"/>
          </a:xfrm>
        </p:grpSpPr>
        <p:sp>
          <p:nvSpPr>
            <p:cNvPr id="88" name="ZoneTexte 87"/>
            <p:cNvSpPr txBox="1"/>
            <p:nvPr/>
          </p:nvSpPr>
          <p:spPr>
            <a:xfrm>
              <a:off x="1069146" y="921852"/>
              <a:ext cx="682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1364324" y="924551"/>
              <a:ext cx="682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0" name="ZoneTexte 89"/>
          <p:cNvSpPr txBox="1"/>
          <p:nvPr/>
        </p:nvSpPr>
        <p:spPr>
          <a:xfrm>
            <a:off x="1709227" y="1036245"/>
            <a:ext cx="8355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sting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ZoneTexte 90"/>
          <p:cNvSpPr txBox="1"/>
          <p:nvPr/>
        </p:nvSpPr>
        <p:spPr>
          <a:xfrm>
            <a:off x="2422501" y="1023009"/>
            <a:ext cx="1450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     +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Connecteur droit 91"/>
          <p:cNvCxnSpPr/>
          <p:nvPr/>
        </p:nvCxnSpPr>
        <p:spPr>
          <a:xfrm>
            <a:off x="2530371" y="1047392"/>
            <a:ext cx="20826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Connecteur droit 92"/>
          <p:cNvCxnSpPr/>
          <p:nvPr/>
        </p:nvCxnSpPr>
        <p:spPr>
          <a:xfrm>
            <a:off x="2824208" y="1047392"/>
            <a:ext cx="20826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ZoneTexte 95"/>
          <p:cNvSpPr txBox="1"/>
          <p:nvPr/>
        </p:nvSpPr>
        <p:spPr>
          <a:xfrm>
            <a:off x="2566309" y="1638397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5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ZoneTexte 96"/>
          <p:cNvSpPr txBox="1"/>
          <p:nvPr/>
        </p:nvSpPr>
        <p:spPr>
          <a:xfrm>
            <a:off x="2566309" y="2606947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32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ZoneTexte 97"/>
          <p:cNvSpPr txBox="1"/>
          <p:nvPr/>
        </p:nvSpPr>
        <p:spPr>
          <a:xfrm>
            <a:off x="2566309" y="1961805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5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ZoneTexte 98"/>
          <p:cNvSpPr txBox="1"/>
          <p:nvPr/>
        </p:nvSpPr>
        <p:spPr>
          <a:xfrm>
            <a:off x="2572847" y="2288460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32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626340" y="74601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626803" y="3766765"/>
            <a:ext cx="2987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Rectangle 25"/>
          <p:cNvSpPr/>
          <p:nvPr/>
        </p:nvSpPr>
        <p:spPr>
          <a:xfrm>
            <a:off x="396255" y="6073021"/>
            <a:ext cx="6659809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4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DD1 KO mic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display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limited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decrease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Akt/mTORC1 signaling under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nergetic stress.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a) </a:t>
            </a:r>
            <a:r>
              <a:rPr lang="en-US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tibialis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anterior muscle was removed after a 16-h fasting (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=8/group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 b) Gastrocnemius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uscle was removed immediately after a 90 min bout of running exercise (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=6/group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.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ED, sedentary and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X, exercise group.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*p&lt;0.05 and ** p&lt;0.01 vs. corresponding WT group by unpaired t test; $$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p&lt;0.01 vs. corresponding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ED group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(same genotype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by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two-way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NOVA and Fisher post-hoc test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4" name="Groupe 3"/>
          <p:cNvGrpSpPr/>
          <p:nvPr/>
        </p:nvGrpSpPr>
        <p:grpSpPr>
          <a:xfrm>
            <a:off x="3945383" y="800813"/>
            <a:ext cx="4155728" cy="2016236"/>
            <a:chOff x="3945383" y="800813"/>
            <a:chExt cx="4155728" cy="2016236"/>
          </a:xfrm>
        </p:grpSpPr>
        <p:grpSp>
          <p:nvGrpSpPr>
            <p:cNvPr id="2" name="Groupe 1"/>
            <p:cNvGrpSpPr/>
            <p:nvPr/>
          </p:nvGrpSpPr>
          <p:grpSpPr>
            <a:xfrm>
              <a:off x="3945383" y="800813"/>
              <a:ext cx="2830711" cy="2016236"/>
              <a:chOff x="3945383" y="800813"/>
              <a:chExt cx="2830711" cy="2016236"/>
            </a:xfrm>
          </p:grpSpPr>
          <p:grpSp>
            <p:nvGrpSpPr>
              <p:cNvPr id="44" name="Groupe 43"/>
              <p:cNvGrpSpPr/>
              <p:nvPr/>
            </p:nvGrpSpPr>
            <p:grpSpPr>
              <a:xfrm>
                <a:off x="4124114" y="913423"/>
                <a:ext cx="2651980" cy="1903626"/>
                <a:chOff x="1771961" y="1909554"/>
                <a:chExt cx="2651980" cy="1903626"/>
              </a:xfrm>
            </p:grpSpPr>
            <p:graphicFrame>
              <p:nvGraphicFramePr>
                <p:cNvPr id="105" name="Graphique 10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14256589"/>
                    </p:ext>
                  </p:extLst>
                </p:nvPr>
              </p:nvGraphicFramePr>
              <p:xfrm>
                <a:off x="1771961" y="1909554"/>
                <a:ext cx="2647950" cy="164083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sp>
              <p:nvSpPr>
                <p:cNvPr id="106" name="ZoneTexte 2"/>
                <p:cNvSpPr txBox="1"/>
                <p:nvPr/>
              </p:nvSpPr>
              <p:spPr>
                <a:xfrm>
                  <a:off x="2552836" y="3383434"/>
                  <a:ext cx="825991" cy="429746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EBP1</a:t>
                  </a:r>
                </a:p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37/46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ZoneTexte 2"/>
                <p:cNvSpPr txBox="1"/>
                <p:nvPr/>
              </p:nvSpPr>
              <p:spPr>
                <a:xfrm>
                  <a:off x="3074019" y="3383434"/>
                  <a:ext cx="825991" cy="429746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6</a:t>
                  </a:r>
                </a:p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240/244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ZoneTexte 2"/>
                <p:cNvSpPr txBox="1"/>
                <p:nvPr/>
              </p:nvSpPr>
              <p:spPr>
                <a:xfrm>
                  <a:off x="3597950" y="3383434"/>
                  <a:ext cx="825991" cy="429746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ULK1</a:t>
                  </a:r>
                </a:p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757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ZoneTexte 2"/>
                <p:cNvSpPr txBox="1"/>
                <p:nvPr/>
              </p:nvSpPr>
              <p:spPr>
                <a:xfrm>
                  <a:off x="2014339" y="3383434"/>
                  <a:ext cx="825991" cy="429746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EBP1</a:t>
                  </a:r>
                </a:p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65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" name="Groupe 17"/>
              <p:cNvGrpSpPr/>
              <p:nvPr/>
            </p:nvGrpSpPr>
            <p:grpSpPr>
              <a:xfrm>
                <a:off x="3945383" y="800813"/>
                <a:ext cx="2351000" cy="1764102"/>
                <a:chOff x="3149695" y="3775402"/>
                <a:chExt cx="2351000" cy="1764102"/>
              </a:xfrm>
            </p:grpSpPr>
            <p:sp>
              <p:nvSpPr>
                <p:cNvPr id="75" name="ZoneTexte 2"/>
                <p:cNvSpPr txBox="1"/>
                <p:nvPr/>
              </p:nvSpPr>
              <p:spPr>
                <a:xfrm rot="16200000">
                  <a:off x="2459135" y="4506041"/>
                  <a:ext cx="1724023" cy="342903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to-</a:t>
                  </a:r>
                  <a:r>
                    <a:rPr lang="fr-F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oal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ZoneTexte 77"/>
                <p:cNvSpPr txBox="1"/>
                <p:nvPr/>
              </p:nvSpPr>
              <p:spPr>
                <a:xfrm>
                  <a:off x="4109301" y="3775402"/>
                  <a:ext cx="139139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asting</a:t>
                  </a:r>
                  <a:endParaRPr lang="fr-FR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ZoneTexte 93"/>
                <p:cNvSpPr txBox="1"/>
                <p:nvPr/>
              </p:nvSpPr>
              <p:spPr>
                <a:xfrm>
                  <a:off x="4295663" y="4535220"/>
                  <a:ext cx="5760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 smtClean="0"/>
                    <a:t>**</a:t>
                  </a:r>
                  <a:endParaRPr lang="fr-FR" sz="1000" b="1" dirty="0"/>
                </a:p>
              </p:txBody>
            </p:sp>
            <p:sp>
              <p:nvSpPr>
                <p:cNvPr id="95" name="ZoneTexte 94"/>
                <p:cNvSpPr txBox="1"/>
                <p:nvPr/>
              </p:nvSpPr>
              <p:spPr>
                <a:xfrm>
                  <a:off x="4829850" y="4053247"/>
                  <a:ext cx="5760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 smtClean="0"/>
                    <a:t>*</a:t>
                  </a:r>
                  <a:endParaRPr lang="fr-FR" sz="1000" b="1" dirty="0"/>
                </a:p>
              </p:txBody>
            </p:sp>
          </p:grpSp>
        </p:grpSp>
        <p:sp>
          <p:nvSpPr>
            <p:cNvPr id="100" name="Rectangle 99"/>
            <p:cNvSpPr/>
            <p:nvPr/>
          </p:nvSpPr>
          <p:spPr>
            <a:xfrm>
              <a:off x="6840901" y="1543914"/>
              <a:ext cx="119075" cy="1263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ysClr val="windowText" lastClr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04306" tIns="52153" rIns="104306" bIns="52153" rtlCol="0" anchor="t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fr-FR" sz="1300"/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6840901" y="1759938"/>
              <a:ext cx="119075" cy="1263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ysClr val="windowText" lastClr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04306" tIns="52153" rIns="104306" bIns="52153" rtlCol="0" anchor="t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fr-FR" sz="1300"/>
            </a:p>
          </p:txBody>
        </p:sp>
        <p:sp>
          <p:nvSpPr>
            <p:cNvPr id="102" name="ZoneTexte 51"/>
            <p:cNvSpPr txBox="1"/>
            <p:nvPr/>
          </p:nvSpPr>
          <p:spPr>
            <a:xfrm>
              <a:off x="6977422" y="1467827"/>
              <a:ext cx="1123689" cy="27847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lIns="104306" tIns="52153" rIns="104306" bIns="52153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ZoneTexte 53"/>
            <p:cNvSpPr txBox="1"/>
            <p:nvPr/>
          </p:nvSpPr>
          <p:spPr>
            <a:xfrm>
              <a:off x="6977423" y="1683851"/>
              <a:ext cx="1113187" cy="27847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lIns="104306" tIns="52153" rIns="104306" bIns="52153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fr-F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ZoneTexte 111"/>
            <p:cNvSpPr txBox="1"/>
            <p:nvPr/>
          </p:nvSpPr>
          <p:spPr>
            <a:xfrm>
              <a:off x="6152849" y="1040081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/>
                <a:t>*</a:t>
              </a:r>
              <a:endParaRPr lang="fr-FR" sz="1000" b="1" dirty="0"/>
            </a:p>
          </p:txBody>
        </p:sp>
      </p:grpSp>
      <p:sp>
        <p:nvSpPr>
          <p:cNvPr id="113" name="ZoneTexte 112"/>
          <p:cNvSpPr txBox="1"/>
          <p:nvPr/>
        </p:nvSpPr>
        <p:spPr>
          <a:xfrm>
            <a:off x="1476376" y="2931777"/>
            <a:ext cx="1053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LK1 S757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ZoneTexte 113"/>
          <p:cNvSpPr txBox="1"/>
          <p:nvPr/>
        </p:nvSpPr>
        <p:spPr>
          <a:xfrm>
            <a:off x="2713578" y="2959399"/>
            <a:ext cx="7687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50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ZoneTexte 114"/>
          <p:cNvSpPr txBox="1"/>
          <p:nvPr/>
        </p:nvSpPr>
        <p:spPr>
          <a:xfrm>
            <a:off x="1476375" y="3166291"/>
            <a:ext cx="1053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LK1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ZoneTexte 115"/>
          <p:cNvSpPr txBox="1"/>
          <p:nvPr/>
        </p:nvSpPr>
        <p:spPr>
          <a:xfrm>
            <a:off x="2713577" y="3193913"/>
            <a:ext cx="7687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50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ZoneTexte 116"/>
          <p:cNvSpPr txBox="1"/>
          <p:nvPr/>
        </p:nvSpPr>
        <p:spPr>
          <a:xfrm>
            <a:off x="1476375" y="1304727"/>
            <a:ext cx="10679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EBP1 S6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ZoneTexte 117"/>
          <p:cNvSpPr txBox="1"/>
          <p:nvPr/>
        </p:nvSpPr>
        <p:spPr>
          <a:xfrm>
            <a:off x="2565812" y="1334490"/>
            <a:ext cx="8280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5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799" b="29360"/>
          <a:stretch/>
        </p:blipFill>
        <p:spPr>
          <a:xfrm>
            <a:off x="2503802" y="1340111"/>
            <a:ext cx="591472" cy="216024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22"/>
          <a:stretch/>
        </p:blipFill>
        <p:spPr>
          <a:xfrm>
            <a:off x="2498683" y="2244860"/>
            <a:ext cx="592909" cy="277344"/>
          </a:xfrm>
          <a:prstGeom prst="rect">
            <a:avLst/>
          </a:prstGeom>
        </p:spPr>
      </p:pic>
      <p:pic>
        <p:nvPicPr>
          <p:cNvPr id="46" name="Image 4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8683" y="3224620"/>
            <a:ext cx="591312" cy="220980"/>
          </a:xfrm>
          <a:prstGeom prst="rect">
            <a:avLst/>
          </a:prstGeom>
        </p:spPr>
      </p:pic>
      <p:pic>
        <p:nvPicPr>
          <p:cNvPr id="47" name="Image 4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8944" y="2942893"/>
            <a:ext cx="612648" cy="217932"/>
          </a:xfrm>
          <a:prstGeom prst="rect">
            <a:avLst/>
          </a:prstGeom>
        </p:spPr>
      </p:pic>
      <p:pic>
        <p:nvPicPr>
          <p:cNvPr id="119" name="Image 118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209" t="8581" r="2624" b="16895"/>
          <a:stretch/>
        </p:blipFill>
        <p:spPr>
          <a:xfrm>
            <a:off x="2497811" y="2583087"/>
            <a:ext cx="593055" cy="314015"/>
          </a:xfrm>
          <a:prstGeom prst="rect">
            <a:avLst/>
          </a:prstGeom>
        </p:spPr>
      </p:pic>
      <p:graphicFrame>
        <p:nvGraphicFramePr>
          <p:cNvPr id="120" name="Graphique 1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7771287"/>
              </p:ext>
            </p:extLst>
          </p:nvPr>
        </p:nvGraphicFramePr>
        <p:xfrm>
          <a:off x="4208715" y="3766331"/>
          <a:ext cx="1096784" cy="2071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</p:spTree>
    <p:extLst>
      <p:ext uri="{BB962C8B-B14F-4D97-AF65-F5344CB8AC3E}">
        <p14:creationId xmlns:p14="http://schemas.microsoft.com/office/powerpoint/2010/main" val="3673543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6558" y="3339356"/>
            <a:ext cx="6982145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5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DD1 localizes in crude mitochondria after running exercise.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Gastrocnemius muscle was removed immediately after a 90 min bout of running exercise in WT mice. Cytosolic (C) and crude mitochondrial (M) fractions were separated for REDD1 protein expression measurement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18" name="Groupe 17"/>
          <p:cNvGrpSpPr/>
          <p:nvPr/>
        </p:nvGrpSpPr>
        <p:grpSpPr>
          <a:xfrm>
            <a:off x="2497777" y="1458268"/>
            <a:ext cx="2565708" cy="1371263"/>
            <a:chOff x="2497777" y="1458268"/>
            <a:chExt cx="2565708" cy="1371263"/>
          </a:xfrm>
        </p:grpSpPr>
        <p:grpSp>
          <p:nvGrpSpPr>
            <p:cNvPr id="3" name="Groupe 2"/>
            <p:cNvGrpSpPr/>
            <p:nvPr/>
          </p:nvGrpSpPr>
          <p:grpSpPr>
            <a:xfrm>
              <a:off x="2497777" y="1458268"/>
              <a:ext cx="2565708" cy="1367589"/>
              <a:chOff x="1422744" y="3618508"/>
              <a:chExt cx="2565708" cy="1367589"/>
            </a:xfrm>
          </p:grpSpPr>
          <p:grpSp>
            <p:nvGrpSpPr>
              <p:cNvPr id="7" name="Groupe 6"/>
              <p:cNvGrpSpPr/>
              <p:nvPr/>
            </p:nvGrpSpPr>
            <p:grpSpPr>
              <a:xfrm>
                <a:off x="1422744" y="3618508"/>
                <a:ext cx="2225840" cy="824083"/>
                <a:chOff x="3412990" y="4788024"/>
                <a:chExt cx="2225840" cy="824083"/>
              </a:xfrm>
            </p:grpSpPr>
            <p:pic>
              <p:nvPicPr>
                <p:cNvPr id="8" name="Picture 2" descr="D:\Documents\redd1\Dexamétasone\manip fractionnement cellulaire\5H\série 1 et 2 avril mai début juillet\photos\redd1.tiff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786" t="26953" r="28118" b="66194"/>
                <a:stretch/>
              </p:blipFill>
              <p:spPr bwMode="auto">
                <a:xfrm rot="10800000">
                  <a:off x="4486830" y="5402763"/>
                  <a:ext cx="1152000" cy="16284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9" name="ZoneTexte 8"/>
                <p:cNvSpPr txBox="1"/>
                <p:nvPr/>
              </p:nvSpPr>
              <p:spPr>
                <a:xfrm>
                  <a:off x="4508095" y="4994331"/>
                  <a:ext cx="5120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ZoneTexte 9"/>
                <p:cNvSpPr txBox="1"/>
                <p:nvPr/>
              </p:nvSpPr>
              <p:spPr>
                <a:xfrm>
                  <a:off x="5070614" y="4991964"/>
                  <a:ext cx="553570" cy="2331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ZoneTexte 10"/>
                <p:cNvSpPr txBox="1"/>
                <p:nvPr/>
              </p:nvSpPr>
              <p:spPr>
                <a:xfrm>
                  <a:off x="3412990" y="5200744"/>
                  <a:ext cx="108336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XERCISE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ZoneTexte 11"/>
                <p:cNvSpPr txBox="1"/>
                <p:nvPr/>
              </p:nvSpPr>
              <p:spPr>
                <a:xfrm>
                  <a:off x="4444949" y="5203143"/>
                  <a:ext cx="118664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-     +           -     +</a:t>
                  </a:r>
                  <a:endParaRPr lang="fr-FR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" name="Connecteur droit 12"/>
                <p:cNvCxnSpPr/>
                <p:nvPr/>
              </p:nvCxnSpPr>
              <p:spPr>
                <a:xfrm>
                  <a:off x="4512136" y="5184357"/>
                  <a:ext cx="50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Connecteur droit 13"/>
                <p:cNvCxnSpPr/>
                <p:nvPr/>
              </p:nvCxnSpPr>
              <p:spPr>
                <a:xfrm>
                  <a:off x="5095399" y="5186723"/>
                  <a:ext cx="50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Connecteur droit 14"/>
                <p:cNvCxnSpPr/>
                <p:nvPr/>
              </p:nvCxnSpPr>
              <p:spPr>
                <a:xfrm>
                  <a:off x="4508095" y="4989542"/>
                  <a:ext cx="108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ZoneTexte 91"/>
                <p:cNvSpPr txBox="1"/>
                <p:nvPr/>
              </p:nvSpPr>
              <p:spPr>
                <a:xfrm>
                  <a:off x="4755566" y="4788024"/>
                  <a:ext cx="589363" cy="1755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17" name="ZoneTexte 120"/>
                <p:cNvSpPr txBox="1">
                  <a:spLocks noChangeArrowheads="1"/>
                </p:cNvSpPr>
                <p:nvPr/>
              </p:nvSpPr>
              <p:spPr bwMode="auto">
                <a:xfrm>
                  <a:off x="3597499" y="5372298"/>
                  <a:ext cx="898856" cy="2398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 dirty="0">
                      <a:solidFill>
                        <a:schemeClr val="tx1"/>
                      </a:solidFill>
                      <a:latin typeface="Arial" charset="0"/>
                    </a:rPr>
                    <a:t>REDD1</a:t>
                  </a:r>
                </a:p>
              </p:txBody>
            </p:sp>
          </p:grpSp>
          <p:pic>
            <p:nvPicPr>
              <p:cNvPr id="1026" name="Picture 2" descr="E:\projet REDD\Exercice aigu\Exo 90min-florian\CS.tiff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97" t="46921" r="56400" b="40262"/>
              <a:stretch/>
            </p:blipFill>
            <p:spPr bwMode="auto">
              <a:xfrm>
                <a:off x="2496583" y="4466329"/>
                <a:ext cx="1152001" cy="20979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0" name="ZoneTexte 120"/>
              <p:cNvSpPr txBox="1">
                <a:spLocks noChangeArrowheads="1"/>
              </p:cNvSpPr>
              <p:nvPr/>
            </p:nvSpPr>
            <p:spPr bwMode="auto">
              <a:xfrm>
                <a:off x="1422744" y="4458819"/>
                <a:ext cx="108697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900" b="1" dirty="0" smtClean="0">
                    <a:latin typeface="Arial" charset="0"/>
                  </a:rPr>
                  <a:t>citrate synthase</a:t>
                </a:r>
                <a:endParaRPr lang="fr-FR" altLang="fr-FR" sz="900" b="1" dirty="0">
                  <a:solidFill>
                    <a:schemeClr val="tx1"/>
                  </a:solidFill>
                  <a:latin typeface="Arial" charset="0"/>
                </a:endParaRPr>
              </a:p>
            </p:txBody>
          </p:sp>
          <p:sp>
            <p:nvSpPr>
              <p:cNvPr id="21" name="ZoneTexte 120"/>
              <p:cNvSpPr txBox="1">
                <a:spLocks noChangeArrowheads="1"/>
              </p:cNvSpPr>
              <p:nvPr/>
            </p:nvSpPr>
            <p:spPr bwMode="auto">
              <a:xfrm>
                <a:off x="1423419" y="4755265"/>
                <a:ext cx="1086977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fr-FR" sz="900" b="1" dirty="0" smtClean="0">
                    <a:latin typeface="Arial" charset="0"/>
                  </a:rPr>
                  <a:t>α</a:t>
                </a:r>
                <a:r>
                  <a:rPr lang="fr-FR" altLang="fr-FR" sz="900" b="1" dirty="0" smtClean="0">
                    <a:latin typeface="Arial" charset="0"/>
                  </a:rPr>
                  <a:t>-</a:t>
                </a:r>
                <a:r>
                  <a:rPr lang="fr-FR" altLang="fr-FR" sz="900" b="1" dirty="0" err="1" smtClean="0">
                    <a:latin typeface="Arial" charset="0"/>
                  </a:rPr>
                  <a:t>tubulin</a:t>
                </a:r>
                <a:endParaRPr lang="fr-FR" altLang="fr-FR" sz="900" b="1" dirty="0">
                  <a:solidFill>
                    <a:schemeClr val="tx1"/>
                  </a:solidFill>
                  <a:latin typeface="Arial" charset="0"/>
                </a:endParaRP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3160360" y="4189208"/>
                <a:ext cx="8280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32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ZoneTexte 22"/>
              <p:cNvSpPr txBox="1"/>
              <p:nvPr/>
            </p:nvSpPr>
            <p:spPr>
              <a:xfrm>
                <a:off x="3160360" y="4755265"/>
                <a:ext cx="8280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5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>
                <a:off x="3151609" y="4454029"/>
                <a:ext cx="8280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50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" name="Imag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32" t="21648" r="57805" b="71214"/>
            <a:stretch/>
          </p:blipFill>
          <p:spPr>
            <a:xfrm>
              <a:off x="3579583" y="2588758"/>
              <a:ext cx="1135238" cy="24077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210587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3615556"/>
              </p:ext>
            </p:extLst>
          </p:nvPr>
        </p:nvGraphicFramePr>
        <p:xfrm>
          <a:off x="1258027" y="2129872"/>
          <a:ext cx="1567821" cy="1662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2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9327548"/>
              </p:ext>
            </p:extLst>
          </p:nvPr>
        </p:nvGraphicFramePr>
        <p:xfrm>
          <a:off x="2907441" y="2129872"/>
          <a:ext cx="1111367" cy="16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4" name="Graphique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1069752"/>
              </p:ext>
            </p:extLst>
          </p:nvPr>
        </p:nvGraphicFramePr>
        <p:xfrm>
          <a:off x="4676944" y="2129872"/>
          <a:ext cx="1564845" cy="16671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5" name="ZoneTexte 34"/>
          <p:cNvSpPr txBox="1"/>
          <p:nvPr/>
        </p:nvSpPr>
        <p:spPr>
          <a:xfrm>
            <a:off x="4761090" y="1809907"/>
            <a:ext cx="2619941" cy="259213"/>
          </a:xfrm>
          <a:prstGeom prst="rect">
            <a:avLst/>
          </a:prstGeom>
          <a:noFill/>
        </p:spPr>
        <p:txBody>
          <a:bodyPr wrap="square" lIns="104306" tIns="52153" rIns="104306" bIns="52153" rtlCol="0">
            <a:spAutoFit/>
          </a:bodyPr>
          <a:lstStyle/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12-mo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ZoneTexte 22"/>
          <p:cNvSpPr txBox="1"/>
          <p:nvPr/>
        </p:nvSpPr>
        <p:spPr>
          <a:xfrm rot="16200000">
            <a:off x="3615487" y="2661371"/>
            <a:ext cx="1779189" cy="41310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OCR</a:t>
            </a:r>
          </a:p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O</a:t>
            </a:r>
            <a:r>
              <a:rPr lang="fr-FR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/s/ mg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37" name="Graphique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5535297"/>
              </p:ext>
            </p:extLst>
          </p:nvPr>
        </p:nvGraphicFramePr>
        <p:xfrm>
          <a:off x="6257887" y="2129872"/>
          <a:ext cx="1095392" cy="16671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2" name="ZoneTexte 41"/>
          <p:cNvSpPr txBox="1"/>
          <p:nvPr/>
        </p:nvSpPr>
        <p:spPr>
          <a:xfrm>
            <a:off x="6566134" y="3487570"/>
            <a:ext cx="626608" cy="259213"/>
          </a:xfrm>
          <a:prstGeom prst="rect">
            <a:avLst/>
          </a:prstGeom>
          <a:solidFill>
            <a:schemeClr val="bg1"/>
          </a:solidFill>
        </p:spPr>
        <p:txBody>
          <a:bodyPr wrap="square" lIns="104306" tIns="52153" rIns="104306" bIns="52153" rtlCol="0">
            <a:spAutoFit/>
          </a:bodyPr>
          <a:lstStyle/>
          <a:p>
            <a:pPr algn="ctr"/>
            <a:r>
              <a:rPr lang="fr-FR" sz="1000" dirty="0"/>
              <a:t>RCR</a:t>
            </a:r>
          </a:p>
        </p:txBody>
      </p:sp>
      <p:sp>
        <p:nvSpPr>
          <p:cNvPr id="2" name="Rectangle 1"/>
          <p:cNvSpPr/>
          <p:nvPr/>
        </p:nvSpPr>
        <p:spPr>
          <a:xfrm>
            <a:off x="5278580" y="3549496"/>
            <a:ext cx="714529" cy="1349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ctr"/>
          <a:lstStyle/>
          <a:p>
            <a:pPr algn="ctr"/>
            <a:endParaRPr lang="fr-FR"/>
          </a:p>
        </p:txBody>
      </p:sp>
      <p:sp>
        <p:nvSpPr>
          <p:cNvPr id="44" name="ZoneTexte 43"/>
          <p:cNvSpPr txBox="1"/>
          <p:nvPr/>
        </p:nvSpPr>
        <p:spPr>
          <a:xfrm>
            <a:off x="5538383" y="3487570"/>
            <a:ext cx="656143" cy="259213"/>
          </a:xfrm>
          <a:prstGeom prst="rect">
            <a:avLst/>
          </a:prstGeom>
          <a:noFill/>
        </p:spPr>
        <p:txBody>
          <a:bodyPr wrap="square" lIns="104306" tIns="52153" rIns="104306" bIns="52153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tate 3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5098790" y="3487570"/>
            <a:ext cx="635137" cy="259213"/>
          </a:xfrm>
          <a:prstGeom prst="rect">
            <a:avLst/>
          </a:prstGeom>
          <a:noFill/>
        </p:spPr>
        <p:txBody>
          <a:bodyPr wrap="square" lIns="104306" tIns="52153" rIns="104306" bIns="52153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tate 4</a:t>
            </a:r>
          </a:p>
        </p:txBody>
      </p:sp>
      <p:sp>
        <p:nvSpPr>
          <p:cNvPr id="46" name="ZoneTexte 22"/>
          <p:cNvSpPr txBox="1"/>
          <p:nvPr/>
        </p:nvSpPr>
        <p:spPr>
          <a:xfrm rot="16200000">
            <a:off x="157256" y="2650577"/>
            <a:ext cx="1779189" cy="41310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OCR</a:t>
            </a:r>
          </a:p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O</a:t>
            </a:r>
            <a:r>
              <a:rPr lang="fr-FR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/s/ mg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" name="Rectangle 2"/>
          <p:cNvSpPr/>
          <p:nvPr/>
        </p:nvSpPr>
        <p:spPr>
          <a:xfrm>
            <a:off x="1954735" y="3549497"/>
            <a:ext cx="635137" cy="2080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ctr"/>
          <a:lstStyle/>
          <a:p>
            <a:pPr algn="ctr"/>
            <a:endParaRPr lang="fr-FR"/>
          </a:p>
        </p:txBody>
      </p:sp>
      <p:grpSp>
        <p:nvGrpSpPr>
          <p:cNvPr id="4" name="Groupe 3"/>
          <p:cNvGrpSpPr/>
          <p:nvPr/>
        </p:nvGrpSpPr>
        <p:grpSpPr>
          <a:xfrm>
            <a:off x="1707179" y="3487562"/>
            <a:ext cx="1095736" cy="246220"/>
            <a:chOff x="1124744" y="3333056"/>
            <a:chExt cx="993823" cy="210545"/>
          </a:xfrm>
        </p:grpSpPr>
        <p:sp>
          <p:nvSpPr>
            <p:cNvPr id="47" name="ZoneTexte 46"/>
            <p:cNvSpPr txBox="1"/>
            <p:nvPr/>
          </p:nvSpPr>
          <p:spPr>
            <a:xfrm>
              <a:off x="1523451" y="3333056"/>
              <a:ext cx="595116" cy="210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state 3</a:t>
              </a: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1124744" y="3333056"/>
              <a:ext cx="576064" cy="210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state 4</a:t>
              </a:r>
            </a:p>
          </p:txBody>
        </p:sp>
      </p:grpSp>
      <p:sp>
        <p:nvSpPr>
          <p:cNvPr id="64" name="ZoneTexte 63"/>
          <p:cNvSpPr txBox="1"/>
          <p:nvPr/>
        </p:nvSpPr>
        <p:spPr>
          <a:xfrm>
            <a:off x="3206025" y="3516145"/>
            <a:ext cx="626608" cy="259213"/>
          </a:xfrm>
          <a:prstGeom prst="rect">
            <a:avLst/>
          </a:prstGeom>
          <a:solidFill>
            <a:schemeClr val="bg1"/>
          </a:solidFill>
        </p:spPr>
        <p:txBody>
          <a:bodyPr wrap="square" lIns="104306" tIns="52153" rIns="104306" bIns="52153" rtlCol="0">
            <a:spAutoFit/>
          </a:bodyPr>
          <a:lstStyle/>
          <a:p>
            <a:pPr algn="ctr"/>
            <a:r>
              <a:rPr lang="fr-FR" sz="1000" dirty="0"/>
              <a:t>RCR</a:t>
            </a:r>
          </a:p>
        </p:txBody>
      </p:sp>
      <p:sp>
        <p:nvSpPr>
          <p:cNvPr id="77" name="ZoneTexte 76"/>
          <p:cNvSpPr txBox="1"/>
          <p:nvPr/>
        </p:nvSpPr>
        <p:spPr>
          <a:xfrm>
            <a:off x="1448722" y="1809907"/>
            <a:ext cx="2619941" cy="259213"/>
          </a:xfrm>
          <a:prstGeom prst="rect">
            <a:avLst/>
          </a:prstGeom>
          <a:noFill/>
        </p:spPr>
        <p:txBody>
          <a:bodyPr wrap="square" lIns="104306" tIns="52153" rIns="104306" bIns="52153" rtlCol="0">
            <a:spAutoFit/>
          </a:bodyPr>
          <a:lstStyle/>
          <a:p>
            <a:pPr algn="ctr"/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-mo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8" name="Graphique 7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7025489"/>
              </p:ext>
            </p:extLst>
          </p:nvPr>
        </p:nvGraphicFramePr>
        <p:xfrm>
          <a:off x="1258027" y="4505565"/>
          <a:ext cx="1567821" cy="1662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9" name="Graphique 7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54328"/>
              </p:ext>
            </p:extLst>
          </p:nvPr>
        </p:nvGraphicFramePr>
        <p:xfrm>
          <a:off x="2907441" y="4505565"/>
          <a:ext cx="1111367" cy="16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82" name="Groupe 81"/>
          <p:cNvGrpSpPr/>
          <p:nvPr/>
        </p:nvGrpSpPr>
        <p:grpSpPr>
          <a:xfrm>
            <a:off x="5239908" y="4663517"/>
            <a:ext cx="1081273" cy="935812"/>
            <a:chOff x="6774525" y="508029"/>
            <a:chExt cx="1020207" cy="945570"/>
          </a:xfrm>
        </p:grpSpPr>
        <p:sp>
          <p:nvSpPr>
            <p:cNvPr id="83" name="Rectangle 82"/>
            <p:cNvSpPr/>
            <p:nvPr/>
          </p:nvSpPr>
          <p:spPr>
            <a:xfrm>
              <a:off x="6876256" y="508029"/>
              <a:ext cx="918476" cy="94557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Aft>
                  <a:spcPts val="456"/>
                </a:spcAft>
              </a:pP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-CTRL</a:t>
              </a:r>
            </a:p>
            <a:p>
              <a:pPr>
                <a:spcAft>
                  <a:spcPts val="456"/>
                </a:spcAft>
              </a:pP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-DEX</a:t>
              </a:r>
            </a:p>
            <a:p>
              <a:pPr>
                <a:spcAft>
                  <a:spcPts val="456"/>
                </a:spcAft>
              </a:pP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O-CTRL</a:t>
              </a:r>
            </a:p>
            <a:p>
              <a:pPr>
                <a:spcAft>
                  <a:spcPts val="456"/>
                </a:spcAft>
              </a:pP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KO-DEX</a:t>
              </a: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6774525" y="590208"/>
              <a:ext cx="112350" cy="12761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6774525" y="1022495"/>
              <a:ext cx="112350" cy="127617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6774525" y="818044"/>
              <a:ext cx="112350" cy="127617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7" name="Rectangle 86"/>
            <p:cNvSpPr/>
            <p:nvPr/>
          </p:nvSpPr>
          <p:spPr>
            <a:xfrm>
              <a:off x="6774525" y="1259654"/>
              <a:ext cx="112350" cy="12761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88" name="ZoneTexte 87"/>
          <p:cNvSpPr txBox="1"/>
          <p:nvPr/>
        </p:nvSpPr>
        <p:spPr>
          <a:xfrm>
            <a:off x="1376714" y="4156769"/>
            <a:ext cx="2619941" cy="259213"/>
          </a:xfrm>
          <a:prstGeom prst="rect">
            <a:avLst/>
          </a:prstGeom>
          <a:noFill/>
        </p:spPr>
        <p:txBody>
          <a:bodyPr wrap="square" lIns="104306" tIns="52153" rIns="104306" bIns="52153" rtlCol="0">
            <a:spAutoFit/>
          </a:bodyPr>
          <a:lstStyle/>
          <a:p>
            <a:pPr algn="ctr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6-mo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507735" y="1592593"/>
            <a:ext cx="289197" cy="274602"/>
          </a:xfrm>
          <a:prstGeom prst="rect">
            <a:avLst/>
          </a:prstGeom>
          <a:noFill/>
        </p:spPr>
        <p:txBody>
          <a:bodyPr wrap="none" lIns="104306" tIns="52153" rIns="104306" bIns="52153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9" name="ZoneTexte 88"/>
          <p:cNvSpPr txBox="1"/>
          <p:nvPr/>
        </p:nvSpPr>
        <p:spPr>
          <a:xfrm>
            <a:off x="507735" y="4003801"/>
            <a:ext cx="297211" cy="274602"/>
          </a:xfrm>
          <a:prstGeom prst="rect">
            <a:avLst/>
          </a:prstGeom>
          <a:noFill/>
        </p:spPr>
        <p:txBody>
          <a:bodyPr wrap="none" lIns="104306" tIns="52153" rIns="104306" bIns="52153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3" name="ZoneTexte 22"/>
          <p:cNvSpPr txBox="1"/>
          <p:nvPr/>
        </p:nvSpPr>
        <p:spPr>
          <a:xfrm rot="16200000">
            <a:off x="-56107" y="5027183"/>
            <a:ext cx="1779189" cy="41310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lIns="104306" tIns="52153" rIns="104306" bIns="52153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OCR</a:t>
            </a:r>
          </a:p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O</a:t>
            </a:r>
            <a:r>
              <a:rPr lang="fr-FR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/s/ mg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4" name="ZoneTexte 93"/>
          <p:cNvSpPr txBox="1"/>
          <p:nvPr/>
        </p:nvSpPr>
        <p:spPr>
          <a:xfrm>
            <a:off x="3176942" y="5888829"/>
            <a:ext cx="689269" cy="259213"/>
          </a:xfrm>
          <a:prstGeom prst="rect">
            <a:avLst/>
          </a:prstGeom>
          <a:solidFill>
            <a:schemeClr val="bg1"/>
          </a:solidFill>
        </p:spPr>
        <p:txBody>
          <a:bodyPr wrap="square" lIns="104306" tIns="52153" rIns="104306" bIns="52153" rtlCol="0">
            <a:spAutoFit/>
          </a:bodyPr>
          <a:lstStyle/>
          <a:p>
            <a:pPr algn="ctr"/>
            <a:r>
              <a:rPr lang="fr-FR" sz="1000" dirty="0"/>
              <a:t>RCR</a:t>
            </a:r>
          </a:p>
        </p:txBody>
      </p:sp>
      <p:sp>
        <p:nvSpPr>
          <p:cNvPr id="6" name="Rectangle 5"/>
          <p:cNvSpPr/>
          <p:nvPr/>
        </p:nvSpPr>
        <p:spPr>
          <a:xfrm>
            <a:off x="1933729" y="5869778"/>
            <a:ext cx="656144" cy="2535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04306" tIns="52153" rIns="104306" bIns="52153" rtlCol="0" anchor="ctr"/>
          <a:lstStyle/>
          <a:p>
            <a:pPr algn="ctr"/>
            <a:endParaRPr lang="fr-FR"/>
          </a:p>
        </p:txBody>
      </p:sp>
      <p:grpSp>
        <p:nvGrpSpPr>
          <p:cNvPr id="90" name="Groupe 89"/>
          <p:cNvGrpSpPr/>
          <p:nvPr/>
        </p:nvGrpSpPr>
        <p:grpSpPr>
          <a:xfrm>
            <a:off x="1686404" y="5869771"/>
            <a:ext cx="1095736" cy="246220"/>
            <a:chOff x="1124744" y="3333056"/>
            <a:chExt cx="993823" cy="210545"/>
          </a:xfrm>
        </p:grpSpPr>
        <p:sp>
          <p:nvSpPr>
            <p:cNvPr id="91" name="ZoneTexte 90"/>
            <p:cNvSpPr txBox="1"/>
            <p:nvPr/>
          </p:nvSpPr>
          <p:spPr>
            <a:xfrm>
              <a:off x="1523451" y="3333056"/>
              <a:ext cx="595116" cy="210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state 3</a:t>
              </a:r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1124744" y="3333056"/>
              <a:ext cx="576064" cy="210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state 4</a:t>
              </a:r>
            </a:p>
          </p:txBody>
        </p:sp>
      </p:grpSp>
      <p:sp>
        <p:nvSpPr>
          <p:cNvPr id="9" name="Rectangle 8"/>
          <p:cNvSpPr/>
          <p:nvPr/>
        </p:nvSpPr>
        <p:spPr>
          <a:xfrm>
            <a:off x="324248" y="6720745"/>
            <a:ext cx="6868494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6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DD1 deletion does not alter respiration capacity of isolated mitochondria.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) O</a:t>
            </a:r>
            <a:r>
              <a:rPr lang="en-US" sz="1100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sumption rate (OCR) and respiratory control ratio (RCR; i.e. state3-to-state4 ratio) of skeletal muscle mitochondria in 6-mo old and 12-mo old REDD1 KO and WT mice (n=3/group). b) O</a:t>
            </a:r>
            <a:r>
              <a:rPr lang="en-US" sz="1100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onsumption rate and respiratory control ratio of skeletal muscle mitochondria in REDD1 KO and WT mice acutely treated with dexamethasone (DEX; 1 mg/kg; n=4/group). Respiration was recorded in presence of carbohydrates (glutamate + malate and succinate)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9601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681887" y="1242244"/>
            <a:ext cx="6126980" cy="2376264"/>
            <a:chOff x="252239" y="3546500"/>
            <a:chExt cx="6126980" cy="2376264"/>
          </a:xfrm>
        </p:grpSpPr>
        <p:graphicFrame>
          <p:nvGraphicFramePr>
            <p:cNvPr id="30" name="Graphique 2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65575180"/>
                </p:ext>
              </p:extLst>
            </p:nvPr>
          </p:nvGraphicFramePr>
          <p:xfrm>
            <a:off x="5013151" y="3762524"/>
            <a:ext cx="1366068" cy="18573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ZoneTexte 1"/>
            <p:cNvSpPr txBox="1"/>
            <p:nvPr/>
          </p:nvSpPr>
          <p:spPr>
            <a:xfrm>
              <a:off x="5371093" y="3546500"/>
              <a:ext cx="82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4797127" y="5490716"/>
              <a:ext cx="15460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GFP     +      -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ZoneTexte 33"/>
            <p:cNvSpPr txBox="1"/>
            <p:nvPr/>
          </p:nvSpPr>
          <p:spPr>
            <a:xfrm>
              <a:off x="704773" y="4786569"/>
              <a:ext cx="82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ZoneTexte 34"/>
            <p:cNvSpPr txBox="1"/>
            <p:nvPr/>
          </p:nvSpPr>
          <p:spPr>
            <a:xfrm>
              <a:off x="704773" y="4482604"/>
              <a:ext cx="82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DD1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252239" y="4194572"/>
              <a:ext cx="1283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REDD1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252239" y="4020359"/>
              <a:ext cx="1283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GFP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1570965" y="4004970"/>
              <a:ext cx="23077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    -    +     -      +    -     +     -    +</a:t>
              </a:r>
              <a:endParaRPr lang="fr-F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1586483" y="4194572"/>
              <a:ext cx="23077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    +    -     +      -    +     -     +    -</a:t>
              </a:r>
              <a:endParaRPr lang="fr-FR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4644727" y="5676543"/>
              <a:ext cx="15460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V-REDD1     -      +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2" descr="E:\projet REDD\AAV-REDD1\REDD1+CitSynt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80" t="60071" r="8377" b="26709"/>
            <a:stretch/>
          </p:blipFill>
          <p:spPr bwMode="auto">
            <a:xfrm>
              <a:off x="1531790" y="4775323"/>
              <a:ext cx="2307784" cy="27402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2" descr="E:\projet REDD\AAV-REDD1\REDD1+CitSynt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80" t="76272" r="8377" b="7529"/>
            <a:stretch/>
          </p:blipFill>
          <p:spPr bwMode="auto">
            <a:xfrm>
              <a:off x="1535239" y="4393027"/>
              <a:ext cx="2307784" cy="335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ZoneTexte 16"/>
            <p:cNvSpPr txBox="1"/>
            <p:nvPr/>
          </p:nvSpPr>
          <p:spPr>
            <a:xfrm>
              <a:off x="3331331" y="4419222"/>
              <a:ext cx="828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32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3331331" y="4755828"/>
              <a:ext cx="828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5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3334318" y="4139538"/>
              <a:ext cx="828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396775" y="4060572"/>
            <a:ext cx="6624216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7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DD1 overexpression does not alter citrate synthase protein expression.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Representative blots of citrate synthase (CS) and REDD1 and corresponding quantification (CS) in AAV-GFP and AAV-REDD1 injected muscles from WT mice. </a:t>
            </a:r>
            <a:r>
              <a:rPr lang="en-US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ibialis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terior was removed 3 weeks after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injection (n=9/group)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3711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e 45"/>
          <p:cNvGrpSpPr/>
          <p:nvPr/>
        </p:nvGrpSpPr>
        <p:grpSpPr>
          <a:xfrm>
            <a:off x="756295" y="2970436"/>
            <a:ext cx="4951316" cy="5269644"/>
            <a:chOff x="756295" y="3186460"/>
            <a:chExt cx="4951316" cy="5269644"/>
          </a:xfrm>
        </p:grpSpPr>
        <p:sp>
          <p:nvSpPr>
            <p:cNvPr id="5" name="ZoneTexte 4"/>
            <p:cNvSpPr txBox="1"/>
            <p:nvPr/>
          </p:nvSpPr>
          <p:spPr>
            <a:xfrm>
              <a:off x="782720" y="5219411"/>
              <a:ext cx="1174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AS40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776987" y="3985887"/>
              <a:ext cx="11799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 II </a:t>
              </a:r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nly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775173" y="6477854"/>
              <a:ext cx="11817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756295" y="7724078"/>
              <a:ext cx="12006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DAC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Imag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93" t="14770" r="16908" b="24131"/>
            <a:stretch/>
          </p:blipFill>
          <p:spPr>
            <a:xfrm rot="16200000">
              <a:off x="3216009" y="4732174"/>
              <a:ext cx="1205927" cy="1205929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91" t="14917" r="16925" b="23799"/>
            <a:stretch/>
          </p:blipFill>
          <p:spPr>
            <a:xfrm rot="16200000">
              <a:off x="4501683" y="4734683"/>
              <a:ext cx="1205927" cy="1205929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05" t="26442" r="2096" b="12459"/>
            <a:stretch/>
          </p:blipFill>
          <p:spPr>
            <a:xfrm rot="16200000">
              <a:off x="1929718" y="3481429"/>
              <a:ext cx="1205927" cy="1205929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94" t="27563" r="3678" b="11808"/>
            <a:stretch/>
          </p:blipFill>
          <p:spPr>
            <a:xfrm rot="16200000">
              <a:off x="3216009" y="3481264"/>
              <a:ext cx="1205927" cy="1205929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0" t="27833" r="3422" b="11538"/>
            <a:stretch/>
          </p:blipFill>
          <p:spPr>
            <a:xfrm rot="16200000">
              <a:off x="4501683" y="3481264"/>
              <a:ext cx="1205927" cy="1205929"/>
            </a:xfrm>
            <a:prstGeom prst="rect">
              <a:avLst/>
            </a:prstGeom>
          </p:spPr>
        </p:pic>
        <p:pic>
          <p:nvPicPr>
            <p:cNvPr id="14" name="Image 1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75" t="28815" r="34426" b="10086"/>
            <a:stretch/>
          </p:blipFill>
          <p:spPr>
            <a:xfrm rot="16200000">
              <a:off x="3216009" y="5986648"/>
              <a:ext cx="1205927" cy="1205929"/>
            </a:xfrm>
            <a:prstGeom prst="rect">
              <a:avLst/>
            </a:prstGeom>
          </p:spPr>
        </p:pic>
        <p:pic>
          <p:nvPicPr>
            <p:cNvPr id="15" name="Image 1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7" t="29784" r="34114" b="9117"/>
            <a:stretch/>
          </p:blipFill>
          <p:spPr>
            <a:xfrm rot="16200000">
              <a:off x="4501683" y="5978361"/>
              <a:ext cx="1205927" cy="1205929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41" t="21589" r="25560" b="17312"/>
            <a:stretch/>
          </p:blipFill>
          <p:spPr>
            <a:xfrm rot="16200000">
              <a:off x="3216009" y="7250176"/>
              <a:ext cx="1205927" cy="1205929"/>
            </a:xfrm>
            <a:prstGeom prst="rect">
              <a:avLst/>
            </a:prstGeom>
          </p:spPr>
        </p:pic>
        <p:pic>
          <p:nvPicPr>
            <p:cNvPr id="17" name="Image 16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41" t="21589" r="25560" b="17312"/>
            <a:stretch/>
          </p:blipFill>
          <p:spPr>
            <a:xfrm rot="16200000">
              <a:off x="4501683" y="7250175"/>
              <a:ext cx="1205927" cy="1205929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96" t="14247" r="16194" b="24543"/>
            <a:stretch/>
          </p:blipFill>
          <p:spPr>
            <a:xfrm rot="16200000">
              <a:off x="1929718" y="4728824"/>
              <a:ext cx="1205927" cy="1205929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2" t="20873" r="23478" b="17964"/>
            <a:stretch/>
          </p:blipFill>
          <p:spPr>
            <a:xfrm rot="16200000">
              <a:off x="1929182" y="7249104"/>
              <a:ext cx="1206999" cy="1207001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44" t="28244" r="32946" b="10548"/>
            <a:stretch/>
          </p:blipFill>
          <p:spPr>
            <a:xfrm rot="16200000">
              <a:off x="1929183" y="5984794"/>
              <a:ext cx="1206998" cy="1207000"/>
            </a:xfrm>
            <a:prstGeom prst="rect">
              <a:avLst/>
            </a:prstGeom>
          </p:spPr>
        </p:pic>
        <p:cxnSp>
          <p:nvCxnSpPr>
            <p:cNvPr id="21" name="Connecteur droit 20"/>
            <p:cNvCxnSpPr/>
            <p:nvPr/>
          </p:nvCxnSpPr>
          <p:spPr>
            <a:xfrm>
              <a:off x="2919149" y="7105089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21"/>
            <p:cNvCxnSpPr/>
            <p:nvPr/>
          </p:nvCxnSpPr>
          <p:spPr>
            <a:xfrm>
              <a:off x="4189513" y="7085474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cteur droit 22"/>
            <p:cNvCxnSpPr/>
            <p:nvPr/>
          </p:nvCxnSpPr>
          <p:spPr>
            <a:xfrm>
              <a:off x="5485022" y="7082420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23"/>
            <p:cNvCxnSpPr/>
            <p:nvPr/>
          </p:nvCxnSpPr>
          <p:spPr>
            <a:xfrm>
              <a:off x="2918279" y="5857014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24"/>
            <p:cNvCxnSpPr/>
            <p:nvPr/>
          </p:nvCxnSpPr>
          <p:spPr>
            <a:xfrm>
              <a:off x="2916535" y="4607478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/>
            <p:cNvCxnSpPr/>
            <p:nvPr/>
          </p:nvCxnSpPr>
          <p:spPr>
            <a:xfrm>
              <a:off x="4188645" y="5837399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26"/>
            <p:cNvCxnSpPr/>
            <p:nvPr/>
          </p:nvCxnSpPr>
          <p:spPr>
            <a:xfrm>
              <a:off x="4186900" y="4587864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eur droit 27"/>
            <p:cNvCxnSpPr/>
            <p:nvPr/>
          </p:nvCxnSpPr>
          <p:spPr>
            <a:xfrm>
              <a:off x="5484152" y="5834345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cteur droit 28"/>
            <p:cNvCxnSpPr/>
            <p:nvPr/>
          </p:nvCxnSpPr>
          <p:spPr>
            <a:xfrm>
              <a:off x="5482409" y="4584809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eur droit avec flèche 29"/>
            <p:cNvCxnSpPr/>
            <p:nvPr/>
          </p:nvCxnSpPr>
          <p:spPr>
            <a:xfrm rot="16200000" flipH="1">
              <a:off x="2379278" y="6402787"/>
              <a:ext cx="64807" cy="6480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cteur droit avec flèche 30"/>
            <p:cNvCxnSpPr/>
            <p:nvPr/>
          </p:nvCxnSpPr>
          <p:spPr>
            <a:xfrm rot="16200000">
              <a:off x="2549777" y="6689795"/>
              <a:ext cx="64807" cy="6480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cteur droit avec flèche 31"/>
            <p:cNvCxnSpPr/>
            <p:nvPr/>
          </p:nvCxnSpPr>
          <p:spPr>
            <a:xfrm rot="16200000" flipH="1">
              <a:off x="2357865" y="5149995"/>
              <a:ext cx="64807" cy="6480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cteur droit avec flèche 32"/>
            <p:cNvCxnSpPr/>
            <p:nvPr/>
          </p:nvCxnSpPr>
          <p:spPr>
            <a:xfrm rot="16200000">
              <a:off x="2467773" y="5486704"/>
              <a:ext cx="64807" cy="6480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ZoneTexte 33"/>
            <p:cNvSpPr txBox="1"/>
            <p:nvPr/>
          </p:nvSpPr>
          <p:spPr>
            <a:xfrm>
              <a:off x="1135385" y="3186460"/>
              <a:ext cx="3553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35" name="Connecteur droit 34"/>
            <p:cNvCxnSpPr/>
            <p:nvPr/>
          </p:nvCxnSpPr>
          <p:spPr>
            <a:xfrm>
              <a:off x="2916535" y="8401233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35"/>
            <p:cNvCxnSpPr/>
            <p:nvPr/>
          </p:nvCxnSpPr>
          <p:spPr>
            <a:xfrm>
              <a:off x="4186899" y="8381618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cteur droit 36"/>
            <p:cNvCxnSpPr/>
            <p:nvPr/>
          </p:nvCxnSpPr>
          <p:spPr>
            <a:xfrm>
              <a:off x="5482408" y="8378564"/>
              <a:ext cx="131584" cy="0"/>
            </a:xfrm>
            <a:prstGeom prst="line">
              <a:avLst/>
            </a:prstGeom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ZoneTexte 37"/>
            <p:cNvSpPr txBox="1"/>
            <p:nvPr/>
          </p:nvSpPr>
          <p:spPr>
            <a:xfrm>
              <a:off x="1945194" y="3271698"/>
              <a:ext cx="11904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ntibody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3216007" y="3235209"/>
              <a:ext cx="12054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totracker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4501682" y="3235043"/>
              <a:ext cx="1205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verlap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ZoneTexte 40"/>
          <p:cNvSpPr txBox="1"/>
          <p:nvPr/>
        </p:nvSpPr>
        <p:spPr>
          <a:xfrm>
            <a:off x="1135385" y="275943"/>
            <a:ext cx="3553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506607" y="8443044"/>
            <a:ext cx="6624216" cy="1869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Fig.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8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fr-FR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RAS40 and mTOR </a:t>
            </a:r>
            <a:r>
              <a:rPr lang="fr-FR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localizes</a:t>
            </a:r>
            <a:r>
              <a:rPr lang="fr-FR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n the </a:t>
            </a:r>
            <a:r>
              <a:rPr lang="fr-FR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ude</a:t>
            </a:r>
            <a:r>
              <a:rPr lang="fr-FR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itochondrial fraction </a:t>
            </a:r>
            <a:r>
              <a:rPr lang="fr-FR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rom</a:t>
            </a:r>
            <a:r>
              <a:rPr lang="fr-FR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eletal</a:t>
            </a:r>
            <a:r>
              <a:rPr lang="fr-FR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uscle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a) representative images of crude mitochondria isolated from fresh muscle by transmission electronic microscopy (</a:t>
            </a:r>
            <a:r>
              <a:rPr lang="fr-FR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cale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bars: 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500 nm)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b) Immunofluorescence </a:t>
            </a:r>
            <a:r>
              <a:rPr lang="fr-FR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with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rude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tochondria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solat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rom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eletal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uscle of DEX-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reat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c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using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ti-VDAC, anti-mTOR or anti-PRAS40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ntibodie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Living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tochondria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er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irst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tain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ith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totracker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efor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eing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ix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ith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araformaldehyd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2% and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rocess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or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mmunostaining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Voltage-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ependent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ion-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elective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hannel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VDAC)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a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used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s positive control. </a:t>
            </a:r>
            <a:r>
              <a:rPr lang="fr-FR" sz="11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rrows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oint to 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mTOR 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r PRAS40 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pots (</a:t>
            </a:r>
            <a:r>
              <a:rPr lang="fr-FR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cale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fr-FR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bars: 3 </a:t>
            </a:r>
            <a:r>
              <a:rPr lang="fr-FR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µm)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8811" y="600665"/>
            <a:ext cx="2066925" cy="2066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Image 2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2639" y="591203"/>
            <a:ext cx="2076450" cy="2076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0"/>
            <a:ext cx="756126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44" name="Rectangle 4"/>
          <p:cNvSpPr>
            <a:spLocks noChangeArrowheads="1"/>
          </p:cNvSpPr>
          <p:nvPr/>
        </p:nvSpPr>
        <p:spPr bwMode="auto">
          <a:xfrm>
            <a:off x="0" y="2524125"/>
            <a:ext cx="7561263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smtClean="0">
                <a:ln>
                  <a:noFill/>
                </a:ln>
                <a:solidFill>
                  <a:srgbClr val="FF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endParaRPr kumimoji="0" lang="en-US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" name="Rectangle 5"/>
          <p:cNvSpPr>
            <a:spLocks noChangeArrowheads="1"/>
          </p:cNvSpPr>
          <p:nvPr/>
        </p:nvSpPr>
        <p:spPr bwMode="auto">
          <a:xfrm>
            <a:off x="0" y="4600575"/>
            <a:ext cx="7561263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08879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515516"/>
              </p:ext>
            </p:extLst>
          </p:nvPr>
        </p:nvGraphicFramePr>
        <p:xfrm>
          <a:off x="3788491" y="1314252"/>
          <a:ext cx="1296000" cy="1563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6" name="Groupe 5"/>
          <p:cNvGrpSpPr/>
          <p:nvPr/>
        </p:nvGrpSpPr>
        <p:grpSpPr>
          <a:xfrm>
            <a:off x="5623873" y="1849225"/>
            <a:ext cx="1253102" cy="493343"/>
            <a:chOff x="5754254" y="1132675"/>
            <a:chExt cx="1253102" cy="493343"/>
          </a:xfrm>
        </p:grpSpPr>
        <p:sp>
          <p:nvSpPr>
            <p:cNvPr id="7" name="ZoneTexte 6"/>
            <p:cNvSpPr txBox="1"/>
            <p:nvPr/>
          </p:nvSpPr>
          <p:spPr>
            <a:xfrm>
              <a:off x="5828305" y="1132675"/>
              <a:ext cx="11790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5757861" y="1196703"/>
              <a:ext cx="108000" cy="97241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5754254" y="1467328"/>
              <a:ext cx="108000" cy="97241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5808254" y="1395186"/>
              <a:ext cx="11790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DD1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ZoneTexte 10"/>
          <p:cNvSpPr txBox="1"/>
          <p:nvPr/>
        </p:nvSpPr>
        <p:spPr>
          <a:xfrm>
            <a:off x="3698148" y="1061841"/>
            <a:ext cx="16995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uromycin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incorporation</a:t>
            </a:r>
          </a:p>
        </p:txBody>
      </p:sp>
      <p:sp>
        <p:nvSpPr>
          <p:cNvPr id="12" name="ZoneTexte 11"/>
          <p:cNvSpPr txBox="1"/>
          <p:nvPr/>
        </p:nvSpPr>
        <p:spPr>
          <a:xfrm rot="16200000">
            <a:off x="3000725" y="1847153"/>
            <a:ext cx="1324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% of control group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3829786" y="2646711"/>
            <a:ext cx="12547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fr-F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go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-           +</a:t>
            </a:r>
            <a:endParaRPr lang="fr-F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Connecteur droit 13"/>
          <p:cNvCxnSpPr/>
          <p:nvPr/>
        </p:nvCxnSpPr>
        <p:spPr>
          <a:xfrm rot="16200000">
            <a:off x="4335472" y="2559321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 rot="16200000">
            <a:off x="4745472" y="2555305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396775" y="3186460"/>
            <a:ext cx="6624216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sz="11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Fig. 9. Protein synthesis under energetic stress in human myoblasts depleted for REDD1.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Cells were grown in a serum-free media containing glucose 10mM and treated or not with </a:t>
            </a:r>
            <a:r>
              <a:rPr lang="en-US" sz="11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oligomycin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2 µM for 6h. </a:t>
            </a:r>
            <a:r>
              <a:rPr lang="en-US" sz="11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=3/group from three separate cultures.</a:t>
            </a:r>
            <a:endParaRPr lang="fr-FR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2986" y="1102610"/>
            <a:ext cx="2503049" cy="1954894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>
            <a:off x="121367" y="1043154"/>
            <a:ext cx="128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igo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1524942" y="1026220"/>
            <a:ext cx="23077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      +         -         +    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necteur droit 18"/>
          <p:cNvCxnSpPr/>
          <p:nvPr/>
        </p:nvCxnSpPr>
        <p:spPr>
          <a:xfrm>
            <a:off x="1476375" y="1242244"/>
            <a:ext cx="288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>
            <a:off x="1903095" y="1242244"/>
            <a:ext cx="288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/>
          <p:cNvCxnSpPr/>
          <p:nvPr/>
        </p:nvCxnSpPr>
        <p:spPr>
          <a:xfrm>
            <a:off x="2307370" y="1242244"/>
            <a:ext cx="288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/>
          <p:cNvCxnSpPr/>
          <p:nvPr/>
        </p:nvCxnSpPr>
        <p:spPr>
          <a:xfrm>
            <a:off x="2719002" y="1242244"/>
            <a:ext cx="288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121367" y="1242244"/>
            <a:ext cx="128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Connecteur droit 24"/>
          <p:cNvCxnSpPr/>
          <p:nvPr/>
        </p:nvCxnSpPr>
        <p:spPr>
          <a:xfrm>
            <a:off x="1502064" y="1432744"/>
            <a:ext cx="6890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2307370" y="1432744"/>
            <a:ext cx="6996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>
            <a:off x="1532563" y="1239415"/>
            <a:ext cx="6510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2252480" y="1241109"/>
            <a:ext cx="777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DD1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45937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9</TotalTime>
  <Words>1612</Words>
  <Application>Microsoft Office PowerPoint</Application>
  <PresentationFormat>Personnalisé</PresentationFormat>
  <Paragraphs>299</Paragraphs>
  <Slides>11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1</vt:i4>
      </vt:variant>
    </vt:vector>
  </HeadingPairs>
  <TitlesOfParts>
    <vt:vector size="15" baseType="lpstr">
      <vt:lpstr>Arial</vt:lpstr>
      <vt:lpstr>Calibri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APS</dc:creator>
  <cp:lastModifiedBy>Francois</cp:lastModifiedBy>
  <cp:revision>77</cp:revision>
  <cp:lastPrinted>2018-03-22T12:00:42Z</cp:lastPrinted>
  <dcterms:created xsi:type="dcterms:W3CDTF">2016-12-27T13:41:41Z</dcterms:created>
  <dcterms:modified xsi:type="dcterms:W3CDTF">2018-05-03T15:40:31Z</dcterms:modified>
</cp:coreProperties>
</file>